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1"/>
  </p:notesMasterIdLst>
  <p:sldIdLst>
    <p:sldId id="271" r:id="rId2"/>
    <p:sldId id="268" r:id="rId3"/>
    <p:sldId id="272" r:id="rId4"/>
    <p:sldId id="274" r:id="rId5"/>
    <p:sldId id="258" r:id="rId6"/>
    <p:sldId id="265" r:id="rId7"/>
    <p:sldId id="257" r:id="rId8"/>
    <p:sldId id="264" r:id="rId9"/>
    <p:sldId id="270" r:id="rId10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373"/>
    <p:restoredTop sz="94722"/>
  </p:normalViewPr>
  <p:slideViewPr>
    <p:cSldViewPr snapToGrid="0" snapToObjects="1">
      <p:cViewPr varScale="1">
        <p:scale>
          <a:sx n="60" d="100"/>
          <a:sy n="60" d="100"/>
        </p:scale>
        <p:origin x="71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BBCFEA-1E92-7D4F-8C40-1369008E0DFD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A56189-E906-BD4B-9326-09331E0BF9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2214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A56189-E906-BD4B-9326-09331E0BF97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1679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A56189-E906-BD4B-9326-09331E0BF97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84751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A56189-E906-BD4B-9326-09331E0BF97E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0696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FC08A-4FA3-D943-8A5D-6EC6A882A124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EEBFB-F80A-B340-83FC-5E6522934E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379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FC08A-4FA3-D943-8A5D-6EC6A882A124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EEBFB-F80A-B340-83FC-5E6522934E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2553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FC08A-4FA3-D943-8A5D-6EC6A882A124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EEBFB-F80A-B340-83FC-5E6522934E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686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FC08A-4FA3-D943-8A5D-6EC6A882A124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EEBFB-F80A-B340-83FC-5E6522934E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950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FC08A-4FA3-D943-8A5D-6EC6A882A124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EEBFB-F80A-B340-83FC-5E6522934E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6990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FC08A-4FA3-D943-8A5D-6EC6A882A124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EEBFB-F80A-B340-83FC-5E6522934E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402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FC08A-4FA3-D943-8A5D-6EC6A882A124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EEBFB-F80A-B340-83FC-5E6522934E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900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FC08A-4FA3-D943-8A5D-6EC6A882A124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EEBFB-F80A-B340-83FC-5E6522934E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7725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FC08A-4FA3-D943-8A5D-6EC6A882A124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EEBFB-F80A-B340-83FC-5E6522934E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05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FC08A-4FA3-D943-8A5D-6EC6A882A124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EEBFB-F80A-B340-83FC-5E6522934E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978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FC08A-4FA3-D943-8A5D-6EC6A882A124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EEBFB-F80A-B340-83FC-5E6522934E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489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5FC08A-4FA3-D943-8A5D-6EC6A882A124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AEEBFB-F80A-B340-83FC-5E6522934E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246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13" Type="http://schemas.openxmlformats.org/officeDocument/2006/relationships/image" Target="../media/image13.png"/><Relationship Id="rId18" Type="http://schemas.openxmlformats.org/officeDocument/2006/relationships/image" Target="../media/image16.png"/><Relationship Id="rId3" Type="http://schemas.openxmlformats.org/officeDocument/2006/relationships/image" Target="../media/image7.png"/><Relationship Id="rId7" Type="http://schemas.openxmlformats.org/officeDocument/2006/relationships/image" Target="../media/image9.png"/><Relationship Id="rId12" Type="http://schemas.microsoft.com/office/2007/relationships/hdphoto" Target="../media/hdphoto6.wdp"/><Relationship Id="rId17" Type="http://schemas.microsoft.com/office/2007/relationships/hdphoto" Target="../media/hdphoto8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microsoft.com/office/2007/relationships/hdphoto" Target="../media/hdphoto4.wdp"/><Relationship Id="rId11" Type="http://schemas.openxmlformats.org/officeDocument/2006/relationships/image" Target="../media/image12.png"/><Relationship Id="rId5" Type="http://schemas.openxmlformats.org/officeDocument/2006/relationships/image" Target="../media/image8.png"/><Relationship Id="rId15" Type="http://schemas.microsoft.com/office/2007/relationships/hdphoto" Target="../media/hdphoto7.wdp"/><Relationship Id="rId10" Type="http://schemas.openxmlformats.org/officeDocument/2006/relationships/image" Target="../media/image11.png"/><Relationship Id="rId19" Type="http://schemas.microsoft.com/office/2007/relationships/hdphoto" Target="../media/hdphoto9.wdp"/><Relationship Id="rId4" Type="http://schemas.microsoft.com/office/2007/relationships/hdphoto" Target="../media/hdphoto3.wdp"/><Relationship Id="rId9" Type="http://schemas.openxmlformats.org/officeDocument/2006/relationships/image" Target="../media/image10.png"/><Relationship Id="rId1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openxmlformats.org/officeDocument/2006/relationships/image" Target="../media/image27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12" Type="http://schemas.openxmlformats.org/officeDocument/2006/relationships/image" Target="../media/image26.png"/><Relationship Id="rId17" Type="http://schemas.openxmlformats.org/officeDocument/2006/relationships/image" Target="../media/image31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png"/><Relationship Id="rId11" Type="http://schemas.openxmlformats.org/officeDocument/2006/relationships/image" Target="../media/image25.png"/><Relationship Id="rId5" Type="http://schemas.openxmlformats.org/officeDocument/2006/relationships/image" Target="../media/image19.png"/><Relationship Id="rId15" Type="http://schemas.openxmlformats.org/officeDocument/2006/relationships/image" Target="../media/image29.png"/><Relationship Id="rId10" Type="http://schemas.openxmlformats.org/officeDocument/2006/relationships/image" Target="../media/image24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Relationship Id="rId14" Type="http://schemas.openxmlformats.org/officeDocument/2006/relationships/image" Target="../media/image28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jpeg"/><Relationship Id="rId2" Type="http://schemas.openxmlformats.org/officeDocument/2006/relationships/image" Target="../media/image33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jpeg"/><Relationship Id="rId3" Type="http://schemas.openxmlformats.org/officeDocument/2006/relationships/image" Target="../media/image37.png"/><Relationship Id="rId7" Type="http://schemas.openxmlformats.org/officeDocument/2006/relationships/image" Target="../media/image41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jpeg"/><Relationship Id="rId5" Type="http://schemas.openxmlformats.org/officeDocument/2006/relationships/image" Target="../media/image39.jpeg"/><Relationship Id="rId4" Type="http://schemas.openxmlformats.org/officeDocument/2006/relationships/image" Target="../media/image3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10.wdp"/><Relationship Id="rId7" Type="http://schemas.microsoft.com/office/2007/relationships/hdphoto" Target="../media/hdphoto12.wdp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7.png"/><Relationship Id="rId5" Type="http://schemas.microsoft.com/office/2007/relationships/hdphoto" Target="../media/hdphoto11.wdp"/><Relationship Id="rId4" Type="http://schemas.openxmlformats.org/officeDocument/2006/relationships/image" Target="../media/image4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https://attachments.office.net/owa/hongyu.luo%40umontreal.ca/service.svc/s/GetAttachmentThumbnail?id=AAMkADU3MDgxNTA1LTZiNTctNGNhZi04M2M0LTgxNjY1OGE3M2NmZABGAAAAAABzUssUrvcMTIRZlBNbKtJLBwAgxcdIvtiIR64OpwxSkLZ0AAAAE5n1AADn62b1UREgRa7DHJ%2FD50ZOAAOUM9tTAAABEgAQALd%2BuHnj4U1JsOI8xYwJ15k%3D&amp;thumbnailType=2&amp;token=eyJhbGciOiJSUzI1NiIsImtpZCI6IkQ4OThGN0RDMjk2ODQ1MDk1RUUwREZGQ0MzODBBOTM5NjUwNDNFNjQiLCJ0eXAiOiJKV1QiLCJ4NXQiOiIySmozM0Nsb1JRbGU0Tl84dzRDcE9XVUVQbVEifQ.eyJvcmlnaW4iOiJodHRwczovL291dGxvb2sub2ZmaWNlLmNvbSIsInVjIjoiOGY4NWU3OWQwYTY4NDllNGIwMTdmYmE2NGY1M2UyYTMiLCJzaWduaW5fc3RhdGUiOiJbXCJrbXNpXCJdIiwidmVyIjoiRXhjaGFuZ2UuQ2FsbGJhY2suVjEiLCJhcHBjdHhzZW5kZXIiOiJPd2FEb3dubG9hZEBkMjdlZWZlYy0yYTQ3LTRiZTctOTgxZS0wZjg5NzdmYTMxZDgiLCJpc3NyaW5nIjoiV1ciLCJhcHBjdHgiOiJ7XCJtc2V4Y2hwcm90XCI6XCJvd2FcIixcInB1aWRcIjpcIjExNTM5MDY2NjA5NDQ2ODY5NjJcIixcInNjb3BlXCI6XCJPd2FEb3dubG9hZFwiLFwib2lkXCI6XCJmMTRjYjhjNi1lYzA2LTQyZTAtOGZiMS0wNGIxNjg3MjMyMjZcIixcInByaW1hcnlzaWRcIjpcIlMtMS01LTIxLTI5NzMzOTAwOTctMTUyMDE2OTQwLTI1MTg4NzM1NDAtNzk0MjkxNlwifSIsIm5iZiI6MTY3MDUxNTYxOSwiZXhwIjoxNjcwNTE2MjE5LCJpc3MiOiIwMDAwMDAwMi0wMDAwLTBmZjEtY2UwMC0wMDAwMDAwMDAwMDBAZDI3ZWVmZWMtMmE0Ny00YmU3LTk4MWUtMGY4OTc3ZmEzMWQ4IiwiYXVkIjoiMDAwMDAwMDItMDAwMC0wZmYxLWNlMDAtMDAwMDAwMDAwMDAwL2F0dGFjaG1lbnRzLm9mZmljZS5uZXRAZDI3ZWVmZWMtMmE0Ny00YmU3LTk4MWUtMGY4OTc3ZmEzMWQ4IiwiaGFwcCI6Im93YSJ9.TYQUieIdjYucdwSuLfvRZaTP0DC6pETqekXECg09pKkM0YAHtvlPkr1EyrlsY3I0XjnPsfTsqBXD7m7WBJ_IgsjO7Az1_11NZVjQg-h8rXt11QXD2uDg-OAp1-jZcyW23dhmsuQakj-g07bXAibDaKPXaxX0o8-y1IDDH8E6ZMNgEfvajAhtQl1qko0uRVDSRq1EvAXreYG0UYTebdV9-_JFgBGzdDXdXTNp_duSPxt867xyuz7PCL5sh9J99gJZFv4b5YkSIudj_5ZSDrjUCEEe1p3OmE-ojw62A-6fZ78fEjbYNE771NPefPiXkSHlHi0-7NtO08Om34mPiQXOmg&amp;X-OWA-CANARY=L-083GvcI0exlvA3tAg6MOBYRVs22doY1zPgYW-z66O9pmkVuRNqhWXCsjlmUhLZ3vM5BGoi_yE.&amp;owa=outlook.office.com&amp;scriptVer=20221124007.08&amp;animation=true">
            <a:extLst>
              <a:ext uri="{FF2B5EF4-FFF2-40B4-BE49-F238E27FC236}">
                <a16:creationId xmlns:a16="http://schemas.microsoft.com/office/drawing/2014/main" id="{5230DAA9-6DEE-4349-8226-0F2A72733A0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863" t="43268"/>
          <a:stretch/>
        </p:blipFill>
        <p:spPr bwMode="auto">
          <a:xfrm>
            <a:off x="4619215" y="3939250"/>
            <a:ext cx="1427540" cy="12546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CDA553D-950A-4584-AD9A-5F4C31D7F2DE}"/>
              </a:ext>
            </a:extLst>
          </p:cNvPr>
          <p:cNvSpPr txBox="1"/>
          <p:nvPr/>
        </p:nvSpPr>
        <p:spPr>
          <a:xfrm>
            <a:off x="218512" y="2291595"/>
            <a:ext cx="21622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3B </a:t>
            </a:r>
            <a:endParaRPr lang="en-CA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46AC22D-27A7-479F-99D8-846F033F105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5958"/>
          <a:stretch/>
        </p:blipFill>
        <p:spPr>
          <a:xfrm>
            <a:off x="4601489" y="5283341"/>
            <a:ext cx="1481899" cy="627372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4F71FF7E-3DAC-4F82-A79E-F331B22E7C8E}"/>
              </a:ext>
            </a:extLst>
          </p:cNvPr>
          <p:cNvSpPr txBox="1"/>
          <p:nvPr/>
        </p:nvSpPr>
        <p:spPr>
          <a:xfrm>
            <a:off x="2711942" y="4534315"/>
            <a:ext cx="6656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25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0B2A22B-8096-4271-9D6F-97C561204067}"/>
              </a:ext>
            </a:extLst>
          </p:cNvPr>
          <p:cNvSpPr txBox="1"/>
          <p:nvPr/>
        </p:nvSpPr>
        <p:spPr>
          <a:xfrm>
            <a:off x="2697956" y="4780536"/>
            <a:ext cx="65938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5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6C6A47D-C9B5-4FE5-B64B-2A7A16ED1F60}"/>
              </a:ext>
            </a:extLst>
          </p:cNvPr>
          <p:cNvSpPr txBox="1"/>
          <p:nvPr/>
        </p:nvSpPr>
        <p:spPr>
          <a:xfrm>
            <a:off x="2696453" y="5846256"/>
            <a:ext cx="6796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75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58A7D12-C122-453E-90A7-099D3902F1AD}"/>
              </a:ext>
            </a:extLst>
          </p:cNvPr>
          <p:cNvSpPr txBox="1"/>
          <p:nvPr/>
        </p:nvSpPr>
        <p:spPr>
          <a:xfrm>
            <a:off x="5976800" y="4655411"/>
            <a:ext cx="679652" cy="25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75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33D4290-682A-4177-B1B7-7BE5BC205E7F}"/>
              </a:ext>
            </a:extLst>
          </p:cNvPr>
          <p:cNvSpPr txBox="1"/>
          <p:nvPr/>
        </p:nvSpPr>
        <p:spPr>
          <a:xfrm>
            <a:off x="2677683" y="5521684"/>
            <a:ext cx="6796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15EBB067-1BA9-4A94-A8DA-8E1DB5246C7E}"/>
              </a:ext>
            </a:extLst>
          </p:cNvPr>
          <p:cNvGrpSpPr/>
          <p:nvPr/>
        </p:nvGrpSpPr>
        <p:grpSpPr>
          <a:xfrm>
            <a:off x="2711814" y="4339442"/>
            <a:ext cx="779516" cy="272181"/>
            <a:chOff x="-1953136" y="566236"/>
            <a:chExt cx="779516" cy="272181"/>
          </a:xfrm>
        </p:grpSpPr>
        <p:sp>
          <p:nvSpPr>
            <p:cNvPr id="17" name="Left Brace 16">
              <a:extLst>
                <a:ext uri="{FF2B5EF4-FFF2-40B4-BE49-F238E27FC236}">
                  <a16:creationId xmlns:a16="http://schemas.microsoft.com/office/drawing/2014/main" id="{5998BAD7-EE57-4AF6-AF36-C2026449EF05}"/>
                </a:ext>
              </a:extLst>
            </p:cNvPr>
            <p:cNvSpPr/>
            <p:nvPr/>
          </p:nvSpPr>
          <p:spPr>
            <a:xfrm flipH="1">
              <a:off x="-1904079" y="566236"/>
              <a:ext cx="59916" cy="175832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CA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AE833F55-0416-4C3B-8067-F1540B6DFBA3}"/>
                </a:ext>
              </a:extLst>
            </p:cNvPr>
            <p:cNvSpPr/>
            <p:nvPr/>
          </p:nvSpPr>
          <p:spPr>
            <a:xfrm>
              <a:off x="-1953136" y="566600"/>
              <a:ext cx="779516" cy="27181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LR2A</a:t>
              </a: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9AF4EBA8-B353-4811-A8B9-47A1A67E2860}"/>
              </a:ext>
            </a:extLst>
          </p:cNvPr>
          <p:cNvGrpSpPr/>
          <p:nvPr/>
        </p:nvGrpSpPr>
        <p:grpSpPr>
          <a:xfrm>
            <a:off x="5992674" y="4168288"/>
            <a:ext cx="790638" cy="218630"/>
            <a:chOff x="-2245287" y="5967334"/>
            <a:chExt cx="790638" cy="218630"/>
          </a:xfrm>
        </p:grpSpPr>
        <p:sp>
          <p:nvSpPr>
            <p:cNvPr id="39" name="Left Brace 38">
              <a:extLst>
                <a:ext uri="{FF2B5EF4-FFF2-40B4-BE49-F238E27FC236}">
                  <a16:creationId xmlns:a16="http://schemas.microsoft.com/office/drawing/2014/main" id="{0F4B43A0-AA99-4DD2-A6FA-A5B94BD1B6DF}"/>
                </a:ext>
              </a:extLst>
            </p:cNvPr>
            <p:cNvSpPr/>
            <p:nvPr/>
          </p:nvSpPr>
          <p:spPr>
            <a:xfrm flipH="1">
              <a:off x="-2155099" y="5967334"/>
              <a:ext cx="59916" cy="175832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CA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A8A3DD6C-D63B-401F-878A-358B8970373B}"/>
                </a:ext>
              </a:extLst>
            </p:cNvPr>
            <p:cNvSpPr/>
            <p:nvPr/>
          </p:nvSpPr>
          <p:spPr>
            <a:xfrm>
              <a:off x="-2245287" y="5970520"/>
              <a:ext cx="79063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MC5</a:t>
              </a:r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132CB991-58C9-4444-AE70-A74C17C6F554}"/>
              </a:ext>
            </a:extLst>
          </p:cNvPr>
          <p:cNvSpPr txBox="1"/>
          <p:nvPr/>
        </p:nvSpPr>
        <p:spPr>
          <a:xfrm>
            <a:off x="3768912" y="5445064"/>
            <a:ext cx="933268" cy="2718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CUL3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314E9408-B7AD-444C-A726-9245E733E70F}"/>
              </a:ext>
            </a:extLst>
          </p:cNvPr>
          <p:cNvSpPr/>
          <p:nvPr/>
        </p:nvSpPr>
        <p:spPr>
          <a:xfrm>
            <a:off x="3782601" y="4398696"/>
            <a:ext cx="909631" cy="2718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HA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400D862-AE72-44C8-81AD-98D371D2C659}"/>
              </a:ext>
            </a:extLst>
          </p:cNvPr>
          <p:cNvSpPr txBox="1"/>
          <p:nvPr/>
        </p:nvSpPr>
        <p:spPr>
          <a:xfrm>
            <a:off x="1476074" y="2858487"/>
            <a:ext cx="1025433" cy="2718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SK-N-SH cells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D089978B-4BEE-45DA-B0CC-21916BA2D483}"/>
              </a:ext>
            </a:extLst>
          </p:cNvPr>
          <p:cNvCxnSpPr/>
          <p:nvPr/>
        </p:nvCxnSpPr>
        <p:spPr>
          <a:xfrm flipH="1" flipV="1">
            <a:off x="1296475" y="3412847"/>
            <a:ext cx="555285" cy="45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8DC4E922-C4EE-4D1B-A5F1-E4B234B9C77F}"/>
              </a:ext>
            </a:extLst>
          </p:cNvPr>
          <p:cNvSpPr txBox="1"/>
          <p:nvPr/>
        </p:nvSpPr>
        <p:spPr>
          <a:xfrm>
            <a:off x="1296475" y="3119624"/>
            <a:ext cx="754427" cy="2718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HA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AF97C1B8-4767-4CAE-B890-6AAE1215ED22}"/>
              </a:ext>
            </a:extLst>
          </p:cNvPr>
          <p:cNvCxnSpPr/>
          <p:nvPr/>
        </p:nvCxnSpPr>
        <p:spPr>
          <a:xfrm flipH="1" flipV="1">
            <a:off x="2047715" y="3412847"/>
            <a:ext cx="555285" cy="45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823B4FFA-4B2C-4F46-AD27-EE793037916B}"/>
              </a:ext>
            </a:extLst>
          </p:cNvPr>
          <p:cNvSpPr txBox="1"/>
          <p:nvPr/>
        </p:nvSpPr>
        <p:spPr>
          <a:xfrm>
            <a:off x="2057691" y="3129058"/>
            <a:ext cx="660512" cy="2718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grpSp>
        <p:nvGrpSpPr>
          <p:cNvPr id="57" name="Group 56">
            <a:extLst>
              <a:ext uri="{FF2B5EF4-FFF2-40B4-BE49-F238E27FC236}">
                <a16:creationId xmlns:a16="http://schemas.microsoft.com/office/drawing/2014/main" id="{39C71589-0F80-4039-8F03-5373ED1AA7CB}"/>
              </a:ext>
            </a:extLst>
          </p:cNvPr>
          <p:cNvGrpSpPr/>
          <p:nvPr/>
        </p:nvGrpSpPr>
        <p:grpSpPr>
          <a:xfrm>
            <a:off x="2088335" y="3671951"/>
            <a:ext cx="413172" cy="113242"/>
            <a:chOff x="877433" y="6064029"/>
            <a:chExt cx="338575" cy="89756"/>
          </a:xfrm>
        </p:grpSpPr>
        <p:sp>
          <p:nvSpPr>
            <p:cNvPr id="58" name="Oval 57">
              <a:extLst>
                <a:ext uri="{FF2B5EF4-FFF2-40B4-BE49-F238E27FC236}">
                  <a16:creationId xmlns:a16="http://schemas.microsoft.com/office/drawing/2014/main" id="{6AB89F9C-9029-4E07-B420-6124EB1F44AF}"/>
                </a:ext>
              </a:extLst>
            </p:cNvPr>
            <p:cNvSpPr/>
            <p:nvPr/>
          </p:nvSpPr>
          <p:spPr>
            <a:xfrm>
              <a:off x="877433" y="6064029"/>
              <a:ext cx="101071" cy="89756"/>
            </a:xfrm>
            <a:prstGeom prst="ellipse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 sz="800" dirty="0"/>
            </a:p>
          </p:txBody>
        </p:sp>
        <p:sp>
          <p:nvSpPr>
            <p:cNvPr id="59" name="Oval 58">
              <a:extLst>
                <a:ext uri="{FF2B5EF4-FFF2-40B4-BE49-F238E27FC236}">
                  <a16:creationId xmlns:a16="http://schemas.microsoft.com/office/drawing/2014/main" id="{1EBD6276-7C91-4109-99A6-3489816243DA}"/>
                </a:ext>
              </a:extLst>
            </p:cNvPr>
            <p:cNvSpPr/>
            <p:nvPr/>
          </p:nvSpPr>
          <p:spPr>
            <a:xfrm>
              <a:off x="1114937" y="6064029"/>
              <a:ext cx="101071" cy="89756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 sz="800" dirty="0"/>
            </a:p>
          </p:txBody>
        </p:sp>
      </p:grpSp>
      <p:grpSp>
        <p:nvGrpSpPr>
          <p:cNvPr id="60" name="Group 59">
            <a:extLst>
              <a:ext uri="{FF2B5EF4-FFF2-40B4-BE49-F238E27FC236}">
                <a16:creationId xmlns:a16="http://schemas.microsoft.com/office/drawing/2014/main" id="{68BD001F-2A97-4E26-844B-B1227B1408EC}"/>
              </a:ext>
            </a:extLst>
          </p:cNvPr>
          <p:cNvGrpSpPr/>
          <p:nvPr/>
        </p:nvGrpSpPr>
        <p:grpSpPr>
          <a:xfrm>
            <a:off x="2090950" y="3482917"/>
            <a:ext cx="413172" cy="113242"/>
            <a:chOff x="877433" y="6194580"/>
            <a:chExt cx="338575" cy="89756"/>
          </a:xfrm>
        </p:grpSpPr>
        <p:sp>
          <p:nvSpPr>
            <p:cNvPr id="61" name="Oval 60">
              <a:extLst>
                <a:ext uri="{FF2B5EF4-FFF2-40B4-BE49-F238E27FC236}">
                  <a16:creationId xmlns:a16="http://schemas.microsoft.com/office/drawing/2014/main" id="{49A518FC-4D57-4512-BD6A-5124963D84AC}"/>
                </a:ext>
              </a:extLst>
            </p:cNvPr>
            <p:cNvSpPr/>
            <p:nvPr/>
          </p:nvSpPr>
          <p:spPr>
            <a:xfrm>
              <a:off x="877433" y="6194580"/>
              <a:ext cx="101071" cy="89756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 sz="800" dirty="0"/>
            </a:p>
          </p:txBody>
        </p:sp>
        <p:sp>
          <p:nvSpPr>
            <p:cNvPr id="62" name="Oval 61">
              <a:extLst>
                <a:ext uri="{FF2B5EF4-FFF2-40B4-BE49-F238E27FC236}">
                  <a16:creationId xmlns:a16="http://schemas.microsoft.com/office/drawing/2014/main" id="{D8D39726-9E1A-49D3-83BA-F3C3165B1ACB}"/>
                </a:ext>
              </a:extLst>
            </p:cNvPr>
            <p:cNvSpPr/>
            <p:nvPr/>
          </p:nvSpPr>
          <p:spPr>
            <a:xfrm>
              <a:off x="1114937" y="6194580"/>
              <a:ext cx="101071" cy="89756"/>
            </a:xfrm>
            <a:prstGeom prst="ellipse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 sz="800" dirty="0"/>
            </a:p>
          </p:txBody>
        </p:sp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E653FA3C-E0B3-4E3B-93D6-5B9E356BD198}"/>
              </a:ext>
            </a:extLst>
          </p:cNvPr>
          <p:cNvSpPr txBox="1"/>
          <p:nvPr/>
        </p:nvSpPr>
        <p:spPr>
          <a:xfrm>
            <a:off x="354009" y="3402352"/>
            <a:ext cx="1052942" cy="2718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RMC5-HA</a:t>
            </a:r>
          </a:p>
        </p:txBody>
      </p:sp>
      <p:grpSp>
        <p:nvGrpSpPr>
          <p:cNvPr id="64" name="Group 63">
            <a:extLst>
              <a:ext uri="{FF2B5EF4-FFF2-40B4-BE49-F238E27FC236}">
                <a16:creationId xmlns:a16="http://schemas.microsoft.com/office/drawing/2014/main" id="{E1C9109F-E235-4A7A-9922-D0833287C5DF}"/>
              </a:ext>
            </a:extLst>
          </p:cNvPr>
          <p:cNvGrpSpPr/>
          <p:nvPr/>
        </p:nvGrpSpPr>
        <p:grpSpPr>
          <a:xfrm>
            <a:off x="1379100" y="3482917"/>
            <a:ext cx="413172" cy="113242"/>
            <a:chOff x="1138290" y="4782789"/>
            <a:chExt cx="338575" cy="89756"/>
          </a:xfrm>
        </p:grpSpPr>
        <p:sp>
          <p:nvSpPr>
            <p:cNvPr id="65" name="Oval 64">
              <a:extLst>
                <a:ext uri="{FF2B5EF4-FFF2-40B4-BE49-F238E27FC236}">
                  <a16:creationId xmlns:a16="http://schemas.microsoft.com/office/drawing/2014/main" id="{8B6D1BCE-3B4B-47C4-A0EF-35410F842F09}"/>
                </a:ext>
              </a:extLst>
            </p:cNvPr>
            <p:cNvSpPr/>
            <p:nvPr/>
          </p:nvSpPr>
          <p:spPr>
            <a:xfrm>
              <a:off x="1138290" y="4782789"/>
              <a:ext cx="101071" cy="89756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 sz="800" dirty="0"/>
            </a:p>
          </p:txBody>
        </p:sp>
        <p:sp>
          <p:nvSpPr>
            <p:cNvPr id="66" name="Oval 65">
              <a:extLst>
                <a:ext uri="{FF2B5EF4-FFF2-40B4-BE49-F238E27FC236}">
                  <a16:creationId xmlns:a16="http://schemas.microsoft.com/office/drawing/2014/main" id="{8ED8D4C2-65A0-4039-A56D-836D80B92CF7}"/>
                </a:ext>
              </a:extLst>
            </p:cNvPr>
            <p:cNvSpPr/>
            <p:nvPr/>
          </p:nvSpPr>
          <p:spPr>
            <a:xfrm>
              <a:off x="1375794" y="4782789"/>
              <a:ext cx="101071" cy="89756"/>
            </a:xfrm>
            <a:prstGeom prst="ellipse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 sz="800" dirty="0"/>
            </a:p>
          </p:txBody>
        </p:sp>
      </p:grpSp>
      <p:sp>
        <p:nvSpPr>
          <p:cNvPr id="67" name="TextBox 66">
            <a:extLst>
              <a:ext uri="{FF2B5EF4-FFF2-40B4-BE49-F238E27FC236}">
                <a16:creationId xmlns:a16="http://schemas.microsoft.com/office/drawing/2014/main" id="{5B4E09A9-D458-4F3F-8C53-955B6A33F9CF}"/>
              </a:ext>
            </a:extLst>
          </p:cNvPr>
          <p:cNvSpPr txBox="1"/>
          <p:nvPr/>
        </p:nvSpPr>
        <p:spPr>
          <a:xfrm>
            <a:off x="410366" y="3579070"/>
            <a:ext cx="1006055" cy="2718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mpty vector</a:t>
            </a:r>
          </a:p>
        </p:txBody>
      </p:sp>
      <p:grpSp>
        <p:nvGrpSpPr>
          <p:cNvPr id="68" name="Group 67">
            <a:extLst>
              <a:ext uri="{FF2B5EF4-FFF2-40B4-BE49-F238E27FC236}">
                <a16:creationId xmlns:a16="http://schemas.microsoft.com/office/drawing/2014/main" id="{2B9B35C1-DEF3-41CD-85ED-B2CE073E68EF}"/>
              </a:ext>
            </a:extLst>
          </p:cNvPr>
          <p:cNvGrpSpPr/>
          <p:nvPr/>
        </p:nvGrpSpPr>
        <p:grpSpPr>
          <a:xfrm>
            <a:off x="1379100" y="3671951"/>
            <a:ext cx="413172" cy="113242"/>
            <a:chOff x="1138290" y="4913340"/>
            <a:chExt cx="338575" cy="89756"/>
          </a:xfrm>
        </p:grpSpPr>
        <p:sp>
          <p:nvSpPr>
            <p:cNvPr id="69" name="Oval 68">
              <a:extLst>
                <a:ext uri="{FF2B5EF4-FFF2-40B4-BE49-F238E27FC236}">
                  <a16:creationId xmlns:a16="http://schemas.microsoft.com/office/drawing/2014/main" id="{742D48AA-3B85-4674-9549-494CE0F09916}"/>
                </a:ext>
              </a:extLst>
            </p:cNvPr>
            <p:cNvSpPr/>
            <p:nvPr/>
          </p:nvSpPr>
          <p:spPr>
            <a:xfrm>
              <a:off x="1138290" y="4913340"/>
              <a:ext cx="101071" cy="89756"/>
            </a:xfrm>
            <a:prstGeom prst="ellipse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 sz="800" dirty="0"/>
            </a:p>
          </p:txBody>
        </p:sp>
        <p:sp>
          <p:nvSpPr>
            <p:cNvPr id="70" name="Oval 69">
              <a:extLst>
                <a:ext uri="{FF2B5EF4-FFF2-40B4-BE49-F238E27FC236}">
                  <a16:creationId xmlns:a16="http://schemas.microsoft.com/office/drawing/2014/main" id="{D2EA5347-D422-4EC7-A286-98090C2BE92C}"/>
                </a:ext>
              </a:extLst>
            </p:cNvPr>
            <p:cNvSpPr/>
            <p:nvPr/>
          </p:nvSpPr>
          <p:spPr>
            <a:xfrm>
              <a:off x="1375794" y="4913340"/>
              <a:ext cx="101071" cy="89756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 sz="800" dirty="0"/>
            </a:p>
          </p:txBody>
        </p:sp>
      </p:grpSp>
      <p:sp>
        <p:nvSpPr>
          <p:cNvPr id="74" name="Rectangle 73">
            <a:extLst>
              <a:ext uri="{FF2B5EF4-FFF2-40B4-BE49-F238E27FC236}">
                <a16:creationId xmlns:a16="http://schemas.microsoft.com/office/drawing/2014/main" id="{EF469BF5-43E7-46ED-ADAB-15496B8244E7}"/>
              </a:ext>
            </a:extLst>
          </p:cNvPr>
          <p:cNvSpPr/>
          <p:nvPr/>
        </p:nvSpPr>
        <p:spPr>
          <a:xfrm>
            <a:off x="170501" y="4260259"/>
            <a:ext cx="90963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POLR2A</a:t>
            </a:r>
          </a:p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4H8)</a:t>
            </a: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0769BD3D-58C7-4995-A451-E6EC060E1FDF}"/>
              </a:ext>
            </a:extLst>
          </p:cNvPr>
          <p:cNvSpPr/>
          <p:nvPr/>
        </p:nvSpPr>
        <p:spPr>
          <a:xfrm>
            <a:off x="226081" y="2731335"/>
            <a:ext cx="3190629" cy="37349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D1A24A03-0EC3-4091-85BC-7B422B620C9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grayscl/>
          </a:blip>
          <a:srcRect t="2297"/>
          <a:stretch/>
        </p:blipFill>
        <p:spPr>
          <a:xfrm flipH="1">
            <a:off x="1049434" y="5192300"/>
            <a:ext cx="805143" cy="109859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267D45F-A61D-4EDE-B037-5378D0B63AA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grayscl/>
          </a:blip>
          <a:srcRect b="6549"/>
          <a:stretch/>
        </p:blipFill>
        <p:spPr>
          <a:xfrm flipH="1">
            <a:off x="1927280" y="5192301"/>
            <a:ext cx="807871" cy="1098592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0C8C6F21-5F3E-4D93-88AB-A9CBAF1F1413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grayscl/>
          </a:blip>
          <a:srcRect t="3562"/>
          <a:stretch/>
        </p:blipFill>
        <p:spPr>
          <a:xfrm flipH="1">
            <a:off x="1045123" y="3917805"/>
            <a:ext cx="806637" cy="120757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BBF21F34-96EE-40CC-9EA9-2A45A3022BE5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grayscl/>
          </a:blip>
          <a:srcRect l="5778"/>
          <a:stretch/>
        </p:blipFill>
        <p:spPr>
          <a:xfrm flipH="1">
            <a:off x="1927280" y="3917228"/>
            <a:ext cx="828032" cy="1204603"/>
          </a:xfrm>
          <a:prstGeom prst="rect">
            <a:avLst/>
          </a:prstGeom>
        </p:spPr>
      </p:pic>
      <p:grpSp>
        <p:nvGrpSpPr>
          <p:cNvPr id="21" name="Group 20">
            <a:extLst>
              <a:ext uri="{FF2B5EF4-FFF2-40B4-BE49-F238E27FC236}">
                <a16:creationId xmlns:a16="http://schemas.microsoft.com/office/drawing/2014/main" id="{A21E401B-2F33-420A-97FE-05A88BAEDBC2}"/>
              </a:ext>
            </a:extLst>
          </p:cNvPr>
          <p:cNvGrpSpPr/>
          <p:nvPr/>
        </p:nvGrpSpPr>
        <p:grpSpPr>
          <a:xfrm>
            <a:off x="3796823" y="2931635"/>
            <a:ext cx="2364194" cy="992400"/>
            <a:chOff x="6369900" y="1013673"/>
            <a:chExt cx="2364194" cy="992400"/>
          </a:xfrm>
        </p:grpSpPr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970FA733-A78A-42FD-AEDA-E4BB622D7876}"/>
                </a:ext>
              </a:extLst>
            </p:cNvPr>
            <p:cNvSpPr txBox="1"/>
            <p:nvPr/>
          </p:nvSpPr>
          <p:spPr>
            <a:xfrm>
              <a:off x="7491965" y="1013673"/>
              <a:ext cx="1025433" cy="2718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dirty="0">
                  <a:latin typeface="Arial" panose="020B0604020202020204" pitchFamily="34" charset="0"/>
                  <a:cs typeface="Arial" panose="020B0604020202020204" pitchFamily="34" charset="0"/>
                </a:rPr>
                <a:t>SK-N-SH cells</a:t>
              </a:r>
            </a:p>
          </p:txBody>
        </p: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774B8E3D-1D48-4D2B-ADA7-33F548B886A5}"/>
                </a:ext>
              </a:extLst>
            </p:cNvPr>
            <p:cNvCxnSpPr/>
            <p:nvPr/>
          </p:nvCxnSpPr>
          <p:spPr>
            <a:xfrm flipH="1" flipV="1">
              <a:off x="7312366" y="1568033"/>
              <a:ext cx="555285" cy="45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E89746A0-8C50-4616-991A-7DEA599115B1}"/>
                </a:ext>
              </a:extLst>
            </p:cNvPr>
            <p:cNvSpPr txBox="1"/>
            <p:nvPr/>
          </p:nvSpPr>
          <p:spPr>
            <a:xfrm>
              <a:off x="7312366" y="1274810"/>
              <a:ext cx="754427" cy="2718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P: </a:t>
              </a:r>
              <a:r>
                <a:rPr lang="en-US" sz="8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HA</a:t>
              </a:r>
            </a:p>
          </p:txBody>
        </p: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74FCE42A-577B-47B9-817F-E59E9698E29B}"/>
                </a:ext>
              </a:extLst>
            </p:cNvPr>
            <p:cNvCxnSpPr/>
            <p:nvPr/>
          </p:nvCxnSpPr>
          <p:spPr>
            <a:xfrm flipH="1" flipV="1">
              <a:off x="8063606" y="1568033"/>
              <a:ext cx="555285" cy="45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228B363A-CECE-4DBE-8E90-1D4E1DE20489}"/>
                </a:ext>
              </a:extLst>
            </p:cNvPr>
            <p:cNvSpPr txBox="1"/>
            <p:nvPr/>
          </p:nvSpPr>
          <p:spPr>
            <a:xfrm>
              <a:off x="8073582" y="1284244"/>
              <a:ext cx="660512" cy="2718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</a:p>
          </p:txBody>
        </p:sp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7B04C44A-3E19-44B9-B3B4-76FA4B989F86}"/>
                </a:ext>
              </a:extLst>
            </p:cNvPr>
            <p:cNvGrpSpPr/>
            <p:nvPr/>
          </p:nvGrpSpPr>
          <p:grpSpPr>
            <a:xfrm>
              <a:off x="8104226" y="1827137"/>
              <a:ext cx="413172" cy="113242"/>
              <a:chOff x="877433" y="6064029"/>
              <a:chExt cx="338575" cy="89756"/>
            </a:xfrm>
          </p:grpSpPr>
          <p:sp>
            <p:nvSpPr>
              <p:cNvPr id="83" name="Oval 82">
                <a:extLst>
                  <a:ext uri="{FF2B5EF4-FFF2-40B4-BE49-F238E27FC236}">
                    <a16:creationId xmlns:a16="http://schemas.microsoft.com/office/drawing/2014/main" id="{52AA3EAD-20D4-4EDF-B260-FE2F34D10827}"/>
                  </a:ext>
                </a:extLst>
              </p:cNvPr>
              <p:cNvSpPr/>
              <p:nvPr/>
            </p:nvSpPr>
            <p:spPr>
              <a:xfrm>
                <a:off x="877433" y="6064029"/>
                <a:ext cx="101071" cy="89756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CA" sz="800" dirty="0"/>
              </a:p>
            </p:txBody>
          </p:sp>
          <p:sp>
            <p:nvSpPr>
              <p:cNvPr id="84" name="Oval 83">
                <a:extLst>
                  <a:ext uri="{FF2B5EF4-FFF2-40B4-BE49-F238E27FC236}">
                    <a16:creationId xmlns:a16="http://schemas.microsoft.com/office/drawing/2014/main" id="{15B02CC0-3B8A-463E-81E7-7E02DD1D7F92}"/>
                  </a:ext>
                </a:extLst>
              </p:cNvPr>
              <p:cNvSpPr/>
              <p:nvPr/>
            </p:nvSpPr>
            <p:spPr>
              <a:xfrm>
                <a:off x="1114937" y="6064029"/>
                <a:ext cx="101071" cy="89756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CA" sz="800" dirty="0"/>
              </a:p>
            </p:txBody>
          </p:sp>
        </p:grp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D192BAC5-EF08-41AB-B717-4699C210F905}"/>
                </a:ext>
              </a:extLst>
            </p:cNvPr>
            <p:cNvGrpSpPr/>
            <p:nvPr/>
          </p:nvGrpSpPr>
          <p:grpSpPr>
            <a:xfrm>
              <a:off x="8106841" y="1638103"/>
              <a:ext cx="413172" cy="113242"/>
              <a:chOff x="877433" y="6194580"/>
              <a:chExt cx="338575" cy="89756"/>
            </a:xfrm>
          </p:grpSpPr>
          <p:sp>
            <p:nvSpPr>
              <p:cNvPr id="86" name="Oval 85">
                <a:extLst>
                  <a:ext uri="{FF2B5EF4-FFF2-40B4-BE49-F238E27FC236}">
                    <a16:creationId xmlns:a16="http://schemas.microsoft.com/office/drawing/2014/main" id="{E0BF269D-C23C-45CA-A01F-8F9A9AF1A895}"/>
                  </a:ext>
                </a:extLst>
              </p:cNvPr>
              <p:cNvSpPr/>
              <p:nvPr/>
            </p:nvSpPr>
            <p:spPr>
              <a:xfrm>
                <a:off x="877433" y="6194580"/>
                <a:ext cx="101071" cy="89756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CA" sz="800" dirty="0"/>
              </a:p>
            </p:txBody>
          </p:sp>
          <p:sp>
            <p:nvSpPr>
              <p:cNvPr id="87" name="Oval 86">
                <a:extLst>
                  <a:ext uri="{FF2B5EF4-FFF2-40B4-BE49-F238E27FC236}">
                    <a16:creationId xmlns:a16="http://schemas.microsoft.com/office/drawing/2014/main" id="{DA9AF157-0526-453B-A904-C2904D56B45A}"/>
                  </a:ext>
                </a:extLst>
              </p:cNvPr>
              <p:cNvSpPr/>
              <p:nvPr/>
            </p:nvSpPr>
            <p:spPr>
              <a:xfrm>
                <a:off x="1114937" y="6194580"/>
                <a:ext cx="101071" cy="89756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CA" sz="800" dirty="0"/>
              </a:p>
            </p:txBody>
          </p:sp>
        </p:grp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9796C7BD-1F83-420F-AC97-475504E67A63}"/>
                </a:ext>
              </a:extLst>
            </p:cNvPr>
            <p:cNvSpPr txBox="1"/>
            <p:nvPr/>
          </p:nvSpPr>
          <p:spPr>
            <a:xfrm>
              <a:off x="6369900" y="1557538"/>
              <a:ext cx="1052942" cy="2718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RMC5-HA</a:t>
              </a:r>
            </a:p>
          </p:txBody>
        </p:sp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AC19911B-9EB7-4E95-8808-F7DF90741F7D}"/>
                </a:ext>
              </a:extLst>
            </p:cNvPr>
            <p:cNvGrpSpPr/>
            <p:nvPr/>
          </p:nvGrpSpPr>
          <p:grpSpPr>
            <a:xfrm>
              <a:off x="7394991" y="1638103"/>
              <a:ext cx="413172" cy="113242"/>
              <a:chOff x="1138290" y="4782789"/>
              <a:chExt cx="338575" cy="89756"/>
            </a:xfrm>
          </p:grpSpPr>
          <p:sp>
            <p:nvSpPr>
              <p:cNvPr id="90" name="Oval 89">
                <a:extLst>
                  <a:ext uri="{FF2B5EF4-FFF2-40B4-BE49-F238E27FC236}">
                    <a16:creationId xmlns:a16="http://schemas.microsoft.com/office/drawing/2014/main" id="{98CBE20C-91E2-49A7-B97A-4006E3305DCF}"/>
                  </a:ext>
                </a:extLst>
              </p:cNvPr>
              <p:cNvSpPr/>
              <p:nvPr/>
            </p:nvSpPr>
            <p:spPr>
              <a:xfrm>
                <a:off x="1138290" y="4782789"/>
                <a:ext cx="101071" cy="89756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CA" sz="800" dirty="0"/>
              </a:p>
            </p:txBody>
          </p:sp>
          <p:sp>
            <p:nvSpPr>
              <p:cNvPr id="91" name="Oval 90">
                <a:extLst>
                  <a:ext uri="{FF2B5EF4-FFF2-40B4-BE49-F238E27FC236}">
                    <a16:creationId xmlns:a16="http://schemas.microsoft.com/office/drawing/2014/main" id="{94A8A32F-D03E-4073-8E06-ECCC77AC24DC}"/>
                  </a:ext>
                </a:extLst>
              </p:cNvPr>
              <p:cNvSpPr/>
              <p:nvPr/>
            </p:nvSpPr>
            <p:spPr>
              <a:xfrm>
                <a:off x="1375794" y="4782789"/>
                <a:ext cx="101071" cy="89756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CA" sz="800" dirty="0"/>
              </a:p>
            </p:txBody>
          </p:sp>
        </p:grp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FA16FDAF-B0E3-4B1D-B134-C4E93FD66BB5}"/>
                </a:ext>
              </a:extLst>
            </p:cNvPr>
            <p:cNvSpPr txBox="1"/>
            <p:nvPr/>
          </p:nvSpPr>
          <p:spPr>
            <a:xfrm>
              <a:off x="6426257" y="1734256"/>
              <a:ext cx="1006055" cy="2718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mpty vector</a:t>
              </a:r>
            </a:p>
          </p:txBody>
        </p:sp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C7FD8F6F-F046-4CE3-84E1-CFF20E1B4A4E}"/>
                </a:ext>
              </a:extLst>
            </p:cNvPr>
            <p:cNvGrpSpPr/>
            <p:nvPr/>
          </p:nvGrpSpPr>
          <p:grpSpPr>
            <a:xfrm>
              <a:off x="7394991" y="1827137"/>
              <a:ext cx="413172" cy="113242"/>
              <a:chOff x="1138290" y="4913340"/>
              <a:chExt cx="338575" cy="89756"/>
            </a:xfrm>
          </p:grpSpPr>
          <p:sp>
            <p:nvSpPr>
              <p:cNvPr id="94" name="Oval 93">
                <a:extLst>
                  <a:ext uri="{FF2B5EF4-FFF2-40B4-BE49-F238E27FC236}">
                    <a16:creationId xmlns:a16="http://schemas.microsoft.com/office/drawing/2014/main" id="{BA8607BB-BD6B-456E-BAD3-EAFA35DA7582}"/>
                  </a:ext>
                </a:extLst>
              </p:cNvPr>
              <p:cNvSpPr/>
              <p:nvPr/>
            </p:nvSpPr>
            <p:spPr>
              <a:xfrm>
                <a:off x="1138290" y="4913340"/>
                <a:ext cx="101071" cy="89756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CA" sz="800" dirty="0"/>
              </a:p>
            </p:txBody>
          </p:sp>
          <p:sp>
            <p:nvSpPr>
              <p:cNvPr id="95" name="Oval 94">
                <a:extLst>
                  <a:ext uri="{FF2B5EF4-FFF2-40B4-BE49-F238E27FC236}">
                    <a16:creationId xmlns:a16="http://schemas.microsoft.com/office/drawing/2014/main" id="{48201F88-A572-4CBB-BCEE-565E75079D4C}"/>
                  </a:ext>
                </a:extLst>
              </p:cNvPr>
              <p:cNvSpPr/>
              <p:nvPr/>
            </p:nvSpPr>
            <p:spPr>
              <a:xfrm>
                <a:off x="1375794" y="4913340"/>
                <a:ext cx="101071" cy="89756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CA" sz="800" dirty="0"/>
              </a:p>
            </p:txBody>
          </p:sp>
        </p:grpSp>
      </p:grpSp>
      <p:sp>
        <p:nvSpPr>
          <p:cNvPr id="96" name="Rectangle 95">
            <a:extLst>
              <a:ext uri="{FF2B5EF4-FFF2-40B4-BE49-F238E27FC236}">
                <a16:creationId xmlns:a16="http://schemas.microsoft.com/office/drawing/2014/main" id="{73F31873-8FDB-4F8E-BF99-73FAD170F6BD}"/>
              </a:ext>
            </a:extLst>
          </p:cNvPr>
          <p:cNvSpPr/>
          <p:nvPr/>
        </p:nvSpPr>
        <p:spPr>
          <a:xfrm>
            <a:off x="208181" y="5393391"/>
            <a:ext cx="909631" cy="2718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HA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5ECEBC65-7A4F-4EE6-BE2E-02BEF010EECD}"/>
              </a:ext>
            </a:extLst>
          </p:cNvPr>
          <p:cNvSpPr txBox="1"/>
          <p:nvPr/>
        </p:nvSpPr>
        <p:spPr>
          <a:xfrm>
            <a:off x="5976800" y="4949515"/>
            <a:ext cx="6796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5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9E90BD9C-1355-430F-AFBD-95935217E5BB}"/>
              </a:ext>
            </a:extLst>
          </p:cNvPr>
          <p:cNvSpPr txBox="1"/>
          <p:nvPr/>
        </p:nvSpPr>
        <p:spPr>
          <a:xfrm>
            <a:off x="5976800" y="5554297"/>
            <a:ext cx="679652" cy="25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75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66B8D9C2-8270-41A2-A025-BEDE84EF4073}"/>
              </a:ext>
            </a:extLst>
          </p:cNvPr>
          <p:cNvSpPr txBox="1"/>
          <p:nvPr/>
        </p:nvSpPr>
        <p:spPr>
          <a:xfrm>
            <a:off x="5976800" y="4325001"/>
            <a:ext cx="6796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A6433933-FA5F-41EF-AEC4-6169943F2537}"/>
              </a:ext>
            </a:extLst>
          </p:cNvPr>
          <p:cNvSpPr txBox="1"/>
          <p:nvPr/>
        </p:nvSpPr>
        <p:spPr>
          <a:xfrm>
            <a:off x="5976800" y="5228089"/>
            <a:ext cx="6796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13C9CBAB-7E59-49CB-A2C5-B3CC5982026C}"/>
              </a:ext>
            </a:extLst>
          </p:cNvPr>
          <p:cNvSpPr txBox="1"/>
          <p:nvPr/>
        </p:nvSpPr>
        <p:spPr>
          <a:xfrm>
            <a:off x="5976800" y="4042141"/>
            <a:ext cx="65938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5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9A201FDE-F252-4A14-AD46-F7D030D1E665}"/>
              </a:ext>
            </a:extLst>
          </p:cNvPr>
          <p:cNvSpPr/>
          <p:nvPr/>
        </p:nvSpPr>
        <p:spPr>
          <a:xfrm>
            <a:off x="3485554" y="2731335"/>
            <a:ext cx="3190629" cy="37349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D573DCE1-1504-4E80-AE02-B37D3D8450AA}"/>
              </a:ext>
            </a:extLst>
          </p:cNvPr>
          <p:cNvSpPr txBox="1"/>
          <p:nvPr/>
        </p:nvSpPr>
        <p:spPr>
          <a:xfrm>
            <a:off x="3521716" y="2308017"/>
            <a:ext cx="1472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3C </a:t>
            </a:r>
            <a:endParaRPr lang="en-CA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1CC63A6-0B34-4FD0-8364-4752E307BC8F}"/>
              </a:ext>
            </a:extLst>
          </p:cNvPr>
          <p:cNvSpPr txBox="1"/>
          <p:nvPr/>
        </p:nvSpPr>
        <p:spPr>
          <a:xfrm>
            <a:off x="1502440" y="867508"/>
            <a:ext cx="41524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ditional file 6: original uncropped blots</a:t>
            </a:r>
          </a:p>
        </p:txBody>
      </p:sp>
    </p:spTree>
    <p:extLst>
      <p:ext uri="{BB962C8B-B14F-4D97-AF65-F5344CB8AC3E}">
        <p14:creationId xmlns:p14="http://schemas.microsoft.com/office/powerpoint/2010/main" val="33025291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DCAA442-9CD1-4F88-B04D-F0FB6B9D449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42758" t="31956"/>
          <a:stretch/>
        </p:blipFill>
        <p:spPr>
          <a:xfrm>
            <a:off x="1830716" y="4189054"/>
            <a:ext cx="988774" cy="218472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5E20B6B-EF58-47E3-ABE6-CDAAEE1CCC4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3162" r="63828"/>
          <a:stretch/>
        </p:blipFill>
        <p:spPr>
          <a:xfrm>
            <a:off x="1945041" y="960554"/>
            <a:ext cx="749433" cy="222044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3E50B2C-0C29-4786-A5D0-EC2AC3238511}"/>
              </a:ext>
            </a:extLst>
          </p:cNvPr>
          <p:cNvSpPr txBox="1"/>
          <p:nvPr/>
        </p:nvSpPr>
        <p:spPr>
          <a:xfrm>
            <a:off x="555785" y="1111544"/>
            <a:ext cx="6673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LR2A</a:t>
            </a:r>
          </a:p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4H8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A0802EB-9F72-4E6C-83A4-28F24ED5A8FF}"/>
              </a:ext>
            </a:extLst>
          </p:cNvPr>
          <p:cNvSpPr txBox="1"/>
          <p:nvPr/>
        </p:nvSpPr>
        <p:spPr>
          <a:xfrm>
            <a:off x="712329" y="2724887"/>
            <a:ext cx="4998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5194C23B-CB50-44F7-B906-019A7C9E4330}"/>
              </a:ext>
            </a:extLst>
          </p:cNvPr>
          <p:cNvGrpSpPr/>
          <p:nvPr/>
        </p:nvGrpSpPr>
        <p:grpSpPr>
          <a:xfrm>
            <a:off x="1135134" y="615976"/>
            <a:ext cx="1553556" cy="398092"/>
            <a:chOff x="589273" y="117778"/>
            <a:chExt cx="1553556" cy="398092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600513F-8954-47F5-9D8A-896A6DAAB024}"/>
                </a:ext>
              </a:extLst>
            </p:cNvPr>
            <p:cNvSpPr txBox="1"/>
            <p:nvPr/>
          </p:nvSpPr>
          <p:spPr>
            <a:xfrm>
              <a:off x="589273" y="117778"/>
              <a:ext cx="8169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ural Tubes 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EC455F7-89AF-4B17-B5C0-BAFE60AF28D3}"/>
                </a:ext>
              </a:extLst>
            </p:cNvPr>
            <p:cNvSpPr txBox="1"/>
            <p:nvPr/>
          </p:nvSpPr>
          <p:spPr>
            <a:xfrm>
              <a:off x="1552470" y="117813"/>
              <a:ext cx="51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PCs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CE9CF10-C6CD-4375-82E2-8755FBD481D0}"/>
                </a:ext>
              </a:extLst>
            </p:cNvPr>
            <p:cNvSpPr txBox="1"/>
            <p:nvPr/>
          </p:nvSpPr>
          <p:spPr>
            <a:xfrm>
              <a:off x="1476669" y="292025"/>
              <a:ext cx="666160" cy="2238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O     WT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C734CDC-1AB5-4766-AF5B-B84FC6F50DC7}"/>
                </a:ext>
              </a:extLst>
            </p:cNvPr>
            <p:cNvSpPr txBox="1"/>
            <p:nvPr/>
          </p:nvSpPr>
          <p:spPr>
            <a:xfrm>
              <a:off x="670556" y="292025"/>
              <a:ext cx="666160" cy="2238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O     WT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4B9DE7A1-A478-4999-AAA5-D7BB5EAA6368}"/>
              </a:ext>
            </a:extLst>
          </p:cNvPr>
          <p:cNvSpPr txBox="1"/>
          <p:nvPr/>
        </p:nvSpPr>
        <p:spPr>
          <a:xfrm>
            <a:off x="469842" y="574586"/>
            <a:ext cx="2433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229AF91-898D-4FF0-A989-DBA8EB77547D}"/>
              </a:ext>
            </a:extLst>
          </p:cNvPr>
          <p:cNvSpPr txBox="1"/>
          <p:nvPr/>
        </p:nvSpPr>
        <p:spPr>
          <a:xfrm>
            <a:off x="439264" y="3670125"/>
            <a:ext cx="3129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FD466FB-BBC0-4212-AD2E-BD54478617D6}"/>
              </a:ext>
            </a:extLst>
          </p:cNvPr>
          <p:cNvSpPr txBox="1"/>
          <p:nvPr/>
        </p:nvSpPr>
        <p:spPr>
          <a:xfrm>
            <a:off x="428678" y="4440375"/>
            <a:ext cx="785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LR2A</a:t>
            </a:r>
          </a:p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F12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D250BA7-5CD2-4590-9A82-B611C855825F}"/>
              </a:ext>
            </a:extLst>
          </p:cNvPr>
          <p:cNvSpPr txBox="1"/>
          <p:nvPr/>
        </p:nvSpPr>
        <p:spPr>
          <a:xfrm>
            <a:off x="625330" y="5817096"/>
            <a:ext cx="4998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180A0AEE-26B2-45AD-81A2-624E9964724E}"/>
              </a:ext>
            </a:extLst>
          </p:cNvPr>
          <p:cNvGrpSpPr/>
          <p:nvPr/>
        </p:nvGrpSpPr>
        <p:grpSpPr>
          <a:xfrm>
            <a:off x="1046589" y="3850403"/>
            <a:ext cx="1528006" cy="393300"/>
            <a:chOff x="659268" y="213598"/>
            <a:chExt cx="1528006" cy="393300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C74906B-A0FE-44BB-8102-C9D27B2A00FC}"/>
                </a:ext>
              </a:extLst>
            </p:cNvPr>
            <p:cNvSpPr txBox="1"/>
            <p:nvPr/>
          </p:nvSpPr>
          <p:spPr>
            <a:xfrm>
              <a:off x="659268" y="213598"/>
              <a:ext cx="8217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ural Tubes 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F501F45-C1CE-44EC-9D3C-40C082BA7D16}"/>
                </a:ext>
              </a:extLst>
            </p:cNvPr>
            <p:cNvSpPr txBox="1"/>
            <p:nvPr/>
          </p:nvSpPr>
          <p:spPr>
            <a:xfrm>
              <a:off x="1596915" y="213598"/>
              <a:ext cx="51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PCs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5C4D34ED-4524-44C0-B7B9-15CCF1B31A9C}"/>
                </a:ext>
              </a:extLst>
            </p:cNvPr>
            <p:cNvSpPr txBox="1"/>
            <p:nvPr/>
          </p:nvSpPr>
          <p:spPr>
            <a:xfrm>
              <a:off x="1521114" y="383053"/>
              <a:ext cx="666160" cy="2238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O     WT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1666DCE-59A6-4416-BA04-01A4334654E4}"/>
                </a:ext>
              </a:extLst>
            </p:cNvPr>
            <p:cNvSpPr txBox="1"/>
            <p:nvPr/>
          </p:nvSpPr>
          <p:spPr>
            <a:xfrm>
              <a:off x="715001" y="383053"/>
              <a:ext cx="666160" cy="2238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O     WT</a:t>
              </a:r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1D7341EA-7F33-4BDB-84FA-5CDFACF4B780}"/>
              </a:ext>
            </a:extLst>
          </p:cNvPr>
          <p:cNvGrpSpPr/>
          <p:nvPr/>
        </p:nvGrpSpPr>
        <p:grpSpPr>
          <a:xfrm>
            <a:off x="2625440" y="1234518"/>
            <a:ext cx="606507" cy="1732713"/>
            <a:chOff x="2025430" y="595411"/>
            <a:chExt cx="606507" cy="1214775"/>
          </a:xfrm>
        </p:grpSpPr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0D04D657-6915-44A3-90DB-556C4978B8DB}"/>
                </a:ext>
              </a:extLst>
            </p:cNvPr>
            <p:cNvGrpSpPr/>
            <p:nvPr/>
          </p:nvGrpSpPr>
          <p:grpSpPr>
            <a:xfrm>
              <a:off x="2025430" y="595411"/>
              <a:ext cx="606507" cy="366908"/>
              <a:chOff x="4063357" y="5656787"/>
              <a:chExt cx="694351" cy="405362"/>
            </a:xfrm>
          </p:grpSpPr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9D486263-29A5-47CA-862D-CBDAA2677339}"/>
                  </a:ext>
                </a:extLst>
              </p:cNvPr>
              <p:cNvSpPr txBox="1"/>
              <p:nvPr/>
            </p:nvSpPr>
            <p:spPr>
              <a:xfrm>
                <a:off x="4063357" y="5656787"/>
                <a:ext cx="694351" cy="2210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250 </a:t>
                </a:r>
                <a:r>
                  <a:rPr lang="en-US" sz="7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58B4212D-E00C-4850-9BD0-8B5EB242559A}"/>
                  </a:ext>
                </a:extLst>
              </p:cNvPr>
              <p:cNvSpPr txBox="1"/>
              <p:nvPr/>
            </p:nvSpPr>
            <p:spPr>
              <a:xfrm>
                <a:off x="4063357" y="5841125"/>
                <a:ext cx="694348" cy="2210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150 </a:t>
                </a:r>
                <a:r>
                  <a:rPr lang="en-US" sz="7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9ACD15A5-6D9E-42F4-B7A9-76552AE74F54}"/>
                </a:ext>
              </a:extLst>
            </p:cNvPr>
            <p:cNvSpPr txBox="1"/>
            <p:nvPr/>
          </p:nvSpPr>
          <p:spPr>
            <a:xfrm>
              <a:off x="2025430" y="1610131"/>
              <a:ext cx="5755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 </a:t>
              </a:r>
              <a:r>
                <a:rPr lang="en-US" sz="7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1FCC2428-025B-4489-A613-224B35A9902A}"/>
              </a:ext>
            </a:extLst>
          </p:cNvPr>
          <p:cNvGrpSpPr/>
          <p:nvPr/>
        </p:nvGrpSpPr>
        <p:grpSpPr>
          <a:xfrm>
            <a:off x="2733683" y="4482907"/>
            <a:ext cx="606507" cy="1626098"/>
            <a:chOff x="2017499" y="583056"/>
            <a:chExt cx="606507" cy="990318"/>
          </a:xfrm>
        </p:grpSpPr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308FF941-5F56-44A4-AF07-8C484D578B0E}"/>
                </a:ext>
              </a:extLst>
            </p:cNvPr>
            <p:cNvGrpSpPr/>
            <p:nvPr/>
          </p:nvGrpSpPr>
          <p:grpSpPr>
            <a:xfrm>
              <a:off x="2017499" y="583056"/>
              <a:ext cx="606507" cy="366908"/>
              <a:chOff x="4054278" y="5643137"/>
              <a:chExt cx="694351" cy="405362"/>
            </a:xfrm>
          </p:grpSpPr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4B2F9CC2-E98C-4C76-A5B0-03A732E55431}"/>
                  </a:ext>
                </a:extLst>
              </p:cNvPr>
              <p:cNvSpPr txBox="1"/>
              <p:nvPr/>
            </p:nvSpPr>
            <p:spPr>
              <a:xfrm>
                <a:off x="4054278" y="5643137"/>
                <a:ext cx="694351" cy="2210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250 </a:t>
                </a:r>
                <a:r>
                  <a:rPr lang="en-US" sz="7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6DA9BEE7-ACDE-4B03-A803-AC4971160FD4}"/>
                  </a:ext>
                </a:extLst>
              </p:cNvPr>
              <p:cNvSpPr txBox="1"/>
              <p:nvPr/>
            </p:nvSpPr>
            <p:spPr>
              <a:xfrm>
                <a:off x="4054278" y="5827475"/>
                <a:ext cx="694348" cy="2210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150 </a:t>
                </a:r>
                <a:r>
                  <a:rPr lang="en-US" sz="7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FC4C52B-7F0E-4205-946D-695CB8BC63FE}"/>
                </a:ext>
              </a:extLst>
            </p:cNvPr>
            <p:cNvSpPr txBox="1"/>
            <p:nvPr/>
          </p:nvSpPr>
          <p:spPr>
            <a:xfrm>
              <a:off x="2025154" y="1373319"/>
              <a:ext cx="5755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0 </a:t>
              </a:r>
              <a:r>
                <a:rPr lang="en-US" sz="7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7E0DC5D3-D964-485C-B02F-08D47BE0A2F6}"/>
              </a:ext>
            </a:extLst>
          </p:cNvPr>
          <p:cNvGrpSpPr/>
          <p:nvPr/>
        </p:nvGrpSpPr>
        <p:grpSpPr>
          <a:xfrm>
            <a:off x="5801240" y="1506598"/>
            <a:ext cx="606507" cy="574353"/>
            <a:chOff x="2025430" y="595411"/>
            <a:chExt cx="606507" cy="574353"/>
          </a:xfrm>
        </p:grpSpPr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A887804A-20FA-4294-9E8D-2005CCF92855}"/>
                </a:ext>
              </a:extLst>
            </p:cNvPr>
            <p:cNvGrpSpPr/>
            <p:nvPr/>
          </p:nvGrpSpPr>
          <p:grpSpPr>
            <a:xfrm>
              <a:off x="2025430" y="595411"/>
              <a:ext cx="606507" cy="366908"/>
              <a:chOff x="4063357" y="5656787"/>
              <a:chExt cx="694351" cy="405362"/>
            </a:xfrm>
          </p:grpSpPr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52B4CBB8-993E-4419-8CF7-4BD10C4BEB65}"/>
                  </a:ext>
                </a:extLst>
              </p:cNvPr>
              <p:cNvSpPr txBox="1"/>
              <p:nvPr/>
            </p:nvSpPr>
            <p:spPr>
              <a:xfrm>
                <a:off x="4063357" y="5656787"/>
                <a:ext cx="694351" cy="2210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250 </a:t>
                </a:r>
                <a:r>
                  <a:rPr lang="en-US" sz="7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680347EF-0628-4D0A-B33A-A17BD172C3CB}"/>
                  </a:ext>
                </a:extLst>
              </p:cNvPr>
              <p:cNvSpPr txBox="1"/>
              <p:nvPr/>
            </p:nvSpPr>
            <p:spPr>
              <a:xfrm>
                <a:off x="4063357" y="5841125"/>
                <a:ext cx="694348" cy="2210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150 </a:t>
                </a:r>
                <a:r>
                  <a:rPr lang="en-US" sz="7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CF466F39-B31E-4174-8EE1-61F8BFEDEB7A}"/>
                </a:ext>
              </a:extLst>
            </p:cNvPr>
            <p:cNvSpPr txBox="1"/>
            <p:nvPr/>
          </p:nvSpPr>
          <p:spPr>
            <a:xfrm>
              <a:off x="2040909" y="969709"/>
              <a:ext cx="5755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00 </a:t>
              </a:r>
              <a:r>
                <a:rPr lang="en-US" sz="7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1" name="TextBox 60">
            <a:extLst>
              <a:ext uri="{FF2B5EF4-FFF2-40B4-BE49-F238E27FC236}">
                <a16:creationId xmlns:a16="http://schemas.microsoft.com/office/drawing/2014/main" id="{9EB79012-1746-4943-A57F-FF6673CB9F33}"/>
              </a:ext>
            </a:extLst>
          </p:cNvPr>
          <p:cNvSpPr txBox="1"/>
          <p:nvPr/>
        </p:nvSpPr>
        <p:spPr>
          <a:xfrm>
            <a:off x="3552930" y="587979"/>
            <a:ext cx="350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494A6BA-114E-4387-B042-6BCBACD968CF}"/>
              </a:ext>
            </a:extLst>
          </p:cNvPr>
          <p:cNvSpPr txBox="1"/>
          <p:nvPr/>
        </p:nvSpPr>
        <p:spPr>
          <a:xfrm>
            <a:off x="3815910" y="5956470"/>
            <a:ext cx="4998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3645EC5B-75E3-4DCB-A40E-A10473E1D2A2}"/>
              </a:ext>
            </a:extLst>
          </p:cNvPr>
          <p:cNvSpPr txBox="1"/>
          <p:nvPr/>
        </p:nvSpPr>
        <p:spPr>
          <a:xfrm>
            <a:off x="3547599" y="3656705"/>
            <a:ext cx="4523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3916B68F-B3CB-4B57-B7E6-7962447AA35D}"/>
              </a:ext>
            </a:extLst>
          </p:cNvPr>
          <p:cNvSpPr txBox="1"/>
          <p:nvPr/>
        </p:nvSpPr>
        <p:spPr>
          <a:xfrm>
            <a:off x="6006129" y="5779150"/>
            <a:ext cx="57554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50 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6" name="Group 115">
            <a:extLst>
              <a:ext uri="{FF2B5EF4-FFF2-40B4-BE49-F238E27FC236}">
                <a16:creationId xmlns:a16="http://schemas.microsoft.com/office/drawing/2014/main" id="{367D2EB2-E3A2-4832-8201-EDEB3CFB2F92}"/>
              </a:ext>
            </a:extLst>
          </p:cNvPr>
          <p:cNvGrpSpPr/>
          <p:nvPr/>
        </p:nvGrpSpPr>
        <p:grpSpPr>
          <a:xfrm>
            <a:off x="4268591" y="3595162"/>
            <a:ext cx="1725981" cy="552013"/>
            <a:chOff x="852478" y="67248"/>
            <a:chExt cx="1725981" cy="552013"/>
          </a:xfrm>
        </p:grpSpPr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096DDF72-2826-43FF-ADAD-A01426EDE9A8}"/>
                </a:ext>
              </a:extLst>
            </p:cNvPr>
            <p:cNvSpPr txBox="1"/>
            <p:nvPr/>
          </p:nvSpPr>
          <p:spPr>
            <a:xfrm>
              <a:off x="852478" y="67248"/>
              <a:ext cx="6065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ural Tubes 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20A27405-3A75-493E-87BF-A2069F653986}"/>
                </a:ext>
              </a:extLst>
            </p:cNvPr>
            <p:cNvSpPr txBox="1"/>
            <p:nvPr/>
          </p:nvSpPr>
          <p:spPr>
            <a:xfrm>
              <a:off x="1934474" y="116165"/>
              <a:ext cx="51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PCs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3B7CB809-ED45-4194-B869-53CE5336EC05}"/>
                </a:ext>
              </a:extLst>
            </p:cNvPr>
            <p:cNvSpPr txBox="1"/>
            <p:nvPr/>
          </p:nvSpPr>
          <p:spPr>
            <a:xfrm>
              <a:off x="1859416" y="403817"/>
              <a:ext cx="7190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O   WT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40A341C3-E066-4884-A56A-0257AD495775}"/>
                </a:ext>
              </a:extLst>
            </p:cNvPr>
            <p:cNvSpPr txBox="1"/>
            <p:nvPr/>
          </p:nvSpPr>
          <p:spPr>
            <a:xfrm>
              <a:off x="888358" y="393647"/>
              <a:ext cx="666160" cy="2238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  KO</a:t>
              </a:r>
            </a:p>
          </p:txBody>
        </p:sp>
      </p:grpSp>
      <p:grpSp>
        <p:nvGrpSpPr>
          <p:cNvPr id="121" name="Group 120">
            <a:extLst>
              <a:ext uri="{FF2B5EF4-FFF2-40B4-BE49-F238E27FC236}">
                <a16:creationId xmlns:a16="http://schemas.microsoft.com/office/drawing/2014/main" id="{68522E31-4364-46D7-83BF-11F034C4E8DE}"/>
              </a:ext>
            </a:extLst>
          </p:cNvPr>
          <p:cNvGrpSpPr/>
          <p:nvPr/>
        </p:nvGrpSpPr>
        <p:grpSpPr>
          <a:xfrm>
            <a:off x="4315758" y="689463"/>
            <a:ext cx="1547541" cy="507804"/>
            <a:chOff x="901284" y="92340"/>
            <a:chExt cx="1547541" cy="507804"/>
          </a:xfrm>
        </p:grpSpPr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A2C12382-D00B-44A9-AF93-A0E786CD07A2}"/>
                </a:ext>
              </a:extLst>
            </p:cNvPr>
            <p:cNvSpPr txBox="1"/>
            <p:nvPr/>
          </p:nvSpPr>
          <p:spPr>
            <a:xfrm>
              <a:off x="901284" y="92340"/>
              <a:ext cx="6065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ural Tubes 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A4B7FB70-2616-47FA-B95D-85813FCD5B6D}"/>
                </a:ext>
              </a:extLst>
            </p:cNvPr>
            <p:cNvSpPr txBox="1"/>
            <p:nvPr/>
          </p:nvSpPr>
          <p:spPr>
            <a:xfrm>
              <a:off x="1789516" y="131671"/>
              <a:ext cx="5145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PCs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E57D00C0-0BE8-4BD8-91AE-0A039C1E1F9A}"/>
                </a:ext>
              </a:extLst>
            </p:cNvPr>
            <p:cNvSpPr txBox="1"/>
            <p:nvPr/>
          </p:nvSpPr>
          <p:spPr>
            <a:xfrm>
              <a:off x="1729782" y="313602"/>
              <a:ext cx="7190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O   WT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9B8F9685-E800-4E16-A220-6F7B32D0B491}"/>
                </a:ext>
              </a:extLst>
            </p:cNvPr>
            <p:cNvSpPr txBox="1"/>
            <p:nvPr/>
          </p:nvSpPr>
          <p:spPr>
            <a:xfrm>
              <a:off x="947328" y="384700"/>
              <a:ext cx="7190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O   WT</a:t>
              </a:r>
            </a:p>
          </p:txBody>
        </p:sp>
      </p:grpSp>
      <p:sp>
        <p:nvSpPr>
          <p:cNvPr id="126" name="TextBox 125">
            <a:extLst>
              <a:ext uri="{FF2B5EF4-FFF2-40B4-BE49-F238E27FC236}">
                <a16:creationId xmlns:a16="http://schemas.microsoft.com/office/drawing/2014/main" id="{68667B7B-8FFE-4F9C-8FE5-322C7ACAFB10}"/>
              </a:ext>
            </a:extLst>
          </p:cNvPr>
          <p:cNvSpPr txBox="1"/>
          <p:nvPr/>
        </p:nvSpPr>
        <p:spPr>
          <a:xfrm>
            <a:off x="3590029" y="4553745"/>
            <a:ext cx="7309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LR2A</a:t>
            </a:r>
          </a:p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P-S5 Ab)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CCB0FC20-8CB7-4D14-9F60-C5FEFE640F7A}"/>
              </a:ext>
            </a:extLst>
          </p:cNvPr>
          <p:cNvSpPr txBox="1"/>
          <p:nvPr/>
        </p:nvSpPr>
        <p:spPr>
          <a:xfrm>
            <a:off x="3644087" y="1396752"/>
            <a:ext cx="7309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LR2A</a:t>
            </a:r>
          </a:p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P-S2 Ab)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591257C3-36F1-4C5B-BB9A-AA70F8AD726D}"/>
              </a:ext>
            </a:extLst>
          </p:cNvPr>
          <p:cNvSpPr txBox="1"/>
          <p:nvPr/>
        </p:nvSpPr>
        <p:spPr>
          <a:xfrm>
            <a:off x="2746468" y="1918727"/>
            <a:ext cx="7229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IB with irrelevant antibody</a:t>
            </a:r>
          </a:p>
        </p:txBody>
      </p:sp>
      <p:pic>
        <p:nvPicPr>
          <p:cNvPr id="142" name="Picture 141">
            <a:extLst>
              <a:ext uri="{FF2B5EF4-FFF2-40B4-BE49-F238E27FC236}">
                <a16:creationId xmlns:a16="http://schemas.microsoft.com/office/drawing/2014/main" id="{DC268526-9C50-4A6D-BE04-C9E9BA6B911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52815" t="13543" r="-9402" b="4716"/>
          <a:stretch/>
        </p:blipFill>
        <p:spPr>
          <a:xfrm>
            <a:off x="1198181" y="976556"/>
            <a:ext cx="771501" cy="2220445"/>
          </a:xfrm>
          <a:prstGeom prst="rect">
            <a:avLst/>
          </a:prstGeom>
        </p:spPr>
      </p:pic>
      <p:pic>
        <p:nvPicPr>
          <p:cNvPr id="148" name="Picture 147">
            <a:extLst>
              <a:ext uri="{FF2B5EF4-FFF2-40B4-BE49-F238E27FC236}">
                <a16:creationId xmlns:a16="http://schemas.microsoft.com/office/drawing/2014/main" id="{AA1AC399-6282-4601-BB9D-C7C68EC7436A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grayscl/>
          </a:blip>
          <a:srcRect t="24501"/>
          <a:stretch/>
        </p:blipFill>
        <p:spPr>
          <a:xfrm flipH="1">
            <a:off x="4292753" y="1159546"/>
            <a:ext cx="857140" cy="1200520"/>
          </a:xfrm>
          <a:prstGeom prst="rect">
            <a:avLst/>
          </a:prstGeom>
        </p:spPr>
      </p:pic>
      <p:pic>
        <p:nvPicPr>
          <p:cNvPr id="151" name="Picture 150">
            <a:extLst>
              <a:ext uri="{FF2B5EF4-FFF2-40B4-BE49-F238E27FC236}">
                <a16:creationId xmlns:a16="http://schemas.microsoft.com/office/drawing/2014/main" id="{D5ADE5ED-BDD8-4C8F-88CB-E450B8DA6F5C}"/>
              </a:ext>
            </a:extLst>
          </p:cNvPr>
          <p:cNvPicPr>
            <a:picLocks noChangeAspect="1"/>
          </p:cNvPicPr>
          <p:nvPr/>
        </p:nvPicPr>
        <p:blipFill>
          <a:blip r:embed="rId10">
            <a:grayscl/>
          </a:blip>
          <a:stretch>
            <a:fillRect/>
          </a:stretch>
        </p:blipFill>
        <p:spPr>
          <a:xfrm flipH="1">
            <a:off x="4301656" y="2393443"/>
            <a:ext cx="863134" cy="878885"/>
          </a:xfrm>
          <a:prstGeom prst="rect">
            <a:avLst/>
          </a:prstGeom>
        </p:spPr>
      </p:pic>
      <p:sp>
        <p:nvSpPr>
          <p:cNvPr id="130" name="TextBox 129">
            <a:extLst>
              <a:ext uri="{FF2B5EF4-FFF2-40B4-BE49-F238E27FC236}">
                <a16:creationId xmlns:a16="http://schemas.microsoft.com/office/drawing/2014/main" id="{349A34DC-2902-4F7B-830A-F6611B6C0405}"/>
              </a:ext>
            </a:extLst>
          </p:cNvPr>
          <p:cNvSpPr txBox="1"/>
          <p:nvPr/>
        </p:nvSpPr>
        <p:spPr>
          <a:xfrm>
            <a:off x="3784176" y="2755691"/>
            <a:ext cx="4998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5BF465B-E727-4ACF-B9F3-654C07E879DA}"/>
              </a:ext>
            </a:extLst>
          </p:cNvPr>
          <p:cNvSpPr txBox="1"/>
          <p:nvPr/>
        </p:nvSpPr>
        <p:spPr>
          <a:xfrm>
            <a:off x="4284024" y="1889078"/>
            <a:ext cx="7282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LR2A (P-S2 Ab)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EAC281E8-47C3-4B9C-A213-C05ABAF7508B}"/>
              </a:ext>
            </a:extLst>
          </p:cNvPr>
          <p:cNvSpPr txBox="1"/>
          <p:nvPr/>
        </p:nvSpPr>
        <p:spPr>
          <a:xfrm>
            <a:off x="5770835" y="2445027"/>
            <a:ext cx="57554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50 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98921B93-A5CB-4164-B1E1-C4B674879B7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V="1">
            <a:off x="1081609" y="5595463"/>
            <a:ext cx="674090" cy="79474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B2BA39A-7262-43F3-9797-53A78CA542E6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201286" y="1140564"/>
            <a:ext cx="650294" cy="1780377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E5842E2-132E-4710-A19A-F3CFFC62AB33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6499"/>
          <a:stretch/>
        </p:blipFill>
        <p:spPr>
          <a:xfrm flipH="1">
            <a:off x="4310605" y="4202821"/>
            <a:ext cx="831704" cy="2129929"/>
          </a:xfrm>
          <a:prstGeom prst="rect">
            <a:avLst/>
          </a:prstGeom>
        </p:spPr>
      </p:pic>
      <p:grpSp>
        <p:nvGrpSpPr>
          <p:cNvPr id="125" name="Group 124">
            <a:extLst>
              <a:ext uri="{FF2B5EF4-FFF2-40B4-BE49-F238E27FC236}">
                <a16:creationId xmlns:a16="http://schemas.microsoft.com/office/drawing/2014/main" id="{D6661C71-FBE7-4E25-95B9-0CC58442B545}"/>
              </a:ext>
            </a:extLst>
          </p:cNvPr>
          <p:cNvGrpSpPr/>
          <p:nvPr/>
        </p:nvGrpSpPr>
        <p:grpSpPr>
          <a:xfrm>
            <a:off x="5968810" y="4529577"/>
            <a:ext cx="606507" cy="574353"/>
            <a:chOff x="2025430" y="595411"/>
            <a:chExt cx="606507" cy="574353"/>
          </a:xfrm>
        </p:grpSpPr>
        <p:grpSp>
          <p:nvGrpSpPr>
            <p:cNvPr id="128" name="Group 127">
              <a:extLst>
                <a:ext uri="{FF2B5EF4-FFF2-40B4-BE49-F238E27FC236}">
                  <a16:creationId xmlns:a16="http://schemas.microsoft.com/office/drawing/2014/main" id="{C0D77432-293F-418F-B687-11B55AAE501B}"/>
                </a:ext>
              </a:extLst>
            </p:cNvPr>
            <p:cNvGrpSpPr/>
            <p:nvPr/>
          </p:nvGrpSpPr>
          <p:grpSpPr>
            <a:xfrm>
              <a:off x="2025430" y="595411"/>
              <a:ext cx="606507" cy="366908"/>
              <a:chOff x="4063357" y="5656787"/>
              <a:chExt cx="694351" cy="405362"/>
            </a:xfrm>
          </p:grpSpPr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E3635E07-B25A-4961-9E03-51F051EF0DF5}"/>
                  </a:ext>
                </a:extLst>
              </p:cNvPr>
              <p:cNvSpPr txBox="1"/>
              <p:nvPr/>
            </p:nvSpPr>
            <p:spPr>
              <a:xfrm>
                <a:off x="4063357" y="5656787"/>
                <a:ext cx="694351" cy="2210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250 </a:t>
                </a:r>
                <a:r>
                  <a:rPr lang="en-US" sz="7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18DA1E28-6BF0-4A60-A037-11EBCA3C87C6}"/>
                  </a:ext>
                </a:extLst>
              </p:cNvPr>
              <p:cNvSpPr txBox="1"/>
              <p:nvPr/>
            </p:nvSpPr>
            <p:spPr>
              <a:xfrm>
                <a:off x="4063357" y="5841125"/>
                <a:ext cx="694348" cy="2210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150 </a:t>
                </a:r>
                <a:r>
                  <a:rPr lang="en-US" sz="7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3B484849-063D-4512-A537-DA478D380905}"/>
                </a:ext>
              </a:extLst>
            </p:cNvPr>
            <p:cNvSpPr txBox="1"/>
            <p:nvPr/>
          </p:nvSpPr>
          <p:spPr>
            <a:xfrm>
              <a:off x="2040909" y="969709"/>
              <a:ext cx="5755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00 </a:t>
              </a:r>
              <a:r>
                <a:rPr lang="en-US" sz="7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9" name="TextBox 78">
            <a:extLst>
              <a:ext uri="{FF2B5EF4-FFF2-40B4-BE49-F238E27FC236}">
                <a16:creationId xmlns:a16="http://schemas.microsoft.com/office/drawing/2014/main" id="{94B0509F-1A00-4596-8427-6CF6313A8461}"/>
              </a:ext>
            </a:extLst>
          </p:cNvPr>
          <p:cNvSpPr txBox="1"/>
          <p:nvPr/>
        </p:nvSpPr>
        <p:spPr>
          <a:xfrm>
            <a:off x="218513" y="122841"/>
            <a:ext cx="1472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4 </a:t>
            </a:r>
            <a:endParaRPr lang="en-CA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920232C-450F-4446-812F-723FF2DDBF00}"/>
              </a:ext>
            </a:extLst>
          </p:cNvPr>
          <p:cNvSpPr/>
          <p:nvPr/>
        </p:nvSpPr>
        <p:spPr>
          <a:xfrm>
            <a:off x="3509039" y="3581400"/>
            <a:ext cx="3050796" cy="30765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C96A9A53-1BE8-4994-AF55-F06EE2252B10}"/>
              </a:ext>
            </a:extLst>
          </p:cNvPr>
          <p:cNvSpPr/>
          <p:nvPr/>
        </p:nvSpPr>
        <p:spPr>
          <a:xfrm>
            <a:off x="439264" y="3595162"/>
            <a:ext cx="2958279" cy="30618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C935482B-F51D-4F54-AAA8-0FD1D4D0724A}"/>
              </a:ext>
            </a:extLst>
          </p:cNvPr>
          <p:cNvSpPr/>
          <p:nvPr/>
        </p:nvSpPr>
        <p:spPr>
          <a:xfrm>
            <a:off x="441098" y="548834"/>
            <a:ext cx="2953253" cy="29458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6B4AA5E-18D5-4555-9E4E-B47665DDD591}"/>
              </a:ext>
            </a:extLst>
          </p:cNvPr>
          <p:cNvSpPr/>
          <p:nvPr/>
        </p:nvSpPr>
        <p:spPr>
          <a:xfrm>
            <a:off x="3509038" y="548746"/>
            <a:ext cx="3050796" cy="29458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4" name="Right Brace 23">
            <a:extLst>
              <a:ext uri="{FF2B5EF4-FFF2-40B4-BE49-F238E27FC236}">
                <a16:creationId xmlns:a16="http://schemas.microsoft.com/office/drawing/2014/main" id="{24F52DA0-BE39-4D2C-9AC9-207F9B55CA1D}"/>
              </a:ext>
            </a:extLst>
          </p:cNvPr>
          <p:cNvSpPr/>
          <p:nvPr/>
        </p:nvSpPr>
        <p:spPr>
          <a:xfrm>
            <a:off x="2715933" y="2041543"/>
            <a:ext cx="45719" cy="234755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302BE3A1-A287-490A-8D31-F85809FA0100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46589" y="4334358"/>
            <a:ext cx="739442" cy="1209737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DF7EE131-20BF-4A9D-90FC-830F073615F5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258635" y="4172954"/>
            <a:ext cx="734744" cy="23394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35150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342ECFA-4DFE-4416-8BFB-A05AEAC6C4B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</a:blip>
          <a:srcRect t="12383" b="49980"/>
          <a:stretch/>
        </p:blipFill>
        <p:spPr>
          <a:xfrm flipH="1">
            <a:off x="4831629" y="2745912"/>
            <a:ext cx="1456105" cy="78570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F9A5B6F-D11F-49E2-BF90-0E0967E0F7F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</a:blip>
          <a:srcRect l="24298" t="-2913" r="3472" b="2913"/>
          <a:stretch/>
        </p:blipFill>
        <p:spPr>
          <a:xfrm>
            <a:off x="670841" y="5646665"/>
            <a:ext cx="1108622" cy="66577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6AF8622-425B-41CF-B645-2C5FDCF7A4A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</a:blip>
          <a:srcRect l="10376" t="61750" r="30709" b="5700"/>
          <a:stretch/>
        </p:blipFill>
        <p:spPr>
          <a:xfrm>
            <a:off x="2704143" y="994335"/>
            <a:ext cx="1381469" cy="99689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6C31010-7280-4D4A-BCD3-92A85948FBC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grayscl/>
          </a:blip>
          <a:srcRect l="15251" t="57412"/>
          <a:stretch/>
        </p:blipFill>
        <p:spPr>
          <a:xfrm>
            <a:off x="5050181" y="4310560"/>
            <a:ext cx="1143809" cy="100645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161F1BF-791A-4E99-AEB7-0538EA3CCCA7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grayscl/>
          </a:blip>
          <a:srcRect t="12459"/>
          <a:stretch/>
        </p:blipFill>
        <p:spPr>
          <a:xfrm>
            <a:off x="4810514" y="1099000"/>
            <a:ext cx="1391380" cy="91411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D63B6D7-1E5C-45BA-A0CC-795D61A104B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grayscl/>
          </a:blip>
          <a:srcRect r="6256"/>
          <a:stretch/>
        </p:blipFill>
        <p:spPr>
          <a:xfrm>
            <a:off x="2736916" y="5291334"/>
            <a:ext cx="1337147" cy="104415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92513AD-C775-46F2-9884-25CCC63ED5C7}"/>
              </a:ext>
            </a:extLst>
          </p:cNvPr>
          <p:cNvPicPr>
            <a:picLocks noChangeAspect="1"/>
          </p:cNvPicPr>
          <p:nvPr/>
        </p:nvPicPr>
        <p:blipFill>
          <a:blip r:embed="rId9">
            <a:grayscl/>
          </a:blip>
          <a:stretch>
            <a:fillRect/>
          </a:stretch>
        </p:blipFill>
        <p:spPr>
          <a:xfrm>
            <a:off x="2751784" y="4384173"/>
            <a:ext cx="1324014" cy="74372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20A2867-86BC-4691-A3B7-6FB09D806D39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grayscl/>
          </a:blip>
          <a:srcRect l="21495" t="17523" r="23720"/>
          <a:stretch/>
        </p:blipFill>
        <p:spPr>
          <a:xfrm>
            <a:off x="641962" y="4418307"/>
            <a:ext cx="1119981" cy="77850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1A305696-DD10-4C29-A12C-C2050D3D068B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-578" t="51724" r="14543" b="9042"/>
          <a:stretch/>
        </p:blipFill>
        <p:spPr>
          <a:xfrm>
            <a:off x="603827" y="978509"/>
            <a:ext cx="1116212" cy="1443579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B6A60AC-D4CE-43F6-BD1B-0773C0E0FCD5}"/>
              </a:ext>
            </a:extLst>
          </p:cNvPr>
          <p:cNvSpPr txBox="1"/>
          <p:nvPr/>
        </p:nvSpPr>
        <p:spPr>
          <a:xfrm>
            <a:off x="148371" y="38048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5966870-CC19-4C6E-AB23-B22FD76D1D41}"/>
              </a:ext>
            </a:extLst>
          </p:cNvPr>
          <p:cNvSpPr txBox="1"/>
          <p:nvPr/>
        </p:nvSpPr>
        <p:spPr>
          <a:xfrm>
            <a:off x="612689" y="6305511"/>
            <a:ext cx="12461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-a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i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8BC77AA-F296-427D-B7A5-DA4DA16E899D}"/>
              </a:ext>
            </a:extLst>
          </p:cNvPr>
          <p:cNvSpPr txBox="1"/>
          <p:nvPr/>
        </p:nvSpPr>
        <p:spPr>
          <a:xfrm>
            <a:off x="4957572" y="5082711"/>
            <a:ext cx="1431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POLR2A (4H8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3555110-90EB-4D67-9DD2-2A428248991B}"/>
              </a:ext>
            </a:extLst>
          </p:cNvPr>
          <p:cNvSpPr txBox="1"/>
          <p:nvPr/>
        </p:nvSpPr>
        <p:spPr>
          <a:xfrm>
            <a:off x="1055654" y="4160592"/>
            <a:ext cx="5505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76F3EA6A-9CFC-4D02-9418-74F3EC44269E}"/>
              </a:ext>
            </a:extLst>
          </p:cNvPr>
          <p:cNvCxnSpPr/>
          <p:nvPr/>
        </p:nvCxnSpPr>
        <p:spPr>
          <a:xfrm flipH="1">
            <a:off x="730113" y="4354557"/>
            <a:ext cx="1007223" cy="140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" name="Group 22">
            <a:extLst>
              <a:ext uri="{FF2B5EF4-FFF2-40B4-BE49-F238E27FC236}">
                <a16:creationId xmlns:a16="http://schemas.microsoft.com/office/drawing/2014/main" id="{CAAE85D3-94F1-4B8F-959E-159AC945DF20}"/>
              </a:ext>
            </a:extLst>
          </p:cNvPr>
          <p:cNvGrpSpPr/>
          <p:nvPr/>
        </p:nvGrpSpPr>
        <p:grpSpPr>
          <a:xfrm>
            <a:off x="1667410" y="1580766"/>
            <a:ext cx="497498" cy="727281"/>
            <a:chOff x="1211140" y="2242903"/>
            <a:chExt cx="515766" cy="753985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1909447-57F0-4C6B-BB33-73004C1E9A32}"/>
                </a:ext>
              </a:extLst>
            </p:cNvPr>
            <p:cNvSpPr txBox="1"/>
            <p:nvPr/>
          </p:nvSpPr>
          <p:spPr>
            <a:xfrm>
              <a:off x="1211140" y="2242903"/>
              <a:ext cx="512631" cy="207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10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AC574DA-162B-48A9-95F1-5BBF6624DE9D}"/>
                </a:ext>
              </a:extLst>
            </p:cNvPr>
            <p:cNvSpPr txBox="1"/>
            <p:nvPr/>
          </p:nvSpPr>
          <p:spPr>
            <a:xfrm>
              <a:off x="1218959" y="2789489"/>
              <a:ext cx="507947" cy="2073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70C9484A-57D3-4E3F-AA70-8B2FB552139B}"/>
                </a:ext>
              </a:extLst>
            </p:cNvPr>
            <p:cNvSpPr txBox="1"/>
            <p:nvPr/>
          </p:nvSpPr>
          <p:spPr>
            <a:xfrm>
              <a:off x="1211539" y="2408153"/>
              <a:ext cx="512631" cy="2073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75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73DFF2F1-8AEE-4B94-A4D6-798E554C1E93}"/>
              </a:ext>
            </a:extLst>
          </p:cNvPr>
          <p:cNvSpPr txBox="1"/>
          <p:nvPr/>
        </p:nvSpPr>
        <p:spPr>
          <a:xfrm>
            <a:off x="4722120" y="3554951"/>
            <a:ext cx="17277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POLR2A (4H8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342DD42-4864-48E1-8991-0C8DA9EA957F}"/>
              </a:ext>
            </a:extLst>
          </p:cNvPr>
          <p:cNvSpPr txBox="1"/>
          <p:nvPr/>
        </p:nvSpPr>
        <p:spPr>
          <a:xfrm>
            <a:off x="636357" y="3837327"/>
            <a:ext cx="11007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IB:</a:t>
            </a:r>
            <a:r>
              <a:rPr lang="en-US" sz="800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-Ubiqui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200D9FD3-B41A-43FC-A77F-817CAF9DF010}"/>
              </a:ext>
            </a:extLst>
          </p:cNvPr>
          <p:cNvCxnSpPr/>
          <p:nvPr/>
        </p:nvCxnSpPr>
        <p:spPr>
          <a:xfrm>
            <a:off x="793653" y="576452"/>
            <a:ext cx="404709" cy="162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038DBC9F-9C4A-4FEA-878E-44A9B536F193}"/>
              </a:ext>
            </a:extLst>
          </p:cNvPr>
          <p:cNvSpPr txBox="1"/>
          <p:nvPr/>
        </p:nvSpPr>
        <p:spPr>
          <a:xfrm>
            <a:off x="736981" y="389387"/>
            <a:ext cx="12101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P: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 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   IP: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mIgG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ED2725EE-E4D6-4B88-B208-8276DDC9F7A7}"/>
              </a:ext>
            </a:extLst>
          </p:cNvPr>
          <p:cNvCxnSpPr/>
          <p:nvPr/>
        </p:nvCxnSpPr>
        <p:spPr>
          <a:xfrm>
            <a:off x="1306774" y="576452"/>
            <a:ext cx="404709" cy="162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1" name="Group 30">
            <a:extLst>
              <a:ext uri="{FF2B5EF4-FFF2-40B4-BE49-F238E27FC236}">
                <a16:creationId xmlns:a16="http://schemas.microsoft.com/office/drawing/2014/main" id="{44592195-D6EF-44F1-BD17-94E3880D2FC7}"/>
              </a:ext>
            </a:extLst>
          </p:cNvPr>
          <p:cNvGrpSpPr/>
          <p:nvPr/>
        </p:nvGrpSpPr>
        <p:grpSpPr>
          <a:xfrm>
            <a:off x="697832" y="601542"/>
            <a:ext cx="1164167" cy="425171"/>
            <a:chOff x="2596925" y="300173"/>
            <a:chExt cx="1164167" cy="425171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F763E098-6405-405A-A152-A31EE9D5A03D}"/>
                </a:ext>
              </a:extLst>
            </p:cNvPr>
            <p:cNvSpPr txBox="1"/>
            <p:nvPr/>
          </p:nvSpPr>
          <p:spPr>
            <a:xfrm>
              <a:off x="2869503" y="300173"/>
              <a:ext cx="5381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G132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C2AA249-BB78-41B5-A6D8-1BCFE0CD3B29}"/>
                </a:ext>
              </a:extLst>
            </p:cNvPr>
            <p:cNvSpPr txBox="1"/>
            <p:nvPr/>
          </p:nvSpPr>
          <p:spPr>
            <a:xfrm>
              <a:off x="2596925" y="509900"/>
              <a:ext cx="116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KO   WT   KO   WT    </a:t>
              </a:r>
            </a:p>
          </p:txBody>
        </p: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87861D0D-CA7C-42A8-9977-EBE0DD7C1A46}"/>
                </a:ext>
              </a:extLst>
            </p:cNvPr>
            <p:cNvCxnSpPr/>
            <p:nvPr/>
          </p:nvCxnSpPr>
          <p:spPr>
            <a:xfrm>
              <a:off x="2682858" y="505245"/>
              <a:ext cx="851465" cy="1523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0DA5918D-6BFF-4A18-AB73-07B454BDF995}"/>
              </a:ext>
            </a:extLst>
          </p:cNvPr>
          <p:cNvGrpSpPr/>
          <p:nvPr/>
        </p:nvGrpSpPr>
        <p:grpSpPr>
          <a:xfrm>
            <a:off x="1671342" y="1212176"/>
            <a:ext cx="607802" cy="367833"/>
            <a:chOff x="1209247" y="2139973"/>
            <a:chExt cx="630119" cy="381339"/>
          </a:xfrm>
        </p:grpSpPr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D8191CE-D06F-4E91-B6A0-C9F3A61E606C}"/>
                </a:ext>
              </a:extLst>
            </p:cNvPr>
            <p:cNvSpPr txBox="1"/>
            <p:nvPr/>
          </p:nvSpPr>
          <p:spPr>
            <a:xfrm>
              <a:off x="1211000" y="2139973"/>
              <a:ext cx="628366" cy="207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2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7835FCF-CAC4-49D9-8120-B30C6608FCE8}"/>
                </a:ext>
              </a:extLst>
            </p:cNvPr>
            <p:cNvSpPr txBox="1"/>
            <p:nvPr/>
          </p:nvSpPr>
          <p:spPr>
            <a:xfrm>
              <a:off x="1209247" y="2313912"/>
              <a:ext cx="628366" cy="207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1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D7140D5F-3B07-4CF4-9029-E6C6C7E71904}"/>
              </a:ext>
            </a:extLst>
          </p:cNvPr>
          <p:cNvGrpSpPr/>
          <p:nvPr/>
        </p:nvGrpSpPr>
        <p:grpSpPr>
          <a:xfrm>
            <a:off x="1723012" y="1101701"/>
            <a:ext cx="661219" cy="224367"/>
            <a:chOff x="2162530" y="2061929"/>
            <a:chExt cx="576159" cy="169351"/>
          </a:xfrm>
        </p:grpSpPr>
        <p:sp>
          <p:nvSpPr>
            <p:cNvPr id="39" name="Right Brace 38">
              <a:extLst>
                <a:ext uri="{FF2B5EF4-FFF2-40B4-BE49-F238E27FC236}">
                  <a16:creationId xmlns:a16="http://schemas.microsoft.com/office/drawing/2014/main" id="{3585D936-AF32-4722-B20D-C4E4D9669F17}"/>
                </a:ext>
              </a:extLst>
            </p:cNvPr>
            <p:cNvSpPr/>
            <p:nvPr/>
          </p:nvSpPr>
          <p:spPr>
            <a:xfrm>
              <a:off x="2162530" y="2065978"/>
              <a:ext cx="39838" cy="165302"/>
            </a:xfrm>
            <a:prstGeom prst="righ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B77B4E3-8F18-433C-84DB-42AB2F6C8367}"/>
                </a:ext>
              </a:extLst>
            </p:cNvPr>
            <p:cNvSpPr txBox="1"/>
            <p:nvPr/>
          </p:nvSpPr>
          <p:spPr>
            <a:xfrm>
              <a:off x="2182448" y="2061929"/>
              <a:ext cx="556241" cy="162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OLR2A</a:t>
              </a:r>
            </a:p>
          </p:txBody>
        </p:sp>
      </p:grpSp>
      <p:pic>
        <p:nvPicPr>
          <p:cNvPr id="41" name="Picture 40">
            <a:extLst>
              <a:ext uri="{FF2B5EF4-FFF2-40B4-BE49-F238E27FC236}">
                <a16:creationId xmlns:a16="http://schemas.microsoft.com/office/drawing/2014/main" id="{B580396E-BCE7-4532-9F21-2B931B558C90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2409" t="37019" r="30731" b="37347"/>
          <a:stretch/>
        </p:blipFill>
        <p:spPr>
          <a:xfrm>
            <a:off x="2742655" y="2869587"/>
            <a:ext cx="1333703" cy="784155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A8803EF6-B582-40AA-BE80-8B3B9D19DA30}"/>
              </a:ext>
            </a:extLst>
          </p:cNvPr>
          <p:cNvSpPr txBox="1"/>
          <p:nvPr/>
        </p:nvSpPr>
        <p:spPr>
          <a:xfrm>
            <a:off x="2471626" y="38419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id="{D625D6FF-09CF-4812-B353-90512514C129}"/>
              </a:ext>
            </a:extLst>
          </p:cNvPr>
          <p:cNvGrpSpPr/>
          <p:nvPr/>
        </p:nvGrpSpPr>
        <p:grpSpPr>
          <a:xfrm>
            <a:off x="3951575" y="4631971"/>
            <a:ext cx="533202" cy="330880"/>
            <a:chOff x="1194608" y="2383118"/>
            <a:chExt cx="601889" cy="387465"/>
          </a:xfrm>
        </p:grpSpPr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E4438D1A-A9D6-4477-867F-0D8CC6B7BFA5}"/>
                </a:ext>
              </a:extLst>
            </p:cNvPr>
            <p:cNvSpPr txBox="1"/>
            <p:nvPr/>
          </p:nvSpPr>
          <p:spPr>
            <a:xfrm>
              <a:off x="1194608" y="2383118"/>
              <a:ext cx="601889" cy="2074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2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1F13614E-B2FA-484E-B138-4611F4305202}"/>
                </a:ext>
              </a:extLst>
            </p:cNvPr>
            <p:cNvSpPr txBox="1"/>
            <p:nvPr/>
          </p:nvSpPr>
          <p:spPr>
            <a:xfrm>
              <a:off x="1194608" y="2563182"/>
              <a:ext cx="601889" cy="2074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1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53FF8E07-C083-40B5-A975-058F0E71F713}"/>
              </a:ext>
            </a:extLst>
          </p:cNvPr>
          <p:cNvSpPr txBox="1"/>
          <p:nvPr/>
        </p:nvSpPr>
        <p:spPr>
          <a:xfrm>
            <a:off x="1721311" y="5842627"/>
            <a:ext cx="5370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AE296B8-1E51-4EDC-8CC2-5452BE4DB3A4}"/>
              </a:ext>
            </a:extLst>
          </p:cNvPr>
          <p:cNvSpPr txBox="1"/>
          <p:nvPr/>
        </p:nvSpPr>
        <p:spPr>
          <a:xfrm>
            <a:off x="2853781" y="5117322"/>
            <a:ext cx="11916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POLR2A (F12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08B47C5-D6F6-4605-9690-9C6894BF5E85}"/>
              </a:ext>
            </a:extLst>
          </p:cNvPr>
          <p:cNvSpPr txBox="1"/>
          <p:nvPr/>
        </p:nvSpPr>
        <p:spPr>
          <a:xfrm>
            <a:off x="3233792" y="4085777"/>
            <a:ext cx="5505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9D5EFDB-F94C-4ED9-9222-19A17EEF3885}"/>
              </a:ext>
            </a:extLst>
          </p:cNvPr>
          <p:cNvSpPr txBox="1"/>
          <p:nvPr/>
        </p:nvSpPr>
        <p:spPr>
          <a:xfrm>
            <a:off x="2906037" y="6313964"/>
            <a:ext cx="10717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:  </a:t>
            </a:r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-a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in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277B19E5-6F09-4FF7-8831-E6895D0D96A7}"/>
              </a:ext>
            </a:extLst>
          </p:cNvPr>
          <p:cNvCxnSpPr/>
          <p:nvPr/>
        </p:nvCxnSpPr>
        <p:spPr>
          <a:xfrm flipH="1">
            <a:off x="2970548" y="4315633"/>
            <a:ext cx="1007223" cy="140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4" name="Group 53">
            <a:extLst>
              <a:ext uri="{FF2B5EF4-FFF2-40B4-BE49-F238E27FC236}">
                <a16:creationId xmlns:a16="http://schemas.microsoft.com/office/drawing/2014/main" id="{4908ABFD-DEA5-4DA8-983F-1E2932D5251C}"/>
              </a:ext>
            </a:extLst>
          </p:cNvPr>
          <p:cNvGrpSpPr/>
          <p:nvPr/>
        </p:nvGrpSpPr>
        <p:grpSpPr>
          <a:xfrm>
            <a:off x="4060658" y="1463041"/>
            <a:ext cx="619516" cy="422670"/>
            <a:chOff x="1209742" y="2228417"/>
            <a:chExt cx="642263" cy="438190"/>
          </a:xfrm>
        </p:grpSpPr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84A8194-65BD-4334-B72D-D47229D898B1}"/>
                </a:ext>
              </a:extLst>
            </p:cNvPr>
            <p:cNvSpPr txBox="1"/>
            <p:nvPr/>
          </p:nvSpPr>
          <p:spPr>
            <a:xfrm>
              <a:off x="1223639" y="2228417"/>
              <a:ext cx="628366" cy="207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2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8356688A-1802-4261-AC52-1E1D95BC5AFE}"/>
                </a:ext>
              </a:extLst>
            </p:cNvPr>
            <p:cNvSpPr txBox="1"/>
            <p:nvPr/>
          </p:nvSpPr>
          <p:spPr>
            <a:xfrm>
              <a:off x="1209742" y="2459206"/>
              <a:ext cx="628366" cy="2074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1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7" name="Group 56">
            <a:extLst>
              <a:ext uri="{FF2B5EF4-FFF2-40B4-BE49-F238E27FC236}">
                <a16:creationId xmlns:a16="http://schemas.microsoft.com/office/drawing/2014/main" id="{E183EDA7-D183-46A3-B958-B958567FEF06}"/>
              </a:ext>
            </a:extLst>
          </p:cNvPr>
          <p:cNvGrpSpPr/>
          <p:nvPr/>
        </p:nvGrpSpPr>
        <p:grpSpPr>
          <a:xfrm>
            <a:off x="4111008" y="1327007"/>
            <a:ext cx="622769" cy="224367"/>
            <a:chOff x="2162530" y="2061929"/>
            <a:chExt cx="542655" cy="169351"/>
          </a:xfrm>
        </p:grpSpPr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253979F1-6B68-4B63-8820-D5523FADC799}"/>
                </a:ext>
              </a:extLst>
            </p:cNvPr>
            <p:cNvSpPr txBox="1"/>
            <p:nvPr/>
          </p:nvSpPr>
          <p:spPr>
            <a:xfrm>
              <a:off x="2182448" y="2061929"/>
              <a:ext cx="522737" cy="162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OLR2A</a:t>
              </a:r>
            </a:p>
          </p:txBody>
        </p:sp>
        <p:sp>
          <p:nvSpPr>
            <p:cNvPr id="59" name="Right Brace 58">
              <a:extLst>
                <a:ext uri="{FF2B5EF4-FFF2-40B4-BE49-F238E27FC236}">
                  <a16:creationId xmlns:a16="http://schemas.microsoft.com/office/drawing/2014/main" id="{D9B1F736-6BC9-45DE-ABB6-023E924C7FF0}"/>
                </a:ext>
              </a:extLst>
            </p:cNvPr>
            <p:cNvSpPr/>
            <p:nvPr/>
          </p:nvSpPr>
          <p:spPr>
            <a:xfrm>
              <a:off x="2162530" y="2065978"/>
              <a:ext cx="39838" cy="165302"/>
            </a:xfrm>
            <a:prstGeom prst="righ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0" name="Group 59">
            <a:extLst>
              <a:ext uri="{FF2B5EF4-FFF2-40B4-BE49-F238E27FC236}">
                <a16:creationId xmlns:a16="http://schemas.microsoft.com/office/drawing/2014/main" id="{6EBC79C4-864C-443B-98D2-C729DC8E2D72}"/>
              </a:ext>
            </a:extLst>
          </p:cNvPr>
          <p:cNvGrpSpPr/>
          <p:nvPr/>
        </p:nvGrpSpPr>
        <p:grpSpPr>
          <a:xfrm>
            <a:off x="4053339" y="3234928"/>
            <a:ext cx="544330" cy="412005"/>
            <a:chOff x="1206546" y="2312347"/>
            <a:chExt cx="564317" cy="427133"/>
          </a:xfrm>
        </p:grpSpPr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A03C0C17-59E4-4261-BD81-1E096FB823F0}"/>
                </a:ext>
              </a:extLst>
            </p:cNvPr>
            <p:cNvSpPr txBox="1"/>
            <p:nvPr/>
          </p:nvSpPr>
          <p:spPr>
            <a:xfrm>
              <a:off x="1206546" y="2312347"/>
              <a:ext cx="552296" cy="207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2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231FDE68-8FFC-40E0-BE3F-BF27471AC175}"/>
                </a:ext>
              </a:extLst>
            </p:cNvPr>
            <p:cNvSpPr txBox="1"/>
            <p:nvPr/>
          </p:nvSpPr>
          <p:spPr>
            <a:xfrm>
              <a:off x="1218567" y="2532079"/>
              <a:ext cx="552296" cy="2074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1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08AF2686-46EF-4588-B436-2BD866CE166D}"/>
              </a:ext>
            </a:extLst>
          </p:cNvPr>
          <p:cNvSpPr txBox="1"/>
          <p:nvPr/>
        </p:nvSpPr>
        <p:spPr>
          <a:xfrm>
            <a:off x="2938735" y="391703"/>
            <a:ext cx="11475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POLR2A (F12)</a:t>
            </a:r>
          </a:p>
        </p:txBody>
      </p:sp>
      <p:grpSp>
        <p:nvGrpSpPr>
          <p:cNvPr id="64" name="Group 63">
            <a:extLst>
              <a:ext uri="{FF2B5EF4-FFF2-40B4-BE49-F238E27FC236}">
                <a16:creationId xmlns:a16="http://schemas.microsoft.com/office/drawing/2014/main" id="{E2012D8D-D03B-467B-97D7-EFA843CAE44E}"/>
              </a:ext>
            </a:extLst>
          </p:cNvPr>
          <p:cNvGrpSpPr/>
          <p:nvPr/>
        </p:nvGrpSpPr>
        <p:grpSpPr>
          <a:xfrm>
            <a:off x="2979710" y="619491"/>
            <a:ext cx="1164167" cy="414848"/>
            <a:chOff x="2596925" y="310496"/>
            <a:chExt cx="1164167" cy="414848"/>
          </a:xfrm>
        </p:grpSpPr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ADC1EC2F-932E-4B17-90EA-8FEABC6E8956}"/>
                </a:ext>
              </a:extLst>
            </p:cNvPr>
            <p:cNvSpPr txBox="1"/>
            <p:nvPr/>
          </p:nvSpPr>
          <p:spPr>
            <a:xfrm>
              <a:off x="3089333" y="310496"/>
              <a:ext cx="5381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G132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4F670791-6C0B-42A7-A452-DC4FF943CC3F}"/>
                </a:ext>
              </a:extLst>
            </p:cNvPr>
            <p:cNvSpPr txBox="1"/>
            <p:nvPr/>
          </p:nvSpPr>
          <p:spPr>
            <a:xfrm>
              <a:off x="2596925" y="509900"/>
              <a:ext cx="116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KO   WT   KO   WT    </a:t>
              </a:r>
            </a:p>
          </p:txBody>
        </p: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51096D35-1A79-42B8-8672-2A0826E2BFCC}"/>
                </a:ext>
              </a:extLst>
            </p:cNvPr>
            <p:cNvCxnSpPr/>
            <p:nvPr/>
          </p:nvCxnSpPr>
          <p:spPr>
            <a:xfrm flipV="1">
              <a:off x="3174295" y="506767"/>
              <a:ext cx="360028" cy="1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8" name="TextBox 67">
            <a:extLst>
              <a:ext uri="{FF2B5EF4-FFF2-40B4-BE49-F238E27FC236}">
                <a16:creationId xmlns:a16="http://schemas.microsoft.com/office/drawing/2014/main" id="{2E3ABAD2-9184-416E-BE11-5088B12D09FD}"/>
              </a:ext>
            </a:extLst>
          </p:cNvPr>
          <p:cNvSpPr txBox="1"/>
          <p:nvPr/>
        </p:nvSpPr>
        <p:spPr>
          <a:xfrm>
            <a:off x="2656803" y="2039718"/>
            <a:ext cx="1476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Ubiquitin (K48)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4F36102E-2250-44DD-9645-E53F7E2BA108}"/>
              </a:ext>
            </a:extLst>
          </p:cNvPr>
          <p:cNvSpPr txBox="1"/>
          <p:nvPr/>
        </p:nvSpPr>
        <p:spPr>
          <a:xfrm>
            <a:off x="2852726" y="3707848"/>
            <a:ext cx="11916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POLR2A (F12)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17B9E58A-36D7-4DF5-BA6F-E7DC8A7AF5C6}"/>
              </a:ext>
            </a:extLst>
          </p:cNvPr>
          <p:cNvCxnSpPr/>
          <p:nvPr/>
        </p:nvCxnSpPr>
        <p:spPr>
          <a:xfrm flipH="1">
            <a:off x="2986161" y="585221"/>
            <a:ext cx="1007223" cy="140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7D43D6C5-7E2B-4728-A845-4D25233E8B5A}"/>
              </a:ext>
            </a:extLst>
          </p:cNvPr>
          <p:cNvSpPr txBox="1"/>
          <p:nvPr/>
        </p:nvSpPr>
        <p:spPr>
          <a:xfrm>
            <a:off x="3942232" y="3144508"/>
            <a:ext cx="5423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&lt;IIO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F5A43584-B40B-4866-A578-82EF745443C3}"/>
              </a:ext>
            </a:extLst>
          </p:cNvPr>
          <p:cNvSpPr txBox="1"/>
          <p:nvPr/>
        </p:nvSpPr>
        <p:spPr>
          <a:xfrm>
            <a:off x="3942232" y="3337195"/>
            <a:ext cx="5423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&lt;IIA</a:t>
            </a:r>
          </a:p>
        </p:txBody>
      </p:sp>
      <p:grpSp>
        <p:nvGrpSpPr>
          <p:cNvPr id="75" name="Group 74">
            <a:extLst>
              <a:ext uri="{FF2B5EF4-FFF2-40B4-BE49-F238E27FC236}">
                <a16:creationId xmlns:a16="http://schemas.microsoft.com/office/drawing/2014/main" id="{2744C11E-213C-4103-B428-A8264405CC47}"/>
              </a:ext>
            </a:extLst>
          </p:cNvPr>
          <p:cNvGrpSpPr/>
          <p:nvPr/>
        </p:nvGrpSpPr>
        <p:grpSpPr>
          <a:xfrm>
            <a:off x="1626772" y="2712114"/>
            <a:ext cx="497114" cy="767275"/>
            <a:chOff x="1201178" y="2126013"/>
            <a:chExt cx="515368" cy="795448"/>
          </a:xfrm>
        </p:grpSpPr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8D245779-3EC8-4D1C-B21F-C4F115A988B2}"/>
                </a:ext>
              </a:extLst>
            </p:cNvPr>
            <p:cNvSpPr txBox="1"/>
            <p:nvPr/>
          </p:nvSpPr>
          <p:spPr>
            <a:xfrm>
              <a:off x="1201178" y="2126013"/>
              <a:ext cx="512631" cy="207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10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A70241E1-FD96-43F8-843C-BD0D7F93B70A}"/>
                </a:ext>
              </a:extLst>
            </p:cNvPr>
            <p:cNvSpPr txBox="1"/>
            <p:nvPr/>
          </p:nvSpPr>
          <p:spPr>
            <a:xfrm>
              <a:off x="1208599" y="2714063"/>
              <a:ext cx="507947" cy="207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40DCB158-3C23-4264-AD95-D0BE20A222CC}"/>
                </a:ext>
              </a:extLst>
            </p:cNvPr>
            <p:cNvSpPr txBox="1"/>
            <p:nvPr/>
          </p:nvSpPr>
          <p:spPr>
            <a:xfrm>
              <a:off x="1201179" y="2289580"/>
              <a:ext cx="512631" cy="207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75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7" name="TextBox 86">
            <a:extLst>
              <a:ext uri="{FF2B5EF4-FFF2-40B4-BE49-F238E27FC236}">
                <a16:creationId xmlns:a16="http://schemas.microsoft.com/office/drawing/2014/main" id="{8C353001-4CCB-4548-A51D-459206BA16D9}"/>
              </a:ext>
            </a:extLst>
          </p:cNvPr>
          <p:cNvSpPr txBox="1"/>
          <p:nvPr/>
        </p:nvSpPr>
        <p:spPr>
          <a:xfrm>
            <a:off x="4003466" y="5623404"/>
            <a:ext cx="5370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DDC35E03-C6A2-401B-8508-6DE1FF12E60C}"/>
              </a:ext>
            </a:extLst>
          </p:cNvPr>
          <p:cNvSpPr txBox="1"/>
          <p:nvPr/>
        </p:nvSpPr>
        <p:spPr>
          <a:xfrm>
            <a:off x="4687836" y="38419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91" name="Group 90">
            <a:extLst>
              <a:ext uri="{FF2B5EF4-FFF2-40B4-BE49-F238E27FC236}">
                <a16:creationId xmlns:a16="http://schemas.microsoft.com/office/drawing/2014/main" id="{D50D271A-9A51-4A6C-83A0-1E64DCC28738}"/>
              </a:ext>
            </a:extLst>
          </p:cNvPr>
          <p:cNvGrpSpPr/>
          <p:nvPr/>
        </p:nvGrpSpPr>
        <p:grpSpPr>
          <a:xfrm>
            <a:off x="6178041" y="4645230"/>
            <a:ext cx="533202" cy="313847"/>
            <a:chOff x="1160983" y="2229164"/>
            <a:chExt cx="601889" cy="367518"/>
          </a:xfrm>
        </p:grpSpPr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D11EEAC7-E9A9-456D-B8E1-15637C5DB803}"/>
                </a:ext>
              </a:extLst>
            </p:cNvPr>
            <p:cNvSpPr txBox="1"/>
            <p:nvPr/>
          </p:nvSpPr>
          <p:spPr>
            <a:xfrm>
              <a:off x="1160983" y="2229164"/>
              <a:ext cx="601889" cy="207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2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92CDF564-9E88-4156-90C6-5E02A1697BEC}"/>
                </a:ext>
              </a:extLst>
            </p:cNvPr>
            <p:cNvSpPr txBox="1"/>
            <p:nvPr/>
          </p:nvSpPr>
          <p:spPr>
            <a:xfrm>
              <a:off x="1160983" y="2389282"/>
              <a:ext cx="601889" cy="207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1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4" name="TextBox 93">
            <a:extLst>
              <a:ext uri="{FF2B5EF4-FFF2-40B4-BE49-F238E27FC236}">
                <a16:creationId xmlns:a16="http://schemas.microsoft.com/office/drawing/2014/main" id="{FE4ED4FF-1D25-44D0-B60F-C8D0F8182923}"/>
              </a:ext>
            </a:extLst>
          </p:cNvPr>
          <p:cNvSpPr txBox="1"/>
          <p:nvPr/>
        </p:nvSpPr>
        <p:spPr>
          <a:xfrm>
            <a:off x="5504042" y="4097734"/>
            <a:ext cx="5505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5883C991-C7DF-400A-A665-04A88418A702}"/>
              </a:ext>
            </a:extLst>
          </p:cNvPr>
          <p:cNvCxnSpPr/>
          <p:nvPr/>
        </p:nvCxnSpPr>
        <p:spPr>
          <a:xfrm flipH="1">
            <a:off x="5163955" y="4291699"/>
            <a:ext cx="1007223" cy="140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8" name="Group 97">
            <a:extLst>
              <a:ext uri="{FF2B5EF4-FFF2-40B4-BE49-F238E27FC236}">
                <a16:creationId xmlns:a16="http://schemas.microsoft.com/office/drawing/2014/main" id="{DD1F723F-B90A-41BA-B819-F7482A014642}"/>
              </a:ext>
            </a:extLst>
          </p:cNvPr>
          <p:cNvGrpSpPr/>
          <p:nvPr/>
        </p:nvGrpSpPr>
        <p:grpSpPr>
          <a:xfrm>
            <a:off x="6071606" y="1525019"/>
            <a:ext cx="494609" cy="412356"/>
            <a:chOff x="1223639" y="2228417"/>
            <a:chExt cx="512770" cy="427496"/>
          </a:xfrm>
        </p:grpSpPr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04A8E4D3-0B2B-47B2-AE1B-A1A40ACEB427}"/>
                </a:ext>
              </a:extLst>
            </p:cNvPr>
            <p:cNvSpPr txBox="1"/>
            <p:nvPr/>
          </p:nvSpPr>
          <p:spPr>
            <a:xfrm>
              <a:off x="1223639" y="2228417"/>
              <a:ext cx="512770" cy="207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2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AFDBE906-B6CF-496A-8E95-0574C4F2A26A}"/>
                </a:ext>
              </a:extLst>
            </p:cNvPr>
            <p:cNvSpPr txBox="1"/>
            <p:nvPr/>
          </p:nvSpPr>
          <p:spPr>
            <a:xfrm>
              <a:off x="1223639" y="2448513"/>
              <a:ext cx="512631" cy="207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1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6" name="Group 105">
            <a:extLst>
              <a:ext uri="{FF2B5EF4-FFF2-40B4-BE49-F238E27FC236}">
                <a16:creationId xmlns:a16="http://schemas.microsoft.com/office/drawing/2014/main" id="{569A5E54-834B-40B2-AE31-D5FADABD3193}"/>
              </a:ext>
            </a:extLst>
          </p:cNvPr>
          <p:cNvGrpSpPr/>
          <p:nvPr/>
        </p:nvGrpSpPr>
        <p:grpSpPr>
          <a:xfrm>
            <a:off x="6103343" y="1337474"/>
            <a:ext cx="657415" cy="297823"/>
            <a:chOff x="4765100" y="5753937"/>
            <a:chExt cx="572845" cy="224795"/>
          </a:xfrm>
        </p:grpSpPr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AF5D7090-A8B6-49B6-A1A2-B3500FB325C5}"/>
                </a:ext>
              </a:extLst>
            </p:cNvPr>
            <p:cNvSpPr txBox="1"/>
            <p:nvPr/>
          </p:nvSpPr>
          <p:spPr>
            <a:xfrm>
              <a:off x="4787289" y="5797553"/>
              <a:ext cx="550656" cy="1626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OLR2A</a:t>
              </a:r>
            </a:p>
          </p:txBody>
        </p:sp>
        <p:sp>
          <p:nvSpPr>
            <p:cNvPr id="108" name="Right Brace 107">
              <a:extLst>
                <a:ext uri="{FF2B5EF4-FFF2-40B4-BE49-F238E27FC236}">
                  <a16:creationId xmlns:a16="http://schemas.microsoft.com/office/drawing/2014/main" id="{BD45C77A-9AAD-44F2-9510-0007CF75A9AD}"/>
                </a:ext>
              </a:extLst>
            </p:cNvPr>
            <p:cNvSpPr/>
            <p:nvPr/>
          </p:nvSpPr>
          <p:spPr>
            <a:xfrm>
              <a:off x="4765100" y="5753937"/>
              <a:ext cx="39838" cy="224795"/>
            </a:xfrm>
            <a:prstGeom prst="righ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9" name="TextBox 108">
            <a:extLst>
              <a:ext uri="{FF2B5EF4-FFF2-40B4-BE49-F238E27FC236}">
                <a16:creationId xmlns:a16="http://schemas.microsoft.com/office/drawing/2014/main" id="{4FD859F9-48FA-4F35-AA92-6E6E254493E8}"/>
              </a:ext>
            </a:extLst>
          </p:cNvPr>
          <p:cNvSpPr txBox="1"/>
          <p:nvPr/>
        </p:nvSpPr>
        <p:spPr>
          <a:xfrm>
            <a:off x="5021575" y="367451"/>
            <a:ext cx="12050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POLR2A (4H8)</a:t>
            </a:r>
          </a:p>
        </p:txBody>
      </p: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3ADBAB03-963D-459D-875A-7013BFCC4324}"/>
              </a:ext>
            </a:extLst>
          </p:cNvPr>
          <p:cNvCxnSpPr/>
          <p:nvPr/>
        </p:nvCxnSpPr>
        <p:spPr>
          <a:xfrm flipH="1">
            <a:off x="5058085" y="563668"/>
            <a:ext cx="1007223" cy="140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2" name="Group 111">
            <a:extLst>
              <a:ext uri="{FF2B5EF4-FFF2-40B4-BE49-F238E27FC236}">
                <a16:creationId xmlns:a16="http://schemas.microsoft.com/office/drawing/2014/main" id="{5A888470-1C6A-4135-97C3-F78E5B9CAC81}"/>
              </a:ext>
            </a:extLst>
          </p:cNvPr>
          <p:cNvGrpSpPr/>
          <p:nvPr/>
        </p:nvGrpSpPr>
        <p:grpSpPr>
          <a:xfrm>
            <a:off x="5025785" y="595239"/>
            <a:ext cx="1164167" cy="414848"/>
            <a:chOff x="2596925" y="310496"/>
            <a:chExt cx="1164167" cy="414848"/>
          </a:xfrm>
        </p:grpSpPr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2765ECA8-7578-4544-9657-9C2DD215D884}"/>
                </a:ext>
              </a:extLst>
            </p:cNvPr>
            <p:cNvSpPr txBox="1"/>
            <p:nvPr/>
          </p:nvSpPr>
          <p:spPr>
            <a:xfrm>
              <a:off x="3089333" y="310496"/>
              <a:ext cx="5381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G132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2C48968F-5E97-4553-9D5C-64E9E94C3B0D}"/>
                </a:ext>
              </a:extLst>
            </p:cNvPr>
            <p:cNvSpPr txBox="1"/>
            <p:nvPr/>
          </p:nvSpPr>
          <p:spPr>
            <a:xfrm>
              <a:off x="2596925" y="509900"/>
              <a:ext cx="116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KO   WT   KO   WT    </a:t>
              </a:r>
            </a:p>
          </p:txBody>
        </p:sp>
        <p:cxnSp>
          <p:nvCxnSpPr>
            <p:cNvPr id="115" name="Straight Connector 114">
              <a:extLst>
                <a:ext uri="{FF2B5EF4-FFF2-40B4-BE49-F238E27FC236}">
                  <a16:creationId xmlns:a16="http://schemas.microsoft.com/office/drawing/2014/main" id="{159D13AC-FF49-4E4C-9DD1-AC4AC8854105}"/>
                </a:ext>
              </a:extLst>
            </p:cNvPr>
            <p:cNvCxnSpPr/>
            <p:nvPr/>
          </p:nvCxnSpPr>
          <p:spPr>
            <a:xfrm flipV="1">
              <a:off x="3174295" y="506767"/>
              <a:ext cx="360028" cy="1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8" name="TextBox 117">
            <a:extLst>
              <a:ext uri="{FF2B5EF4-FFF2-40B4-BE49-F238E27FC236}">
                <a16:creationId xmlns:a16="http://schemas.microsoft.com/office/drawing/2014/main" id="{E3E7D015-D621-42DE-AC29-BC560CA8EBEF}"/>
              </a:ext>
            </a:extLst>
          </p:cNvPr>
          <p:cNvSpPr txBox="1"/>
          <p:nvPr/>
        </p:nvSpPr>
        <p:spPr>
          <a:xfrm>
            <a:off x="4800315" y="2095383"/>
            <a:ext cx="1476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Ubiquitin (K48)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58E49AA2-44BD-4EB3-AFAB-E81469876D69}"/>
              </a:ext>
            </a:extLst>
          </p:cNvPr>
          <p:cNvSpPr txBox="1"/>
          <p:nvPr/>
        </p:nvSpPr>
        <p:spPr>
          <a:xfrm>
            <a:off x="494291" y="2470636"/>
            <a:ext cx="1431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POLR2A (4H8)</a:t>
            </a:r>
          </a:p>
        </p:txBody>
      </p:sp>
      <p:pic>
        <p:nvPicPr>
          <p:cNvPr id="120" name="Picture 119">
            <a:extLst>
              <a:ext uri="{FF2B5EF4-FFF2-40B4-BE49-F238E27FC236}">
                <a16:creationId xmlns:a16="http://schemas.microsoft.com/office/drawing/2014/main" id="{255267E0-4247-4A90-8B70-4809303E23C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grayscl/>
          </a:blip>
          <a:srcRect t="-3450" r="7198" b="49999"/>
          <a:stretch/>
        </p:blipFill>
        <p:spPr>
          <a:xfrm>
            <a:off x="5119110" y="5235362"/>
            <a:ext cx="1094966" cy="1104284"/>
          </a:xfrm>
          <a:prstGeom prst="rect">
            <a:avLst/>
          </a:prstGeom>
        </p:spPr>
      </p:pic>
      <p:grpSp>
        <p:nvGrpSpPr>
          <p:cNvPr id="121" name="Group 120">
            <a:extLst>
              <a:ext uri="{FF2B5EF4-FFF2-40B4-BE49-F238E27FC236}">
                <a16:creationId xmlns:a16="http://schemas.microsoft.com/office/drawing/2014/main" id="{78918F50-A8BA-4F6C-B5EA-660D2D321105}"/>
              </a:ext>
            </a:extLst>
          </p:cNvPr>
          <p:cNvGrpSpPr/>
          <p:nvPr/>
        </p:nvGrpSpPr>
        <p:grpSpPr>
          <a:xfrm>
            <a:off x="6043991" y="3038241"/>
            <a:ext cx="503210" cy="427796"/>
            <a:chOff x="1223639" y="2228417"/>
            <a:chExt cx="521687" cy="443503"/>
          </a:xfrm>
        </p:grpSpPr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96A23D52-88FD-4CB5-AE95-8D509BBCDE8E}"/>
                </a:ext>
              </a:extLst>
            </p:cNvPr>
            <p:cNvSpPr txBox="1"/>
            <p:nvPr/>
          </p:nvSpPr>
          <p:spPr>
            <a:xfrm>
              <a:off x="1223639" y="2228417"/>
              <a:ext cx="512770" cy="207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2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EF555A8F-055E-446F-AB51-01F20746CEDF}"/>
                </a:ext>
              </a:extLst>
            </p:cNvPr>
            <p:cNvSpPr txBox="1"/>
            <p:nvPr/>
          </p:nvSpPr>
          <p:spPr>
            <a:xfrm>
              <a:off x="1232695" y="2464520"/>
              <a:ext cx="512631" cy="207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1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4" name="TextBox 123">
            <a:extLst>
              <a:ext uri="{FF2B5EF4-FFF2-40B4-BE49-F238E27FC236}">
                <a16:creationId xmlns:a16="http://schemas.microsoft.com/office/drawing/2014/main" id="{D480BC92-1226-4925-983A-751992478286}"/>
              </a:ext>
            </a:extLst>
          </p:cNvPr>
          <p:cNvSpPr txBox="1"/>
          <p:nvPr/>
        </p:nvSpPr>
        <p:spPr>
          <a:xfrm>
            <a:off x="545421" y="5256898"/>
            <a:ext cx="14318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POLR2A (4H8)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B5C997B6-6BD9-4A5F-9C97-EA3E00699A37}"/>
              </a:ext>
            </a:extLst>
          </p:cNvPr>
          <p:cNvSpPr txBox="1"/>
          <p:nvPr/>
        </p:nvSpPr>
        <p:spPr>
          <a:xfrm>
            <a:off x="5295294" y="6289998"/>
            <a:ext cx="778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-b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D1220A5-D1D5-4209-BBEB-2F3B9E7E233B}"/>
              </a:ext>
            </a:extLst>
          </p:cNvPr>
          <p:cNvSpPr txBox="1"/>
          <p:nvPr/>
        </p:nvSpPr>
        <p:spPr>
          <a:xfrm>
            <a:off x="6165421" y="5748681"/>
            <a:ext cx="49460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5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62D5799D-43C9-45B8-893A-2903F0763F13}"/>
              </a:ext>
            </a:extLst>
          </p:cNvPr>
          <p:cNvSpPr txBox="1"/>
          <p:nvPr/>
        </p:nvSpPr>
        <p:spPr>
          <a:xfrm>
            <a:off x="218513" y="122841"/>
            <a:ext cx="1472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endParaRPr lang="en-CA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8872CFA7-357A-418B-A5B6-80E2DCA89072}"/>
              </a:ext>
            </a:extLst>
          </p:cNvPr>
          <p:cNvSpPr txBox="1"/>
          <p:nvPr/>
        </p:nvSpPr>
        <p:spPr>
          <a:xfrm>
            <a:off x="148371" y="6636110"/>
            <a:ext cx="4523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03A014A7-B431-4720-995E-51600E511AB6}"/>
              </a:ext>
            </a:extLst>
          </p:cNvPr>
          <p:cNvSpPr/>
          <p:nvPr/>
        </p:nvSpPr>
        <p:spPr>
          <a:xfrm>
            <a:off x="112890" y="374662"/>
            <a:ext cx="2176931" cy="61547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16" name="Rectangle 115">
            <a:extLst>
              <a:ext uri="{FF2B5EF4-FFF2-40B4-BE49-F238E27FC236}">
                <a16:creationId xmlns:a16="http://schemas.microsoft.com/office/drawing/2014/main" id="{DCBB9F0B-C9FF-4738-8053-A29B87917542}"/>
              </a:ext>
            </a:extLst>
          </p:cNvPr>
          <p:cNvSpPr/>
          <p:nvPr/>
        </p:nvSpPr>
        <p:spPr>
          <a:xfrm>
            <a:off x="2379334" y="374662"/>
            <a:ext cx="2246454" cy="61547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id="{97EF5685-15C5-4699-9F75-68A5AC8AECEE}"/>
              </a:ext>
            </a:extLst>
          </p:cNvPr>
          <p:cNvSpPr/>
          <p:nvPr/>
        </p:nvSpPr>
        <p:spPr>
          <a:xfrm>
            <a:off x="4713727" y="374663"/>
            <a:ext cx="1982209" cy="61547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0C9D889E-D535-4E47-9412-AE62F84F3B25}"/>
              </a:ext>
            </a:extLst>
          </p:cNvPr>
          <p:cNvSpPr/>
          <p:nvPr/>
        </p:nvSpPr>
        <p:spPr>
          <a:xfrm>
            <a:off x="112890" y="6606959"/>
            <a:ext cx="6564514" cy="24141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1A4B5554-1B76-4CE1-9E28-274CD53A03DD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grayscl/>
          </a:blip>
          <a:srcRect l="5489"/>
          <a:stretch/>
        </p:blipFill>
        <p:spPr>
          <a:xfrm>
            <a:off x="582763" y="2757235"/>
            <a:ext cx="1119981" cy="1040750"/>
          </a:xfrm>
          <a:prstGeom prst="rect">
            <a:avLst/>
          </a:prstGeom>
        </p:spPr>
      </p:pic>
      <p:grpSp>
        <p:nvGrpSpPr>
          <p:cNvPr id="136" name="Group 135">
            <a:extLst>
              <a:ext uri="{FF2B5EF4-FFF2-40B4-BE49-F238E27FC236}">
                <a16:creationId xmlns:a16="http://schemas.microsoft.com/office/drawing/2014/main" id="{065B8E15-88CE-462F-A8B4-F580EE12C7F3}"/>
              </a:ext>
            </a:extLst>
          </p:cNvPr>
          <p:cNvGrpSpPr/>
          <p:nvPr/>
        </p:nvGrpSpPr>
        <p:grpSpPr>
          <a:xfrm>
            <a:off x="1672879" y="4776781"/>
            <a:ext cx="533202" cy="330880"/>
            <a:chOff x="1194608" y="2383118"/>
            <a:chExt cx="601889" cy="387465"/>
          </a:xfrm>
        </p:grpSpPr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8CF53A7E-E8FE-49DA-B607-ED6B6823B958}"/>
                </a:ext>
              </a:extLst>
            </p:cNvPr>
            <p:cNvSpPr txBox="1"/>
            <p:nvPr/>
          </p:nvSpPr>
          <p:spPr>
            <a:xfrm>
              <a:off x="1194608" y="2383118"/>
              <a:ext cx="601889" cy="2074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2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C5CB2162-1BB0-46FB-89F9-2D8133A075C5}"/>
                </a:ext>
              </a:extLst>
            </p:cNvPr>
            <p:cNvSpPr txBox="1"/>
            <p:nvPr/>
          </p:nvSpPr>
          <p:spPr>
            <a:xfrm>
              <a:off x="1194608" y="2563182"/>
              <a:ext cx="601889" cy="2074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1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1" name="Group 180">
            <a:extLst>
              <a:ext uri="{FF2B5EF4-FFF2-40B4-BE49-F238E27FC236}">
                <a16:creationId xmlns:a16="http://schemas.microsoft.com/office/drawing/2014/main" id="{819D835D-6665-4043-B24F-AC1A8F48F1E3}"/>
              </a:ext>
            </a:extLst>
          </p:cNvPr>
          <p:cNvGrpSpPr/>
          <p:nvPr/>
        </p:nvGrpSpPr>
        <p:grpSpPr>
          <a:xfrm>
            <a:off x="614225" y="6631092"/>
            <a:ext cx="5656796" cy="2316454"/>
            <a:chOff x="270147" y="4163348"/>
            <a:chExt cx="5656796" cy="2316454"/>
          </a:xfrm>
        </p:grpSpPr>
        <p:pic>
          <p:nvPicPr>
            <p:cNvPr id="182" name="Picture 181">
              <a:extLst>
                <a:ext uri="{FF2B5EF4-FFF2-40B4-BE49-F238E27FC236}">
                  <a16:creationId xmlns:a16="http://schemas.microsoft.com/office/drawing/2014/main" id="{9F62F5B5-32B6-4892-A276-A0C229E24F55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 flipH="1">
              <a:off x="3413111" y="5469306"/>
              <a:ext cx="1826545" cy="984701"/>
            </a:xfrm>
            <a:prstGeom prst="rect">
              <a:avLst/>
            </a:prstGeom>
          </p:spPr>
        </p:pic>
        <p:pic>
          <p:nvPicPr>
            <p:cNvPr id="183" name="Picture 182">
              <a:extLst>
                <a:ext uri="{FF2B5EF4-FFF2-40B4-BE49-F238E27FC236}">
                  <a16:creationId xmlns:a16="http://schemas.microsoft.com/office/drawing/2014/main" id="{AF8C063D-B93C-4979-9738-3879CBA9A6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2871" t="12662"/>
            <a:stretch/>
          </p:blipFill>
          <p:spPr>
            <a:xfrm rot="10800000">
              <a:off x="1026706" y="5891087"/>
              <a:ext cx="2018888" cy="557274"/>
            </a:xfrm>
            <a:prstGeom prst="rect">
              <a:avLst/>
            </a:prstGeom>
          </p:spPr>
        </p:pic>
        <p:pic>
          <p:nvPicPr>
            <p:cNvPr id="184" name="Picture 183">
              <a:extLst>
                <a:ext uri="{FF2B5EF4-FFF2-40B4-BE49-F238E27FC236}">
                  <a16:creationId xmlns:a16="http://schemas.microsoft.com/office/drawing/2014/main" id="{74B69E4A-F4BA-414F-9731-DACE8B0400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r="8696"/>
            <a:stretch/>
          </p:blipFill>
          <p:spPr>
            <a:xfrm flipH="1">
              <a:off x="3416953" y="4824411"/>
              <a:ext cx="1826547" cy="614111"/>
            </a:xfrm>
            <a:prstGeom prst="rect">
              <a:avLst/>
            </a:prstGeom>
          </p:spPr>
        </p:pic>
        <p:pic>
          <p:nvPicPr>
            <p:cNvPr id="185" name="Picture 184">
              <a:extLst>
                <a:ext uri="{FF2B5EF4-FFF2-40B4-BE49-F238E27FC236}">
                  <a16:creationId xmlns:a16="http://schemas.microsoft.com/office/drawing/2014/main" id="{C53AC173-4DDF-48F9-88B7-6213A4F07A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r="2871"/>
            <a:stretch/>
          </p:blipFill>
          <p:spPr>
            <a:xfrm flipH="1">
              <a:off x="1026706" y="4800453"/>
              <a:ext cx="2018888" cy="1073117"/>
            </a:xfrm>
            <a:prstGeom prst="rect">
              <a:avLst/>
            </a:prstGeom>
          </p:spPr>
        </p:pic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8A98F824-1293-4FD0-AFDE-198DA938E127}"/>
                </a:ext>
              </a:extLst>
            </p:cNvPr>
            <p:cNvSpPr txBox="1"/>
            <p:nvPr/>
          </p:nvSpPr>
          <p:spPr>
            <a:xfrm>
              <a:off x="5157422" y="4942376"/>
              <a:ext cx="533202" cy="1771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2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7" name="Group 186">
              <a:extLst>
                <a:ext uri="{FF2B5EF4-FFF2-40B4-BE49-F238E27FC236}">
                  <a16:creationId xmlns:a16="http://schemas.microsoft.com/office/drawing/2014/main" id="{D0468A08-D2B7-4545-B181-F3E1BE0408BF}"/>
                </a:ext>
              </a:extLst>
            </p:cNvPr>
            <p:cNvGrpSpPr/>
            <p:nvPr/>
          </p:nvGrpSpPr>
          <p:grpSpPr>
            <a:xfrm>
              <a:off x="5157422" y="5735933"/>
              <a:ext cx="606111" cy="492065"/>
              <a:chOff x="1223639" y="2228417"/>
              <a:chExt cx="628366" cy="510131"/>
            </a:xfrm>
          </p:grpSpPr>
          <p:sp>
            <p:nvSpPr>
              <p:cNvPr id="232" name="TextBox 231">
                <a:extLst>
                  <a:ext uri="{FF2B5EF4-FFF2-40B4-BE49-F238E27FC236}">
                    <a16:creationId xmlns:a16="http://schemas.microsoft.com/office/drawing/2014/main" id="{89783541-AB4B-475F-A9FA-90C9792EF70E}"/>
                  </a:ext>
                </a:extLst>
              </p:cNvPr>
              <p:cNvSpPr txBox="1"/>
              <p:nvPr/>
            </p:nvSpPr>
            <p:spPr>
              <a:xfrm>
                <a:off x="1223639" y="2228417"/>
                <a:ext cx="628366" cy="2074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150 kD</a:t>
                </a:r>
              </a:p>
            </p:txBody>
          </p:sp>
          <p:sp>
            <p:nvSpPr>
              <p:cNvPr id="233" name="TextBox 232">
                <a:extLst>
                  <a:ext uri="{FF2B5EF4-FFF2-40B4-BE49-F238E27FC236}">
                    <a16:creationId xmlns:a16="http://schemas.microsoft.com/office/drawing/2014/main" id="{A82C3BE2-6E9C-43CB-8AAD-EC1D47CDCA8A}"/>
                  </a:ext>
                </a:extLst>
              </p:cNvPr>
              <p:cNvSpPr txBox="1"/>
              <p:nvPr/>
            </p:nvSpPr>
            <p:spPr>
              <a:xfrm>
                <a:off x="1223639" y="2531147"/>
                <a:ext cx="628366" cy="207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100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4F083A2C-0159-46EE-B657-EC786DC58DDF}"/>
                </a:ext>
              </a:extLst>
            </p:cNvPr>
            <p:cNvSpPr txBox="1"/>
            <p:nvPr/>
          </p:nvSpPr>
          <p:spPr>
            <a:xfrm>
              <a:off x="2965941" y="6279747"/>
              <a:ext cx="60611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2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B63D4FB2-7B60-4EB8-9305-C842650A3DFA}"/>
                </a:ext>
              </a:extLst>
            </p:cNvPr>
            <p:cNvSpPr txBox="1"/>
            <p:nvPr/>
          </p:nvSpPr>
          <p:spPr>
            <a:xfrm>
              <a:off x="5169270" y="5880273"/>
              <a:ext cx="7540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B: </a:t>
              </a:r>
              <a:r>
                <a:rPr lang="en-US" sz="8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FLAG</a:t>
              </a:r>
            </a:p>
          </p:txBody>
        </p:sp>
        <p:grpSp>
          <p:nvGrpSpPr>
            <p:cNvPr id="190" name="Group 189">
              <a:extLst>
                <a:ext uri="{FF2B5EF4-FFF2-40B4-BE49-F238E27FC236}">
                  <a16:creationId xmlns:a16="http://schemas.microsoft.com/office/drawing/2014/main" id="{24F31C28-65CB-4710-8758-223FF7066C9C}"/>
                </a:ext>
              </a:extLst>
            </p:cNvPr>
            <p:cNvGrpSpPr/>
            <p:nvPr/>
          </p:nvGrpSpPr>
          <p:grpSpPr>
            <a:xfrm>
              <a:off x="2033598" y="4163348"/>
              <a:ext cx="618218" cy="215444"/>
              <a:chOff x="779724" y="5564696"/>
              <a:chExt cx="618218" cy="215444"/>
            </a:xfrm>
          </p:grpSpPr>
          <p:cxnSp>
            <p:nvCxnSpPr>
              <p:cNvPr id="230" name="Straight Connector 229">
                <a:extLst>
                  <a:ext uri="{FF2B5EF4-FFF2-40B4-BE49-F238E27FC236}">
                    <a16:creationId xmlns:a16="http://schemas.microsoft.com/office/drawing/2014/main" id="{F721A2CC-BC4E-484F-B15F-633F6F7C98C8}"/>
                  </a:ext>
                </a:extLst>
              </p:cNvPr>
              <p:cNvCxnSpPr/>
              <p:nvPr/>
            </p:nvCxnSpPr>
            <p:spPr>
              <a:xfrm flipH="1" flipV="1">
                <a:off x="839888" y="5749445"/>
                <a:ext cx="455030" cy="356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1" name="TextBox 230">
                <a:extLst>
                  <a:ext uri="{FF2B5EF4-FFF2-40B4-BE49-F238E27FC236}">
                    <a16:creationId xmlns:a16="http://schemas.microsoft.com/office/drawing/2014/main" id="{7EF1B123-D843-4D03-83D8-0AE0777436F0}"/>
                  </a:ext>
                </a:extLst>
              </p:cNvPr>
              <p:cNvSpPr txBox="1"/>
              <p:nvPr/>
            </p:nvSpPr>
            <p:spPr>
              <a:xfrm>
                <a:off x="779724" y="5564696"/>
                <a:ext cx="6182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IP: </a:t>
                </a:r>
                <a:r>
                  <a:rPr lang="en-US" sz="800" dirty="0">
                    <a:latin typeface="Symbol" panose="05050102010706020507" pitchFamily="18" charset="2"/>
                    <a:cs typeface="Arial" panose="020B0604020202020204" pitchFamily="34" charset="0"/>
                  </a:rPr>
                  <a:t>a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HA</a:t>
                </a:r>
              </a:p>
            </p:txBody>
          </p:sp>
        </p:grp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237281D4-FD81-456E-BCF2-4FC8C9128FB4}"/>
                </a:ext>
              </a:extLst>
            </p:cNvPr>
            <p:cNvSpPr txBox="1"/>
            <p:nvPr/>
          </p:nvSpPr>
          <p:spPr>
            <a:xfrm>
              <a:off x="1312258" y="4470799"/>
              <a:ext cx="8628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RMC5-FLAG</a:t>
              </a:r>
            </a:p>
          </p:txBody>
        </p:sp>
        <p:sp>
          <p:nvSpPr>
            <p:cNvPr id="192" name="Oval 191">
              <a:extLst>
                <a:ext uri="{FF2B5EF4-FFF2-40B4-BE49-F238E27FC236}">
                  <a16:creationId xmlns:a16="http://schemas.microsoft.com/office/drawing/2014/main" id="{675CE748-1E2E-4878-996C-3687769E7A29}"/>
                </a:ext>
              </a:extLst>
            </p:cNvPr>
            <p:cNvSpPr/>
            <p:nvPr/>
          </p:nvSpPr>
          <p:spPr>
            <a:xfrm>
              <a:off x="2144617" y="4533643"/>
              <a:ext cx="101071" cy="89756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 sz="800" dirty="0"/>
            </a:p>
          </p:txBody>
        </p:sp>
        <p:sp>
          <p:nvSpPr>
            <p:cNvPr id="193" name="Oval 192">
              <a:extLst>
                <a:ext uri="{FF2B5EF4-FFF2-40B4-BE49-F238E27FC236}">
                  <a16:creationId xmlns:a16="http://schemas.microsoft.com/office/drawing/2014/main" id="{2CB0CBF5-BEC6-44DF-9380-6B77533032F2}"/>
                </a:ext>
              </a:extLst>
            </p:cNvPr>
            <p:cNvSpPr/>
            <p:nvPr/>
          </p:nvSpPr>
          <p:spPr>
            <a:xfrm>
              <a:off x="2382121" y="4533643"/>
              <a:ext cx="101071" cy="89756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 sz="800" dirty="0"/>
            </a:p>
          </p:txBody>
        </p:sp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2AC38215-AA18-462F-8F36-F342EED7A4B0}"/>
                </a:ext>
              </a:extLst>
            </p:cNvPr>
            <p:cNvSpPr txBox="1"/>
            <p:nvPr/>
          </p:nvSpPr>
          <p:spPr>
            <a:xfrm>
              <a:off x="1393721" y="4326133"/>
              <a:ext cx="771306" cy="2211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b-K48-HA</a:t>
              </a:r>
            </a:p>
          </p:txBody>
        </p:sp>
        <p:sp>
          <p:nvSpPr>
            <p:cNvPr id="195" name="Oval 194">
              <a:extLst>
                <a:ext uri="{FF2B5EF4-FFF2-40B4-BE49-F238E27FC236}">
                  <a16:creationId xmlns:a16="http://schemas.microsoft.com/office/drawing/2014/main" id="{1025124D-C588-4CE7-A0BF-81BD93D33A0A}"/>
                </a:ext>
              </a:extLst>
            </p:cNvPr>
            <p:cNvSpPr/>
            <p:nvPr/>
          </p:nvSpPr>
          <p:spPr>
            <a:xfrm>
              <a:off x="2144617" y="4391833"/>
              <a:ext cx="101071" cy="89756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 sz="800" dirty="0"/>
            </a:p>
          </p:txBody>
        </p:sp>
        <p:sp>
          <p:nvSpPr>
            <p:cNvPr id="196" name="Oval 195">
              <a:extLst>
                <a:ext uri="{FF2B5EF4-FFF2-40B4-BE49-F238E27FC236}">
                  <a16:creationId xmlns:a16="http://schemas.microsoft.com/office/drawing/2014/main" id="{EE670EAF-BC32-4706-800A-3C3F4C5F977F}"/>
                </a:ext>
              </a:extLst>
            </p:cNvPr>
            <p:cNvSpPr/>
            <p:nvPr/>
          </p:nvSpPr>
          <p:spPr>
            <a:xfrm>
              <a:off x="2382121" y="4391833"/>
              <a:ext cx="101071" cy="89756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 sz="800" dirty="0"/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BE6ACC49-8E5B-4258-BC37-52A636ED58B8}"/>
                </a:ext>
              </a:extLst>
            </p:cNvPr>
            <p:cNvSpPr txBox="1"/>
            <p:nvPr/>
          </p:nvSpPr>
          <p:spPr>
            <a:xfrm>
              <a:off x="1350785" y="4611697"/>
              <a:ext cx="8244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mpty vector</a:t>
              </a:r>
            </a:p>
          </p:txBody>
        </p:sp>
        <p:sp>
          <p:nvSpPr>
            <p:cNvPr id="198" name="Oval 197">
              <a:extLst>
                <a:ext uri="{FF2B5EF4-FFF2-40B4-BE49-F238E27FC236}">
                  <a16:creationId xmlns:a16="http://schemas.microsoft.com/office/drawing/2014/main" id="{55390FA8-2157-4588-82FF-2FBD1411A001}"/>
                </a:ext>
              </a:extLst>
            </p:cNvPr>
            <p:cNvSpPr/>
            <p:nvPr/>
          </p:nvSpPr>
          <p:spPr>
            <a:xfrm>
              <a:off x="2144617" y="4674541"/>
              <a:ext cx="101071" cy="89756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 sz="800" dirty="0"/>
            </a:p>
          </p:txBody>
        </p:sp>
        <p:sp>
          <p:nvSpPr>
            <p:cNvPr id="199" name="Oval 198">
              <a:extLst>
                <a:ext uri="{FF2B5EF4-FFF2-40B4-BE49-F238E27FC236}">
                  <a16:creationId xmlns:a16="http://schemas.microsoft.com/office/drawing/2014/main" id="{FFA76125-97C6-4179-B84A-B377E9103F11}"/>
                </a:ext>
              </a:extLst>
            </p:cNvPr>
            <p:cNvSpPr/>
            <p:nvPr/>
          </p:nvSpPr>
          <p:spPr>
            <a:xfrm>
              <a:off x="2382121" y="4674541"/>
              <a:ext cx="101071" cy="89756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 sz="800" dirty="0"/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4179DCA0-E17F-47B5-BCCC-10907CF90A9A}"/>
                </a:ext>
              </a:extLst>
            </p:cNvPr>
            <p:cNvSpPr txBox="1"/>
            <p:nvPr/>
          </p:nvSpPr>
          <p:spPr>
            <a:xfrm>
              <a:off x="365672" y="4898923"/>
              <a:ext cx="73709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B:</a:t>
              </a:r>
            </a:p>
            <a:p>
              <a:pPr algn="ctr"/>
              <a:r>
                <a:rPr lang="en-US" sz="8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POLR2A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(4H8)</a:t>
              </a:r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A29AA857-1B49-4B10-9FC8-C687E6C618D9}"/>
                </a:ext>
              </a:extLst>
            </p:cNvPr>
            <p:cNvSpPr txBox="1"/>
            <p:nvPr/>
          </p:nvSpPr>
          <p:spPr>
            <a:xfrm>
              <a:off x="358779" y="5890888"/>
              <a:ext cx="6383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trip</a:t>
              </a:r>
            </a:p>
          </p:txBody>
        </p:sp>
        <p:cxnSp>
          <p:nvCxnSpPr>
            <p:cNvPr id="202" name="Straight Arrow Connector 201">
              <a:extLst>
                <a:ext uri="{FF2B5EF4-FFF2-40B4-BE49-F238E27FC236}">
                  <a16:creationId xmlns:a16="http://schemas.microsoft.com/office/drawing/2014/main" id="{420D9185-0934-4B7B-AFE3-1A11CECC827A}"/>
                </a:ext>
              </a:extLst>
            </p:cNvPr>
            <p:cNvCxnSpPr>
              <a:cxnSpLocks/>
              <a:stCxn id="201" idx="2"/>
              <a:endCxn id="203" idx="0"/>
            </p:cNvCxnSpPr>
            <p:nvPr/>
          </p:nvCxnSpPr>
          <p:spPr>
            <a:xfrm>
              <a:off x="677959" y="6106332"/>
              <a:ext cx="1" cy="142424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8B29315B-E8F1-4D3B-A719-F522A5F5293A}"/>
                </a:ext>
              </a:extLst>
            </p:cNvPr>
            <p:cNvSpPr txBox="1"/>
            <p:nvPr/>
          </p:nvSpPr>
          <p:spPr>
            <a:xfrm>
              <a:off x="270147" y="6248756"/>
              <a:ext cx="8156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e-IB: </a:t>
              </a:r>
              <a:r>
                <a:rPr lang="en-US" sz="8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HA</a:t>
              </a: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C0C66625-484B-4F10-9AF8-DCD1D0E627E9}"/>
                </a:ext>
              </a:extLst>
            </p:cNvPr>
            <p:cNvSpPr txBox="1"/>
            <p:nvPr/>
          </p:nvSpPr>
          <p:spPr>
            <a:xfrm>
              <a:off x="2956802" y="5119488"/>
              <a:ext cx="60611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250 kD</a:t>
              </a:r>
            </a:p>
          </p:txBody>
        </p:sp>
        <p:grpSp>
          <p:nvGrpSpPr>
            <p:cNvPr id="205" name="Group 204">
              <a:extLst>
                <a:ext uri="{FF2B5EF4-FFF2-40B4-BE49-F238E27FC236}">
                  <a16:creationId xmlns:a16="http://schemas.microsoft.com/office/drawing/2014/main" id="{1976A6C1-0B06-4F85-B227-44BA17A9DCA0}"/>
                </a:ext>
              </a:extLst>
            </p:cNvPr>
            <p:cNvGrpSpPr/>
            <p:nvPr/>
          </p:nvGrpSpPr>
          <p:grpSpPr>
            <a:xfrm>
              <a:off x="4282099" y="4168366"/>
              <a:ext cx="651035" cy="215444"/>
              <a:chOff x="839888" y="5574824"/>
              <a:chExt cx="651035" cy="215444"/>
            </a:xfrm>
          </p:grpSpPr>
          <p:cxnSp>
            <p:nvCxnSpPr>
              <p:cNvPr id="228" name="Straight Connector 227">
                <a:extLst>
                  <a:ext uri="{FF2B5EF4-FFF2-40B4-BE49-F238E27FC236}">
                    <a16:creationId xmlns:a16="http://schemas.microsoft.com/office/drawing/2014/main" id="{55865AF1-915C-493E-86DD-78850D651659}"/>
                  </a:ext>
                </a:extLst>
              </p:cNvPr>
              <p:cNvCxnSpPr/>
              <p:nvPr/>
            </p:nvCxnSpPr>
            <p:spPr>
              <a:xfrm flipH="1" flipV="1">
                <a:off x="839888" y="5749445"/>
                <a:ext cx="455030" cy="356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9" name="TextBox 228">
                <a:extLst>
                  <a:ext uri="{FF2B5EF4-FFF2-40B4-BE49-F238E27FC236}">
                    <a16:creationId xmlns:a16="http://schemas.microsoft.com/office/drawing/2014/main" id="{EE19F90E-EEE3-43B6-94F6-61B6AC445983}"/>
                  </a:ext>
                </a:extLst>
              </p:cNvPr>
              <p:cNvSpPr txBox="1"/>
              <p:nvPr/>
            </p:nvSpPr>
            <p:spPr>
              <a:xfrm>
                <a:off x="872705" y="5574824"/>
                <a:ext cx="6182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</a:p>
            </p:txBody>
          </p:sp>
        </p:grpSp>
        <p:sp>
          <p:nvSpPr>
            <p:cNvPr id="206" name="Oval 205">
              <a:extLst>
                <a:ext uri="{FF2B5EF4-FFF2-40B4-BE49-F238E27FC236}">
                  <a16:creationId xmlns:a16="http://schemas.microsoft.com/office/drawing/2014/main" id="{AD72DC90-A8AB-4CF5-8490-1AAE1CC15ACD}"/>
                </a:ext>
              </a:extLst>
            </p:cNvPr>
            <p:cNvSpPr/>
            <p:nvPr/>
          </p:nvSpPr>
          <p:spPr>
            <a:xfrm>
              <a:off x="4332954" y="4538661"/>
              <a:ext cx="101071" cy="89756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 sz="800" dirty="0"/>
            </a:p>
          </p:txBody>
        </p:sp>
        <p:sp>
          <p:nvSpPr>
            <p:cNvPr id="207" name="Oval 206">
              <a:extLst>
                <a:ext uri="{FF2B5EF4-FFF2-40B4-BE49-F238E27FC236}">
                  <a16:creationId xmlns:a16="http://schemas.microsoft.com/office/drawing/2014/main" id="{EDE60B18-4893-4A9D-B5A8-76C74D599381}"/>
                </a:ext>
              </a:extLst>
            </p:cNvPr>
            <p:cNvSpPr/>
            <p:nvPr/>
          </p:nvSpPr>
          <p:spPr>
            <a:xfrm>
              <a:off x="4570458" y="4538661"/>
              <a:ext cx="101071" cy="89756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 sz="800" dirty="0"/>
            </a:p>
          </p:txBody>
        </p:sp>
        <p:grpSp>
          <p:nvGrpSpPr>
            <p:cNvPr id="208" name="Group 207">
              <a:extLst>
                <a:ext uri="{FF2B5EF4-FFF2-40B4-BE49-F238E27FC236}">
                  <a16:creationId xmlns:a16="http://schemas.microsoft.com/office/drawing/2014/main" id="{08158BD0-1331-4060-B2C1-A136EB99C38B}"/>
                </a:ext>
              </a:extLst>
            </p:cNvPr>
            <p:cNvGrpSpPr/>
            <p:nvPr/>
          </p:nvGrpSpPr>
          <p:grpSpPr>
            <a:xfrm>
              <a:off x="4332954" y="4396851"/>
              <a:ext cx="338575" cy="89756"/>
              <a:chOff x="877433" y="5930622"/>
              <a:chExt cx="338575" cy="89756"/>
            </a:xfrm>
          </p:grpSpPr>
          <p:sp>
            <p:nvSpPr>
              <p:cNvPr id="226" name="Oval 225">
                <a:extLst>
                  <a:ext uri="{FF2B5EF4-FFF2-40B4-BE49-F238E27FC236}">
                    <a16:creationId xmlns:a16="http://schemas.microsoft.com/office/drawing/2014/main" id="{8CC2C723-A96B-483A-A783-00556B02FF14}"/>
                  </a:ext>
                </a:extLst>
              </p:cNvPr>
              <p:cNvSpPr/>
              <p:nvPr/>
            </p:nvSpPr>
            <p:spPr>
              <a:xfrm>
                <a:off x="877433" y="5930622"/>
                <a:ext cx="101071" cy="89756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CA" sz="800" dirty="0"/>
              </a:p>
            </p:txBody>
          </p:sp>
          <p:sp>
            <p:nvSpPr>
              <p:cNvPr id="227" name="Oval 226">
                <a:extLst>
                  <a:ext uri="{FF2B5EF4-FFF2-40B4-BE49-F238E27FC236}">
                    <a16:creationId xmlns:a16="http://schemas.microsoft.com/office/drawing/2014/main" id="{6CD225FF-7D7C-4A15-8C87-492DB738A5BF}"/>
                  </a:ext>
                </a:extLst>
              </p:cNvPr>
              <p:cNvSpPr/>
              <p:nvPr/>
            </p:nvSpPr>
            <p:spPr>
              <a:xfrm>
                <a:off x="1114937" y="5930622"/>
                <a:ext cx="101071" cy="89756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CA" sz="800" dirty="0"/>
              </a:p>
            </p:txBody>
          </p:sp>
        </p:grpSp>
        <p:grpSp>
          <p:nvGrpSpPr>
            <p:cNvPr id="209" name="Group 208">
              <a:extLst>
                <a:ext uri="{FF2B5EF4-FFF2-40B4-BE49-F238E27FC236}">
                  <a16:creationId xmlns:a16="http://schemas.microsoft.com/office/drawing/2014/main" id="{1623C2D4-00F2-48EF-9C6D-703E065A6E7E}"/>
                </a:ext>
              </a:extLst>
            </p:cNvPr>
            <p:cNvGrpSpPr/>
            <p:nvPr/>
          </p:nvGrpSpPr>
          <p:grpSpPr>
            <a:xfrm>
              <a:off x="4332954" y="4679559"/>
              <a:ext cx="338575" cy="89756"/>
              <a:chOff x="877433" y="6194580"/>
              <a:chExt cx="338575" cy="89756"/>
            </a:xfrm>
          </p:grpSpPr>
          <p:sp>
            <p:nvSpPr>
              <p:cNvPr id="224" name="Oval 223">
                <a:extLst>
                  <a:ext uri="{FF2B5EF4-FFF2-40B4-BE49-F238E27FC236}">
                    <a16:creationId xmlns:a16="http://schemas.microsoft.com/office/drawing/2014/main" id="{55981C0B-3D7C-40FE-9D41-8C4EE30D2B50}"/>
                  </a:ext>
                </a:extLst>
              </p:cNvPr>
              <p:cNvSpPr/>
              <p:nvPr/>
            </p:nvSpPr>
            <p:spPr>
              <a:xfrm>
                <a:off x="877433" y="6194580"/>
                <a:ext cx="101071" cy="89756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CA" sz="800" dirty="0"/>
              </a:p>
            </p:txBody>
          </p:sp>
          <p:sp>
            <p:nvSpPr>
              <p:cNvPr id="225" name="Oval 224">
                <a:extLst>
                  <a:ext uri="{FF2B5EF4-FFF2-40B4-BE49-F238E27FC236}">
                    <a16:creationId xmlns:a16="http://schemas.microsoft.com/office/drawing/2014/main" id="{76C4139B-4B41-4397-AF4B-925A8D4710F5}"/>
                  </a:ext>
                </a:extLst>
              </p:cNvPr>
              <p:cNvSpPr/>
              <p:nvPr/>
            </p:nvSpPr>
            <p:spPr>
              <a:xfrm>
                <a:off x="1114937" y="6194580"/>
                <a:ext cx="101071" cy="89756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CA" sz="800" dirty="0"/>
              </a:p>
            </p:txBody>
          </p:sp>
        </p:grp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57695EEE-E284-4650-90E0-C1C424E7286F}"/>
                </a:ext>
              </a:extLst>
            </p:cNvPr>
            <p:cNvSpPr txBox="1"/>
            <p:nvPr/>
          </p:nvSpPr>
          <p:spPr>
            <a:xfrm>
              <a:off x="5080091" y="5081715"/>
              <a:ext cx="8468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B:</a:t>
              </a:r>
            </a:p>
            <a:p>
              <a:pPr algn="ctr"/>
              <a:r>
                <a:rPr lang="en-US" sz="8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POLR2A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(F12)</a:t>
              </a: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23C1FB1A-7D62-4BFB-96EF-F42BE2942C41}"/>
                </a:ext>
              </a:extLst>
            </p:cNvPr>
            <p:cNvSpPr txBox="1"/>
            <p:nvPr/>
          </p:nvSpPr>
          <p:spPr>
            <a:xfrm>
              <a:off x="5157422" y="5589357"/>
              <a:ext cx="533202" cy="1771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250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Rectangle 211">
              <a:extLst>
                <a:ext uri="{FF2B5EF4-FFF2-40B4-BE49-F238E27FC236}">
                  <a16:creationId xmlns:a16="http://schemas.microsoft.com/office/drawing/2014/main" id="{90506C28-E00A-4CD1-AD34-4AFD1F451D95}"/>
                </a:ext>
              </a:extLst>
            </p:cNvPr>
            <p:cNvSpPr/>
            <p:nvPr/>
          </p:nvSpPr>
          <p:spPr>
            <a:xfrm>
              <a:off x="1222204" y="4827141"/>
              <a:ext cx="94115" cy="162122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3" name="Rectangle 212">
              <a:extLst>
                <a:ext uri="{FF2B5EF4-FFF2-40B4-BE49-F238E27FC236}">
                  <a16:creationId xmlns:a16="http://schemas.microsoft.com/office/drawing/2014/main" id="{EDAF337F-5310-4B7B-8E46-BF0FB67CE021}"/>
                </a:ext>
              </a:extLst>
            </p:cNvPr>
            <p:cNvSpPr/>
            <p:nvPr/>
          </p:nvSpPr>
          <p:spPr>
            <a:xfrm>
              <a:off x="1394732" y="4827141"/>
              <a:ext cx="94115" cy="162122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4" name="Rectangle 213">
              <a:extLst>
                <a:ext uri="{FF2B5EF4-FFF2-40B4-BE49-F238E27FC236}">
                  <a16:creationId xmlns:a16="http://schemas.microsoft.com/office/drawing/2014/main" id="{09863A66-5A3F-4C96-B05D-57EFB525D72D}"/>
                </a:ext>
              </a:extLst>
            </p:cNvPr>
            <p:cNvSpPr/>
            <p:nvPr/>
          </p:nvSpPr>
          <p:spPr>
            <a:xfrm>
              <a:off x="1688030" y="4827141"/>
              <a:ext cx="94115" cy="162122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5" name="Rectangle 214">
              <a:extLst>
                <a:ext uri="{FF2B5EF4-FFF2-40B4-BE49-F238E27FC236}">
                  <a16:creationId xmlns:a16="http://schemas.microsoft.com/office/drawing/2014/main" id="{43B2CF00-3388-46B4-8002-0AA40F0753FB}"/>
                </a:ext>
              </a:extLst>
            </p:cNvPr>
            <p:cNvSpPr/>
            <p:nvPr/>
          </p:nvSpPr>
          <p:spPr>
            <a:xfrm>
              <a:off x="1929570" y="4827141"/>
              <a:ext cx="94115" cy="162122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6" name="Rectangle 215">
              <a:extLst>
                <a:ext uri="{FF2B5EF4-FFF2-40B4-BE49-F238E27FC236}">
                  <a16:creationId xmlns:a16="http://schemas.microsoft.com/office/drawing/2014/main" id="{7B85A1C2-843C-4343-A05C-B60283666AD4}"/>
                </a:ext>
              </a:extLst>
            </p:cNvPr>
            <p:cNvSpPr/>
            <p:nvPr/>
          </p:nvSpPr>
          <p:spPr>
            <a:xfrm>
              <a:off x="2611057" y="4827141"/>
              <a:ext cx="94115" cy="162122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7" name="Rectangle 216">
              <a:extLst>
                <a:ext uri="{FF2B5EF4-FFF2-40B4-BE49-F238E27FC236}">
                  <a16:creationId xmlns:a16="http://schemas.microsoft.com/office/drawing/2014/main" id="{A2B4C34B-B63D-437E-BDDB-1461A28C8865}"/>
                </a:ext>
              </a:extLst>
            </p:cNvPr>
            <p:cNvSpPr/>
            <p:nvPr/>
          </p:nvSpPr>
          <p:spPr>
            <a:xfrm>
              <a:off x="2869849" y="4827141"/>
              <a:ext cx="94115" cy="162122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8" name="Rectangle 217">
              <a:extLst>
                <a:ext uri="{FF2B5EF4-FFF2-40B4-BE49-F238E27FC236}">
                  <a16:creationId xmlns:a16="http://schemas.microsoft.com/office/drawing/2014/main" id="{B1E2451D-193B-4EF6-843B-1923E8A882CE}"/>
                </a:ext>
              </a:extLst>
            </p:cNvPr>
            <p:cNvSpPr/>
            <p:nvPr/>
          </p:nvSpPr>
          <p:spPr>
            <a:xfrm>
              <a:off x="3508205" y="4827141"/>
              <a:ext cx="94115" cy="162122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9" name="Rectangle 218">
              <a:extLst>
                <a:ext uri="{FF2B5EF4-FFF2-40B4-BE49-F238E27FC236}">
                  <a16:creationId xmlns:a16="http://schemas.microsoft.com/office/drawing/2014/main" id="{43B48520-85CE-4FB2-ACD5-DECCC9103294}"/>
                </a:ext>
              </a:extLst>
            </p:cNvPr>
            <p:cNvSpPr/>
            <p:nvPr/>
          </p:nvSpPr>
          <p:spPr>
            <a:xfrm>
              <a:off x="3706613" y="4835768"/>
              <a:ext cx="94115" cy="162122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0" name="Rectangle 219">
              <a:extLst>
                <a:ext uri="{FF2B5EF4-FFF2-40B4-BE49-F238E27FC236}">
                  <a16:creationId xmlns:a16="http://schemas.microsoft.com/office/drawing/2014/main" id="{68333D21-23C9-49C9-B3F4-6C1E42672803}"/>
                </a:ext>
              </a:extLst>
            </p:cNvPr>
            <p:cNvSpPr/>
            <p:nvPr/>
          </p:nvSpPr>
          <p:spPr>
            <a:xfrm>
              <a:off x="3956779" y="4835768"/>
              <a:ext cx="94115" cy="162122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1" name="Rectangle 220">
              <a:extLst>
                <a:ext uri="{FF2B5EF4-FFF2-40B4-BE49-F238E27FC236}">
                  <a16:creationId xmlns:a16="http://schemas.microsoft.com/office/drawing/2014/main" id="{77DEF704-F87B-4435-8A06-BC28E2F92725}"/>
                </a:ext>
              </a:extLst>
            </p:cNvPr>
            <p:cNvSpPr/>
            <p:nvPr/>
          </p:nvSpPr>
          <p:spPr>
            <a:xfrm>
              <a:off x="4172439" y="4835768"/>
              <a:ext cx="94115" cy="162122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2" name="Rectangle 221">
              <a:extLst>
                <a:ext uri="{FF2B5EF4-FFF2-40B4-BE49-F238E27FC236}">
                  <a16:creationId xmlns:a16="http://schemas.microsoft.com/office/drawing/2014/main" id="{D6A5AFA1-F28C-4C3C-B999-00D63512448D}"/>
                </a:ext>
              </a:extLst>
            </p:cNvPr>
            <p:cNvSpPr/>
            <p:nvPr/>
          </p:nvSpPr>
          <p:spPr>
            <a:xfrm>
              <a:off x="4836673" y="4835768"/>
              <a:ext cx="94115" cy="162122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3" name="Rectangle 222">
              <a:extLst>
                <a:ext uri="{FF2B5EF4-FFF2-40B4-BE49-F238E27FC236}">
                  <a16:creationId xmlns:a16="http://schemas.microsoft.com/office/drawing/2014/main" id="{FE4B4EEF-704E-4531-93B6-0BC1DCDED0B4}"/>
                </a:ext>
              </a:extLst>
            </p:cNvPr>
            <p:cNvSpPr/>
            <p:nvPr/>
          </p:nvSpPr>
          <p:spPr>
            <a:xfrm>
              <a:off x="5069587" y="4835768"/>
              <a:ext cx="94115" cy="162122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8166817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3620AE3-9D9D-C04D-A860-0AA035F2C318}"/>
              </a:ext>
            </a:extLst>
          </p:cNvPr>
          <p:cNvSpPr txBox="1"/>
          <p:nvPr/>
        </p:nvSpPr>
        <p:spPr>
          <a:xfrm>
            <a:off x="218513" y="122841"/>
            <a:ext cx="1472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6A </a:t>
            </a:r>
            <a:endParaRPr lang="en-CA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 descr="Graphical user interface&#10;&#10;Description automatically generated">
            <a:extLst>
              <a:ext uri="{FF2B5EF4-FFF2-40B4-BE49-F238E27FC236}">
                <a16:creationId xmlns:a16="http://schemas.microsoft.com/office/drawing/2014/main" id="{87E34F04-E96C-80A3-CA25-69BAF23E1AC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963" t="13622"/>
          <a:stretch/>
        </p:blipFill>
        <p:spPr>
          <a:xfrm>
            <a:off x="317500" y="369061"/>
            <a:ext cx="5969000" cy="52301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87370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5480FA4-469D-FF41-B316-86B9532AB71B}"/>
              </a:ext>
            </a:extLst>
          </p:cNvPr>
          <p:cNvSpPr txBox="1"/>
          <p:nvPr/>
        </p:nvSpPr>
        <p:spPr>
          <a:xfrm>
            <a:off x="218513" y="122841"/>
            <a:ext cx="1472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7H </a:t>
            </a:r>
            <a:endParaRPr lang="en-CA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F5915D1-34B2-B94A-9655-0BA0AB3BE946}"/>
              </a:ext>
            </a:extLst>
          </p:cNvPr>
          <p:cNvSpPr txBox="1"/>
          <p:nvPr/>
        </p:nvSpPr>
        <p:spPr>
          <a:xfrm>
            <a:off x="1157656" y="1468273"/>
            <a:ext cx="52450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 75 k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8945F3B-D5D1-644B-8233-0C9353BDAFCD}"/>
              </a:ext>
            </a:extLst>
          </p:cNvPr>
          <p:cNvSpPr txBox="1"/>
          <p:nvPr/>
        </p:nvSpPr>
        <p:spPr>
          <a:xfrm>
            <a:off x="1121753" y="2880454"/>
            <a:ext cx="5689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 40 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FBDF92F-6023-CE44-8A72-1ED42E8126D7}"/>
              </a:ext>
            </a:extLst>
          </p:cNvPr>
          <p:cNvSpPr txBox="1"/>
          <p:nvPr/>
        </p:nvSpPr>
        <p:spPr>
          <a:xfrm>
            <a:off x="955259" y="534296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F4958BA-F520-024B-97CE-93EE745E4014}"/>
              </a:ext>
            </a:extLst>
          </p:cNvPr>
          <p:cNvSpPr txBox="1"/>
          <p:nvPr/>
        </p:nvSpPr>
        <p:spPr>
          <a:xfrm>
            <a:off x="761294" y="534876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212E52E-21E4-5941-800A-31CE495B23C4}"/>
              </a:ext>
            </a:extLst>
          </p:cNvPr>
          <p:cNvSpPr txBox="1"/>
          <p:nvPr/>
        </p:nvSpPr>
        <p:spPr>
          <a:xfrm>
            <a:off x="614444" y="369062"/>
            <a:ext cx="5757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testin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244DF36-52BE-BA4A-A284-CB637C65718E}"/>
              </a:ext>
            </a:extLst>
          </p:cNvPr>
          <p:cNvSpPr txBox="1"/>
          <p:nvPr/>
        </p:nvSpPr>
        <p:spPr>
          <a:xfrm>
            <a:off x="205859" y="2665010"/>
            <a:ext cx="5036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F9B3BC6-CDFF-3A4B-84B7-16C45CDE23EA}"/>
              </a:ext>
            </a:extLst>
          </p:cNvPr>
          <p:cNvSpPr txBox="1"/>
          <p:nvPr/>
        </p:nvSpPr>
        <p:spPr>
          <a:xfrm>
            <a:off x="62110" y="1475915"/>
            <a:ext cx="7911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OLH1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4D220C1-9138-4949-B48E-4F44760993B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378" t="14875" r="9260"/>
          <a:stretch/>
        </p:blipFill>
        <p:spPr>
          <a:xfrm>
            <a:off x="628745" y="750320"/>
            <a:ext cx="598844" cy="124326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7E809232-1014-AD48-B0FA-2DDAE20FD9E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987" r="7044"/>
          <a:stretch/>
        </p:blipFill>
        <p:spPr>
          <a:xfrm>
            <a:off x="628745" y="2042968"/>
            <a:ext cx="598844" cy="1003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82484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Image 29">
            <a:extLst>
              <a:ext uri="{FF2B5EF4-FFF2-40B4-BE49-F238E27FC236}">
                <a16:creationId xmlns:a16="http://schemas.microsoft.com/office/drawing/2014/main" id="{32562418-F6C3-433C-BCBA-690FB5B907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5218" y="1333880"/>
            <a:ext cx="1139216" cy="115096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A50B49D-F4D0-2945-A6C1-DBB2D783D1A6}"/>
              </a:ext>
            </a:extLst>
          </p:cNvPr>
          <p:cNvSpPr txBox="1"/>
          <p:nvPr/>
        </p:nvSpPr>
        <p:spPr>
          <a:xfrm>
            <a:off x="1068684" y="505550"/>
            <a:ext cx="8034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HEK293 cells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9C4B1286-C668-314B-8122-597C8B54CA58}"/>
              </a:ext>
            </a:extLst>
          </p:cNvPr>
          <p:cNvSpPr/>
          <p:nvPr/>
        </p:nvSpPr>
        <p:spPr>
          <a:xfrm>
            <a:off x="596625" y="2144845"/>
            <a:ext cx="59465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HA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C1FD0D6C-ABAA-2148-A612-420ADE536788}"/>
              </a:ext>
            </a:extLst>
          </p:cNvPr>
          <p:cNvCxnSpPr/>
          <p:nvPr/>
        </p:nvCxnSpPr>
        <p:spPr>
          <a:xfrm flipH="1" flipV="1">
            <a:off x="1813843" y="893730"/>
            <a:ext cx="455030" cy="3567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DB261E20-1777-DF4B-BB16-DCCEDF70792F}"/>
              </a:ext>
            </a:extLst>
          </p:cNvPr>
          <p:cNvSpPr txBox="1"/>
          <p:nvPr/>
        </p:nvSpPr>
        <p:spPr>
          <a:xfrm>
            <a:off x="1754975" y="706497"/>
            <a:ext cx="6182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HA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8FC1D959-168B-5B45-940C-A3451A12E596}"/>
              </a:ext>
            </a:extLst>
          </p:cNvPr>
          <p:cNvCxnSpPr/>
          <p:nvPr/>
        </p:nvCxnSpPr>
        <p:spPr>
          <a:xfrm flipH="1" flipV="1">
            <a:off x="1277729" y="886180"/>
            <a:ext cx="455030" cy="3567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01BD7328-8065-6C4D-AE88-BFB094721D9B}"/>
              </a:ext>
            </a:extLst>
          </p:cNvPr>
          <p:cNvSpPr txBox="1"/>
          <p:nvPr/>
        </p:nvSpPr>
        <p:spPr>
          <a:xfrm>
            <a:off x="1287200" y="698947"/>
            <a:ext cx="5412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DC3399A-29F3-1C4A-B23C-779C5286F5FA}"/>
              </a:ext>
            </a:extLst>
          </p:cNvPr>
          <p:cNvSpPr txBox="1"/>
          <p:nvPr/>
        </p:nvSpPr>
        <p:spPr>
          <a:xfrm rot="16200000">
            <a:off x="1737347" y="1098630"/>
            <a:ext cx="415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A4FA70E-0BED-8947-BD13-1ED966E74177}"/>
              </a:ext>
            </a:extLst>
          </p:cNvPr>
          <p:cNvSpPr txBox="1"/>
          <p:nvPr/>
        </p:nvSpPr>
        <p:spPr>
          <a:xfrm rot="16200000">
            <a:off x="1839139" y="987488"/>
            <a:ext cx="6914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334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D1B3C5A-C9C6-2F43-B2BC-79B5D0098243}"/>
              </a:ext>
            </a:extLst>
          </p:cNvPr>
          <p:cNvSpPr txBox="1"/>
          <p:nvPr/>
        </p:nvSpPr>
        <p:spPr>
          <a:xfrm>
            <a:off x="2287610" y="1490988"/>
            <a:ext cx="5454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25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946D381-361D-6647-AABC-C8CEF4527E38}"/>
              </a:ext>
            </a:extLst>
          </p:cNvPr>
          <p:cNvSpPr txBox="1"/>
          <p:nvPr/>
        </p:nvSpPr>
        <p:spPr>
          <a:xfrm>
            <a:off x="2285450" y="1845722"/>
            <a:ext cx="6784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5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6FD8D3-E7F9-4B49-B916-39AB3A96DC47}"/>
              </a:ext>
            </a:extLst>
          </p:cNvPr>
          <p:cNvSpPr txBox="1"/>
          <p:nvPr/>
        </p:nvSpPr>
        <p:spPr>
          <a:xfrm>
            <a:off x="2292608" y="2083691"/>
            <a:ext cx="5569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1608FCD4-1309-5449-88D7-ABE84CC1538A}"/>
              </a:ext>
            </a:extLst>
          </p:cNvPr>
          <p:cNvGrpSpPr/>
          <p:nvPr/>
        </p:nvGrpSpPr>
        <p:grpSpPr>
          <a:xfrm>
            <a:off x="2285450" y="1372613"/>
            <a:ext cx="638777" cy="359938"/>
            <a:chOff x="5585523" y="4826812"/>
            <a:chExt cx="638777" cy="215444"/>
          </a:xfrm>
        </p:grpSpPr>
        <p:sp>
          <p:nvSpPr>
            <p:cNvPr id="15" name="Left Brace 14">
              <a:extLst>
                <a:ext uri="{FF2B5EF4-FFF2-40B4-BE49-F238E27FC236}">
                  <a16:creationId xmlns:a16="http://schemas.microsoft.com/office/drawing/2014/main" id="{52ACE68C-A4AA-2C4A-A038-54BDF7A710D1}"/>
                </a:ext>
              </a:extLst>
            </p:cNvPr>
            <p:cNvSpPr/>
            <p:nvPr/>
          </p:nvSpPr>
          <p:spPr>
            <a:xfrm flipH="1">
              <a:off x="5609536" y="4851813"/>
              <a:ext cx="49098" cy="139366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CA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C3FD4C1D-A67F-7745-BD32-CE1B5C742023}"/>
                </a:ext>
              </a:extLst>
            </p:cNvPr>
            <p:cNvSpPr/>
            <p:nvPr/>
          </p:nvSpPr>
          <p:spPr>
            <a:xfrm>
              <a:off x="5585523" y="4826812"/>
              <a:ext cx="63877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LR2A</a:t>
              </a:r>
            </a:p>
          </p:txBody>
        </p:sp>
      </p:grpSp>
      <p:sp>
        <p:nvSpPr>
          <p:cNvPr id="17" name="Left Brace 16">
            <a:extLst>
              <a:ext uri="{FF2B5EF4-FFF2-40B4-BE49-F238E27FC236}">
                <a16:creationId xmlns:a16="http://schemas.microsoft.com/office/drawing/2014/main" id="{8392B38A-5F47-1E44-908D-E06D72A7847C}"/>
              </a:ext>
            </a:extLst>
          </p:cNvPr>
          <p:cNvSpPr/>
          <p:nvPr/>
        </p:nvSpPr>
        <p:spPr>
          <a:xfrm flipH="1">
            <a:off x="2292608" y="2047943"/>
            <a:ext cx="49098" cy="207589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CA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35308B58-7701-D64F-8065-E840986DA705}"/>
              </a:ext>
            </a:extLst>
          </p:cNvPr>
          <p:cNvSpPr/>
          <p:nvPr/>
        </p:nvSpPr>
        <p:spPr>
          <a:xfrm>
            <a:off x="2240962" y="1956180"/>
            <a:ext cx="638777" cy="3209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MC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788BF7A-20FB-AA43-91D3-FDD643748625}"/>
              </a:ext>
            </a:extLst>
          </p:cNvPr>
          <p:cNvSpPr txBox="1"/>
          <p:nvPr/>
        </p:nvSpPr>
        <p:spPr>
          <a:xfrm rot="16200000">
            <a:off x="663947" y="1045224"/>
            <a:ext cx="7659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RMC5-HA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341BD385-C0C7-B347-B777-E363DD6484DB}"/>
              </a:ext>
            </a:extLst>
          </p:cNvPr>
          <p:cNvCxnSpPr/>
          <p:nvPr/>
        </p:nvCxnSpPr>
        <p:spPr>
          <a:xfrm>
            <a:off x="1156646" y="954726"/>
            <a:ext cx="397" cy="30149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7DEB30E7-FCF8-6D41-8E4D-C38F73A0BBF5}"/>
              </a:ext>
            </a:extLst>
          </p:cNvPr>
          <p:cNvSpPr txBox="1"/>
          <p:nvPr/>
        </p:nvSpPr>
        <p:spPr>
          <a:xfrm rot="16200000">
            <a:off x="1118571" y="1098630"/>
            <a:ext cx="415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71C8441-000D-C241-BA94-A9AEC974B1F5}"/>
              </a:ext>
            </a:extLst>
          </p:cNvPr>
          <p:cNvSpPr txBox="1"/>
          <p:nvPr/>
        </p:nvSpPr>
        <p:spPr>
          <a:xfrm rot="16200000">
            <a:off x="1220363" y="987488"/>
            <a:ext cx="6914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334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1506EEA-E7BA-F94B-86C1-C619E1FCC37C}"/>
              </a:ext>
            </a:extLst>
          </p:cNvPr>
          <p:cNvSpPr txBox="1"/>
          <p:nvPr/>
        </p:nvSpPr>
        <p:spPr>
          <a:xfrm>
            <a:off x="197545" y="137428"/>
            <a:ext cx="18438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9B 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79ACB53B-C925-A946-8CBC-A4F2F480EA84}"/>
              </a:ext>
            </a:extLst>
          </p:cNvPr>
          <p:cNvSpPr/>
          <p:nvPr/>
        </p:nvSpPr>
        <p:spPr>
          <a:xfrm>
            <a:off x="297948" y="1418039"/>
            <a:ext cx="90354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:</a:t>
            </a:r>
          </a:p>
          <a:p>
            <a:pPr algn="ctr"/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POLR2A</a:t>
            </a:r>
          </a:p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4H8)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B64D8CD1-3B11-9C4E-8F3C-E6DE4C56A1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8263" y="3175664"/>
            <a:ext cx="2151289" cy="1727200"/>
          </a:xfrm>
          <a:prstGeom prst="rect">
            <a:avLst/>
          </a:prstGeom>
        </p:spPr>
      </p:pic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E84D2FFF-A967-E446-991D-A2D4A71B5E3F}"/>
              </a:ext>
            </a:extLst>
          </p:cNvPr>
          <p:cNvCxnSpPr/>
          <p:nvPr/>
        </p:nvCxnSpPr>
        <p:spPr>
          <a:xfrm flipV="1">
            <a:off x="1505244" y="1820755"/>
            <a:ext cx="558840" cy="22185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B571E3D8-1F77-7C44-83B3-50629AFC0D02}"/>
              </a:ext>
            </a:extLst>
          </p:cNvPr>
          <p:cNvCxnSpPr/>
          <p:nvPr/>
        </p:nvCxnSpPr>
        <p:spPr>
          <a:xfrm flipH="1" flipV="1">
            <a:off x="1455365" y="1879704"/>
            <a:ext cx="701414" cy="21595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9541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E719CFA-07D8-5340-8926-51C855A349A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752" t="19771" r="2622"/>
          <a:stretch/>
        </p:blipFill>
        <p:spPr>
          <a:xfrm>
            <a:off x="227601" y="2679233"/>
            <a:ext cx="1786909" cy="98395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416FD45-A915-7C4E-A229-AD998ED266A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066" t="8018" b="13015"/>
          <a:stretch/>
        </p:blipFill>
        <p:spPr>
          <a:xfrm>
            <a:off x="2063354" y="2679233"/>
            <a:ext cx="1786909" cy="986306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7D6B2832-A3EC-D043-ACAC-AF540BE764ED}"/>
              </a:ext>
            </a:extLst>
          </p:cNvPr>
          <p:cNvGrpSpPr/>
          <p:nvPr/>
        </p:nvGrpSpPr>
        <p:grpSpPr>
          <a:xfrm>
            <a:off x="1592952" y="4435387"/>
            <a:ext cx="617404" cy="819509"/>
            <a:chOff x="4541071" y="2203568"/>
            <a:chExt cx="617404" cy="819509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F514832-15C8-7D44-81E5-78E955626847}"/>
                </a:ext>
              </a:extLst>
            </p:cNvPr>
            <p:cNvSpPr txBox="1"/>
            <p:nvPr/>
          </p:nvSpPr>
          <p:spPr>
            <a:xfrm rot="16200000">
              <a:off x="4423356" y="2689919"/>
              <a:ext cx="450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D4A7FD6-C961-4446-9383-8B2E9AB7133B}"/>
                </a:ext>
              </a:extLst>
            </p:cNvPr>
            <p:cNvSpPr txBox="1"/>
            <p:nvPr/>
          </p:nvSpPr>
          <p:spPr>
            <a:xfrm rot="16200000">
              <a:off x="4448858" y="2536464"/>
              <a:ext cx="7577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406Q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28D870B-2A18-0347-93DE-D03952A56D30}"/>
                </a:ext>
              </a:extLst>
            </p:cNvPr>
            <p:cNvSpPr txBox="1"/>
            <p:nvPr/>
          </p:nvSpPr>
          <p:spPr>
            <a:xfrm rot="16200000">
              <a:off x="4640998" y="2505601"/>
              <a:ext cx="8195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mpty Vector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EABE05F8-5030-F943-9F3C-44751839B10C}"/>
              </a:ext>
            </a:extLst>
          </p:cNvPr>
          <p:cNvGrpSpPr/>
          <p:nvPr/>
        </p:nvGrpSpPr>
        <p:grpSpPr>
          <a:xfrm>
            <a:off x="727991" y="4451194"/>
            <a:ext cx="645864" cy="819509"/>
            <a:chOff x="5254034" y="2203568"/>
            <a:chExt cx="645864" cy="819509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25C9ECD-A07C-0849-ADEF-A7FAE31505F5}"/>
                </a:ext>
              </a:extLst>
            </p:cNvPr>
            <p:cNvSpPr txBox="1"/>
            <p:nvPr/>
          </p:nvSpPr>
          <p:spPr>
            <a:xfrm rot="16200000">
              <a:off x="5136319" y="2689919"/>
              <a:ext cx="450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2E4C50E-A84C-DE4E-ADDA-FF9B7756C5F9}"/>
                </a:ext>
              </a:extLst>
            </p:cNvPr>
            <p:cNvSpPr txBox="1"/>
            <p:nvPr/>
          </p:nvSpPr>
          <p:spPr>
            <a:xfrm rot="16200000">
              <a:off x="5195581" y="2536464"/>
              <a:ext cx="7577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406Q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45E3F02-73AD-1746-853E-669070BB240B}"/>
                </a:ext>
              </a:extLst>
            </p:cNvPr>
            <p:cNvSpPr txBox="1"/>
            <p:nvPr/>
          </p:nvSpPr>
          <p:spPr>
            <a:xfrm rot="16200000">
              <a:off x="5382421" y="2505601"/>
              <a:ext cx="8195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mpty Vector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4F66F376-C553-3648-9F27-3D576F1F6793}"/>
              </a:ext>
            </a:extLst>
          </p:cNvPr>
          <p:cNvSpPr txBox="1"/>
          <p:nvPr/>
        </p:nvSpPr>
        <p:spPr>
          <a:xfrm>
            <a:off x="1287795" y="4286130"/>
            <a:ext cx="893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FLAG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A3D8B33C-C143-DD4B-B54C-59E4C8236DA5}"/>
              </a:ext>
            </a:extLst>
          </p:cNvPr>
          <p:cNvCxnSpPr>
            <a:cxnSpLocks/>
          </p:cNvCxnSpPr>
          <p:nvPr/>
        </p:nvCxnSpPr>
        <p:spPr>
          <a:xfrm flipH="1">
            <a:off x="1450966" y="4494713"/>
            <a:ext cx="81861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88F54038-417A-2A48-8FDE-838FE8419CEA}"/>
              </a:ext>
            </a:extLst>
          </p:cNvPr>
          <p:cNvSpPr txBox="1"/>
          <p:nvPr/>
        </p:nvSpPr>
        <p:spPr>
          <a:xfrm>
            <a:off x="389941" y="4284676"/>
            <a:ext cx="893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CE0AD7C8-ACBA-E14A-82A9-B2E6F60ECEE6}"/>
              </a:ext>
            </a:extLst>
          </p:cNvPr>
          <p:cNvCxnSpPr>
            <a:cxnSpLocks/>
          </p:cNvCxnSpPr>
          <p:nvPr/>
        </p:nvCxnSpPr>
        <p:spPr>
          <a:xfrm flipH="1">
            <a:off x="770644" y="4493259"/>
            <a:ext cx="57466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7898856B-09B5-364E-A66C-ACC462685041}"/>
              </a:ext>
            </a:extLst>
          </p:cNvPr>
          <p:cNvSpPr txBox="1"/>
          <p:nvPr/>
        </p:nvSpPr>
        <p:spPr>
          <a:xfrm>
            <a:off x="1057975" y="4137147"/>
            <a:ext cx="10096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EK293 cell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BF2EE6F-62CA-F54A-ABD9-96924C89A3C4}"/>
              </a:ext>
            </a:extLst>
          </p:cNvPr>
          <p:cNvSpPr txBox="1"/>
          <p:nvPr/>
        </p:nvSpPr>
        <p:spPr>
          <a:xfrm>
            <a:off x="165602" y="5378210"/>
            <a:ext cx="5868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50 k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47A9D0D-294D-5049-A3CC-2FB34A3F6618}"/>
              </a:ext>
            </a:extLst>
          </p:cNvPr>
          <p:cNvSpPr txBox="1"/>
          <p:nvPr/>
        </p:nvSpPr>
        <p:spPr>
          <a:xfrm>
            <a:off x="165602" y="5634736"/>
            <a:ext cx="5204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50 k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B750B67-9D6A-AD4E-9E93-41A164EB8DEC}"/>
              </a:ext>
            </a:extLst>
          </p:cNvPr>
          <p:cNvSpPr txBox="1"/>
          <p:nvPr/>
        </p:nvSpPr>
        <p:spPr>
          <a:xfrm>
            <a:off x="165602" y="5868185"/>
            <a:ext cx="6094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0 kD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54201668-8B82-2448-9BFB-6D81E2789B7D}"/>
              </a:ext>
            </a:extLst>
          </p:cNvPr>
          <p:cNvGrpSpPr/>
          <p:nvPr/>
        </p:nvGrpSpPr>
        <p:grpSpPr>
          <a:xfrm>
            <a:off x="2240835" y="5315381"/>
            <a:ext cx="638363" cy="213715"/>
            <a:chOff x="2120588" y="1948198"/>
            <a:chExt cx="556241" cy="287131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A5A25645-A859-8840-B37F-B2DEB1224FE9}"/>
                </a:ext>
              </a:extLst>
            </p:cNvPr>
            <p:cNvSpPr txBox="1"/>
            <p:nvPr/>
          </p:nvSpPr>
          <p:spPr>
            <a:xfrm>
              <a:off x="2120588" y="1950321"/>
              <a:ext cx="556241" cy="162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OLR2A</a:t>
              </a:r>
            </a:p>
          </p:txBody>
        </p:sp>
        <p:sp>
          <p:nvSpPr>
            <p:cNvPr id="22" name="Right Brace 21">
              <a:extLst>
                <a:ext uri="{FF2B5EF4-FFF2-40B4-BE49-F238E27FC236}">
                  <a16:creationId xmlns:a16="http://schemas.microsoft.com/office/drawing/2014/main" id="{97108CE3-EACC-D840-822F-BBB22625796A}"/>
                </a:ext>
              </a:extLst>
            </p:cNvPr>
            <p:cNvSpPr/>
            <p:nvPr/>
          </p:nvSpPr>
          <p:spPr>
            <a:xfrm>
              <a:off x="2139728" y="1948198"/>
              <a:ext cx="39838" cy="287131"/>
            </a:xfrm>
            <a:prstGeom prst="righ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FB766FC6-EC11-C34F-8B31-480064C01B3E}"/>
              </a:ext>
            </a:extLst>
          </p:cNvPr>
          <p:cNvGrpSpPr/>
          <p:nvPr/>
        </p:nvGrpSpPr>
        <p:grpSpPr>
          <a:xfrm>
            <a:off x="2262801" y="5886818"/>
            <a:ext cx="644221" cy="251448"/>
            <a:chOff x="2128301" y="1947416"/>
            <a:chExt cx="561344" cy="189792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95CD86A-A2B9-5846-873F-409983E020A2}"/>
                </a:ext>
              </a:extLst>
            </p:cNvPr>
            <p:cNvSpPr txBox="1"/>
            <p:nvPr/>
          </p:nvSpPr>
          <p:spPr>
            <a:xfrm>
              <a:off x="2133404" y="1954181"/>
              <a:ext cx="556241" cy="162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RMC5</a:t>
              </a:r>
            </a:p>
          </p:txBody>
        </p:sp>
        <p:sp>
          <p:nvSpPr>
            <p:cNvPr id="25" name="Right Brace 24">
              <a:extLst>
                <a:ext uri="{FF2B5EF4-FFF2-40B4-BE49-F238E27FC236}">
                  <a16:creationId xmlns:a16="http://schemas.microsoft.com/office/drawing/2014/main" id="{A384708B-A1D5-BE40-8880-9B02B46FC541}"/>
                </a:ext>
              </a:extLst>
            </p:cNvPr>
            <p:cNvSpPr/>
            <p:nvPr/>
          </p:nvSpPr>
          <p:spPr>
            <a:xfrm>
              <a:off x="2128301" y="1947416"/>
              <a:ext cx="59245" cy="189792"/>
            </a:xfrm>
            <a:prstGeom prst="righ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40500663-083C-FD42-B202-BA391A9218E8}"/>
              </a:ext>
            </a:extLst>
          </p:cNvPr>
          <p:cNvSpPr txBox="1"/>
          <p:nvPr/>
        </p:nvSpPr>
        <p:spPr>
          <a:xfrm>
            <a:off x="911272" y="6425155"/>
            <a:ext cx="10350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onger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04C478F-6748-CB44-AC64-3736D2E3F672}"/>
              </a:ext>
            </a:extLst>
          </p:cNvPr>
          <p:cNvSpPr txBox="1"/>
          <p:nvPr/>
        </p:nvSpPr>
        <p:spPr>
          <a:xfrm>
            <a:off x="921365" y="7786042"/>
            <a:ext cx="10350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horter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824A325-5635-B348-B5B2-F47E1BC11042}"/>
              </a:ext>
            </a:extLst>
          </p:cNvPr>
          <p:cNvSpPr txBox="1"/>
          <p:nvPr/>
        </p:nvSpPr>
        <p:spPr>
          <a:xfrm>
            <a:off x="57638" y="189291"/>
            <a:ext cx="18438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9C</a:t>
            </a: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0B263416-093D-4B4F-A720-D06BABC5CBD3}"/>
              </a:ext>
            </a:extLst>
          </p:cNvPr>
          <p:cNvGrpSpPr/>
          <p:nvPr/>
        </p:nvGrpSpPr>
        <p:grpSpPr>
          <a:xfrm>
            <a:off x="346396" y="620099"/>
            <a:ext cx="1526840" cy="819509"/>
            <a:chOff x="631150" y="2203568"/>
            <a:chExt cx="1526840" cy="819509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D3837D7-0BA3-0C49-A21B-6711CD12A21C}"/>
                </a:ext>
              </a:extLst>
            </p:cNvPr>
            <p:cNvSpPr txBox="1"/>
            <p:nvPr/>
          </p:nvSpPr>
          <p:spPr>
            <a:xfrm rot="16200000">
              <a:off x="1824831" y="2689919"/>
              <a:ext cx="450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BF9E38F-CEC7-E744-86E7-DD4C23F33CE2}"/>
                </a:ext>
              </a:extLst>
            </p:cNvPr>
            <p:cNvSpPr txBox="1"/>
            <p:nvPr/>
          </p:nvSpPr>
          <p:spPr>
            <a:xfrm rot="16200000">
              <a:off x="1446430" y="2536464"/>
              <a:ext cx="7577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33S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2F5B1C8-68AB-C345-80CD-CBFA76CB73FE}"/>
                </a:ext>
              </a:extLst>
            </p:cNvPr>
            <p:cNvSpPr txBox="1"/>
            <p:nvPr/>
          </p:nvSpPr>
          <p:spPr>
            <a:xfrm rot="16200000">
              <a:off x="1026165" y="2536464"/>
              <a:ext cx="7577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422S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8311D2C-604E-814B-AE68-2A0928F3917C}"/>
                </a:ext>
              </a:extLst>
            </p:cNvPr>
            <p:cNvSpPr txBox="1"/>
            <p:nvPr/>
          </p:nvSpPr>
          <p:spPr>
            <a:xfrm rot="16200000">
              <a:off x="830170" y="2536464"/>
              <a:ext cx="7577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559L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33A23FC-73BD-E345-88E2-A5C79372607F}"/>
                </a:ext>
              </a:extLst>
            </p:cNvPr>
            <p:cNvSpPr txBox="1"/>
            <p:nvPr/>
          </p:nvSpPr>
          <p:spPr>
            <a:xfrm rot="16200000">
              <a:off x="580035" y="2536464"/>
              <a:ext cx="7577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793Q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1378E49-CBF3-414C-AFC1-828D1A0A37D5}"/>
                </a:ext>
              </a:extLst>
            </p:cNvPr>
            <p:cNvSpPr txBox="1"/>
            <p:nvPr/>
          </p:nvSpPr>
          <p:spPr>
            <a:xfrm rot="16200000">
              <a:off x="329117" y="2505601"/>
              <a:ext cx="8195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mpty Vector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0D333398-7F62-6A4A-8F04-56FCA4D01E34}"/>
                </a:ext>
              </a:extLst>
            </p:cNvPr>
            <p:cNvSpPr txBox="1"/>
            <p:nvPr/>
          </p:nvSpPr>
          <p:spPr>
            <a:xfrm rot="16200000">
              <a:off x="1248750" y="2536464"/>
              <a:ext cx="7577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VALID</a:t>
              </a:r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D8A85553-7307-EF49-9182-6FBC74D02A21}"/>
              </a:ext>
            </a:extLst>
          </p:cNvPr>
          <p:cNvSpPr txBox="1"/>
          <p:nvPr/>
        </p:nvSpPr>
        <p:spPr>
          <a:xfrm>
            <a:off x="3766908" y="1551485"/>
            <a:ext cx="5868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250 kD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DB92999-F2DE-8444-AD80-45EDADB42A75}"/>
              </a:ext>
            </a:extLst>
          </p:cNvPr>
          <p:cNvSpPr txBox="1"/>
          <p:nvPr/>
        </p:nvSpPr>
        <p:spPr>
          <a:xfrm>
            <a:off x="3758520" y="1838033"/>
            <a:ext cx="5204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50 kD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A246A18-C1FC-6E46-AE41-65E7935023DE}"/>
              </a:ext>
            </a:extLst>
          </p:cNvPr>
          <p:cNvSpPr txBox="1"/>
          <p:nvPr/>
        </p:nvSpPr>
        <p:spPr>
          <a:xfrm>
            <a:off x="3758095" y="2159600"/>
            <a:ext cx="6094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0 kD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E720CD5-B1B4-7A4A-8E3A-9E441C2D5E37}"/>
              </a:ext>
            </a:extLst>
          </p:cNvPr>
          <p:cNvSpPr txBox="1"/>
          <p:nvPr/>
        </p:nvSpPr>
        <p:spPr>
          <a:xfrm>
            <a:off x="688552" y="514088"/>
            <a:ext cx="893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FLAG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0B43C6C0-744D-D647-AF67-00C463657B5D}"/>
              </a:ext>
            </a:extLst>
          </p:cNvPr>
          <p:cNvCxnSpPr>
            <a:cxnSpLocks/>
          </p:cNvCxnSpPr>
          <p:nvPr/>
        </p:nvCxnSpPr>
        <p:spPr>
          <a:xfrm flipH="1">
            <a:off x="413785" y="694485"/>
            <a:ext cx="148503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48DC7D48-0E5F-F84F-96D0-C337365C0EDD}"/>
              </a:ext>
            </a:extLst>
          </p:cNvPr>
          <p:cNvCxnSpPr>
            <a:cxnSpLocks/>
          </p:cNvCxnSpPr>
          <p:nvPr/>
        </p:nvCxnSpPr>
        <p:spPr>
          <a:xfrm>
            <a:off x="296518" y="772914"/>
            <a:ext cx="0" cy="57560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8F3EE451-1765-AE49-ABC7-263258C182FC}"/>
              </a:ext>
            </a:extLst>
          </p:cNvPr>
          <p:cNvSpPr txBox="1"/>
          <p:nvPr/>
        </p:nvSpPr>
        <p:spPr>
          <a:xfrm rot="16200000">
            <a:off x="-285247" y="827764"/>
            <a:ext cx="1013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RMC5-FLAG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CB96D8D-B0B6-A24E-A6AA-1CF2A1C59291}"/>
              </a:ext>
            </a:extLst>
          </p:cNvPr>
          <p:cNvSpPr txBox="1"/>
          <p:nvPr/>
        </p:nvSpPr>
        <p:spPr>
          <a:xfrm>
            <a:off x="2238428" y="514088"/>
            <a:ext cx="893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85087C0C-F51B-6841-8FFC-899B71673FD0}"/>
              </a:ext>
            </a:extLst>
          </p:cNvPr>
          <p:cNvCxnSpPr>
            <a:cxnSpLocks/>
          </p:cNvCxnSpPr>
          <p:nvPr/>
        </p:nvCxnSpPr>
        <p:spPr>
          <a:xfrm flipH="1">
            <a:off x="2223203" y="686719"/>
            <a:ext cx="143447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0" name="Group 49">
            <a:extLst>
              <a:ext uri="{FF2B5EF4-FFF2-40B4-BE49-F238E27FC236}">
                <a16:creationId xmlns:a16="http://schemas.microsoft.com/office/drawing/2014/main" id="{5FB6B5F1-C647-B949-8B61-EEA779F15B66}"/>
              </a:ext>
            </a:extLst>
          </p:cNvPr>
          <p:cNvGrpSpPr/>
          <p:nvPr/>
        </p:nvGrpSpPr>
        <p:grpSpPr>
          <a:xfrm>
            <a:off x="2182340" y="620099"/>
            <a:ext cx="1528851" cy="832168"/>
            <a:chOff x="2224490" y="2203568"/>
            <a:chExt cx="1528851" cy="832168"/>
          </a:xfrm>
        </p:grpSpPr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77B3C798-7BBE-8346-97AE-74136A248DED}"/>
                </a:ext>
              </a:extLst>
            </p:cNvPr>
            <p:cNvSpPr txBox="1"/>
            <p:nvPr/>
          </p:nvSpPr>
          <p:spPr>
            <a:xfrm rot="16200000">
              <a:off x="3420182" y="2696848"/>
              <a:ext cx="450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2270ED47-759C-7142-9EC4-E6482107F405}"/>
                </a:ext>
              </a:extLst>
            </p:cNvPr>
            <p:cNvSpPr txBox="1"/>
            <p:nvPr/>
          </p:nvSpPr>
          <p:spPr>
            <a:xfrm rot="16200000">
              <a:off x="3029806" y="2549123"/>
              <a:ext cx="7577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33S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64753076-9830-464D-AEE9-A2C176AA68F7}"/>
                </a:ext>
              </a:extLst>
            </p:cNvPr>
            <p:cNvSpPr txBox="1"/>
            <p:nvPr/>
          </p:nvSpPr>
          <p:spPr>
            <a:xfrm rot="16200000">
              <a:off x="2601453" y="2536464"/>
              <a:ext cx="7577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422S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3CD08031-6BF6-8B48-88A4-B145C3C01467}"/>
                </a:ext>
              </a:extLst>
            </p:cNvPr>
            <p:cNvSpPr txBox="1"/>
            <p:nvPr/>
          </p:nvSpPr>
          <p:spPr>
            <a:xfrm rot="16200000">
              <a:off x="2369366" y="2536464"/>
              <a:ext cx="7577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559L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2200E4D0-8EDF-F142-9F00-911AA5AE4736}"/>
                </a:ext>
              </a:extLst>
            </p:cNvPr>
            <p:cNvSpPr txBox="1"/>
            <p:nvPr/>
          </p:nvSpPr>
          <p:spPr>
            <a:xfrm rot="16200000">
              <a:off x="2149311" y="2536464"/>
              <a:ext cx="7577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793Q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B7B5CD25-A25D-DA4B-9D3B-FB1C153D238A}"/>
                </a:ext>
              </a:extLst>
            </p:cNvPr>
            <p:cNvSpPr txBox="1"/>
            <p:nvPr/>
          </p:nvSpPr>
          <p:spPr>
            <a:xfrm rot="16200000">
              <a:off x="1922457" y="2505601"/>
              <a:ext cx="8195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mpty Vector</a:t>
              </a:r>
            </a:p>
          </p:txBody>
        </p:sp>
      </p:grpSp>
      <p:sp>
        <p:nvSpPr>
          <p:cNvPr id="60" name="TextBox 59">
            <a:extLst>
              <a:ext uri="{FF2B5EF4-FFF2-40B4-BE49-F238E27FC236}">
                <a16:creationId xmlns:a16="http://schemas.microsoft.com/office/drawing/2014/main" id="{955473D7-84C7-1043-9787-DC830BD2B317}"/>
              </a:ext>
            </a:extLst>
          </p:cNvPr>
          <p:cNvSpPr txBox="1"/>
          <p:nvPr/>
        </p:nvSpPr>
        <p:spPr>
          <a:xfrm>
            <a:off x="1534352" y="373106"/>
            <a:ext cx="10096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EK293 cells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9C4C41A-84EA-BB40-B2CD-FA70A9D4CC5C}"/>
              </a:ext>
            </a:extLst>
          </p:cNvPr>
          <p:cNvSpPr txBox="1"/>
          <p:nvPr/>
        </p:nvSpPr>
        <p:spPr>
          <a:xfrm rot="16200000">
            <a:off x="2782891" y="957888"/>
            <a:ext cx="7577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VALID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CB332FE6-CC32-8143-87FC-0F837F944F27}"/>
              </a:ext>
            </a:extLst>
          </p:cNvPr>
          <p:cNvSpPr txBox="1"/>
          <p:nvPr/>
        </p:nvSpPr>
        <p:spPr>
          <a:xfrm>
            <a:off x="209147" y="6098571"/>
            <a:ext cx="6094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75 kD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8E7DBA2A-5119-604F-862D-7436F89A48F5}"/>
              </a:ext>
            </a:extLst>
          </p:cNvPr>
          <p:cNvSpPr txBox="1"/>
          <p:nvPr/>
        </p:nvSpPr>
        <p:spPr>
          <a:xfrm>
            <a:off x="3761150" y="2308537"/>
            <a:ext cx="6094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75 kD</a:t>
            </a:r>
          </a:p>
        </p:txBody>
      </p:sp>
      <p:grpSp>
        <p:nvGrpSpPr>
          <p:cNvPr id="72" name="Group 71">
            <a:extLst>
              <a:ext uri="{FF2B5EF4-FFF2-40B4-BE49-F238E27FC236}">
                <a16:creationId xmlns:a16="http://schemas.microsoft.com/office/drawing/2014/main" id="{B5E4C0F2-1834-9E4D-998C-1787C663E6B8}"/>
              </a:ext>
            </a:extLst>
          </p:cNvPr>
          <p:cNvGrpSpPr/>
          <p:nvPr/>
        </p:nvGrpSpPr>
        <p:grpSpPr>
          <a:xfrm>
            <a:off x="4179030" y="2199840"/>
            <a:ext cx="638363" cy="219223"/>
            <a:chOff x="2128906" y="1975602"/>
            <a:chExt cx="556241" cy="166471"/>
          </a:xfrm>
        </p:grpSpPr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EBDCDF73-B7EA-4947-8A1E-11E57685F68D}"/>
                </a:ext>
              </a:extLst>
            </p:cNvPr>
            <p:cNvSpPr txBox="1"/>
            <p:nvPr/>
          </p:nvSpPr>
          <p:spPr>
            <a:xfrm>
              <a:off x="2128906" y="1979456"/>
              <a:ext cx="556241" cy="162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RMC5</a:t>
              </a:r>
            </a:p>
          </p:txBody>
        </p:sp>
        <p:sp>
          <p:nvSpPr>
            <p:cNvPr id="74" name="Right Brace 73">
              <a:extLst>
                <a:ext uri="{FF2B5EF4-FFF2-40B4-BE49-F238E27FC236}">
                  <a16:creationId xmlns:a16="http://schemas.microsoft.com/office/drawing/2014/main" id="{DA9E2A67-0396-A342-A649-C7098D2C2545}"/>
                </a:ext>
              </a:extLst>
            </p:cNvPr>
            <p:cNvSpPr/>
            <p:nvPr/>
          </p:nvSpPr>
          <p:spPr>
            <a:xfrm>
              <a:off x="2136432" y="1975602"/>
              <a:ext cx="46530" cy="161606"/>
            </a:xfrm>
            <a:prstGeom prst="righ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D2891A01-ADFE-E94F-A617-2EF5DF049DB3}"/>
              </a:ext>
            </a:extLst>
          </p:cNvPr>
          <p:cNvGrpSpPr/>
          <p:nvPr/>
        </p:nvGrpSpPr>
        <p:grpSpPr>
          <a:xfrm>
            <a:off x="4178334" y="1597279"/>
            <a:ext cx="638361" cy="165131"/>
            <a:chOff x="2133140" y="1975697"/>
            <a:chExt cx="556241" cy="221856"/>
          </a:xfrm>
        </p:grpSpPr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6C0DACC8-E6A7-0548-B5C7-037F2835F550}"/>
                </a:ext>
              </a:extLst>
            </p:cNvPr>
            <p:cNvSpPr txBox="1"/>
            <p:nvPr/>
          </p:nvSpPr>
          <p:spPr>
            <a:xfrm>
              <a:off x="2133140" y="1975697"/>
              <a:ext cx="556241" cy="162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OLR2A</a:t>
              </a:r>
            </a:p>
          </p:txBody>
        </p:sp>
        <p:sp>
          <p:nvSpPr>
            <p:cNvPr id="77" name="Right Brace 76">
              <a:extLst>
                <a:ext uri="{FF2B5EF4-FFF2-40B4-BE49-F238E27FC236}">
                  <a16:creationId xmlns:a16="http://schemas.microsoft.com/office/drawing/2014/main" id="{48CEE92E-F40E-804C-A645-DAD387D0B65F}"/>
                </a:ext>
              </a:extLst>
            </p:cNvPr>
            <p:cNvSpPr/>
            <p:nvPr/>
          </p:nvSpPr>
          <p:spPr>
            <a:xfrm>
              <a:off x="2139728" y="2006939"/>
              <a:ext cx="39838" cy="190614"/>
            </a:xfrm>
            <a:prstGeom prst="righ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78" name="Picture 77">
            <a:extLst>
              <a:ext uri="{FF2B5EF4-FFF2-40B4-BE49-F238E27FC236}">
                <a16:creationId xmlns:a16="http://schemas.microsoft.com/office/drawing/2014/main" id="{008E2DE9-E0F0-A642-90C8-17D193E9C8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8088" y="6598810"/>
            <a:ext cx="1660340" cy="1187232"/>
          </a:xfrm>
          <a:prstGeom prst="rect">
            <a:avLst/>
          </a:prstGeom>
        </p:spPr>
      </p:pic>
      <p:pic>
        <p:nvPicPr>
          <p:cNvPr id="79" name="Picture 78">
            <a:extLst>
              <a:ext uri="{FF2B5EF4-FFF2-40B4-BE49-F238E27FC236}">
                <a16:creationId xmlns:a16="http://schemas.microsoft.com/office/drawing/2014/main" id="{E84AD7E0-F72E-5841-8E74-9C9A6AA8EB3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7819" y="5254897"/>
            <a:ext cx="1660609" cy="1187425"/>
          </a:xfrm>
          <a:prstGeom prst="rect">
            <a:avLst/>
          </a:prstGeom>
        </p:spPr>
      </p:pic>
      <p:pic>
        <p:nvPicPr>
          <p:cNvPr id="80" name="Picture 79">
            <a:extLst>
              <a:ext uri="{FF2B5EF4-FFF2-40B4-BE49-F238E27FC236}">
                <a16:creationId xmlns:a16="http://schemas.microsoft.com/office/drawing/2014/main" id="{980EF1FF-439A-BA4A-91E2-FD50C721125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9017" b="1332"/>
          <a:stretch/>
        </p:blipFill>
        <p:spPr>
          <a:xfrm flipH="1">
            <a:off x="2040528" y="1439609"/>
            <a:ext cx="1795332" cy="1062142"/>
          </a:xfrm>
          <a:prstGeom prst="rect">
            <a:avLst/>
          </a:prstGeom>
        </p:spPr>
      </p:pic>
      <p:pic>
        <p:nvPicPr>
          <p:cNvPr id="81" name="Picture 80">
            <a:extLst>
              <a:ext uri="{FF2B5EF4-FFF2-40B4-BE49-F238E27FC236}">
                <a16:creationId xmlns:a16="http://schemas.microsoft.com/office/drawing/2014/main" id="{BB1DF963-4981-EF4D-85EF-FE38B8E37B4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9376" b="3078"/>
          <a:stretch/>
        </p:blipFill>
        <p:spPr>
          <a:xfrm flipH="1">
            <a:off x="227600" y="1446538"/>
            <a:ext cx="1797401" cy="1062142"/>
          </a:xfrm>
          <a:prstGeom prst="rect">
            <a:avLst/>
          </a:prstGeom>
        </p:spPr>
      </p:pic>
      <p:sp>
        <p:nvSpPr>
          <p:cNvPr id="83" name="Rectangle 82">
            <a:extLst>
              <a:ext uri="{FF2B5EF4-FFF2-40B4-BE49-F238E27FC236}">
                <a16:creationId xmlns:a16="http://schemas.microsoft.com/office/drawing/2014/main" id="{F5D9E72D-B94B-934F-9FE2-B177DD465004}"/>
              </a:ext>
            </a:extLst>
          </p:cNvPr>
          <p:cNvSpPr/>
          <p:nvPr/>
        </p:nvSpPr>
        <p:spPr>
          <a:xfrm>
            <a:off x="1273217" y="1446546"/>
            <a:ext cx="100186" cy="2224158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B824F14D-CC12-C54F-98EB-480FAE80EDE0}"/>
              </a:ext>
            </a:extLst>
          </p:cNvPr>
          <p:cNvSpPr/>
          <p:nvPr/>
        </p:nvSpPr>
        <p:spPr>
          <a:xfrm>
            <a:off x="3084600" y="1446545"/>
            <a:ext cx="104265" cy="2218993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7DD6DCE4-1D8E-EB49-8B76-2B4CBA12608D}"/>
              </a:ext>
            </a:extLst>
          </p:cNvPr>
          <p:cNvSpPr txBox="1"/>
          <p:nvPr/>
        </p:nvSpPr>
        <p:spPr>
          <a:xfrm>
            <a:off x="163956" y="6788999"/>
            <a:ext cx="5868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50 kD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FD3A564E-9A33-7845-A4C1-3B3EBFF1A94B}"/>
              </a:ext>
            </a:extLst>
          </p:cNvPr>
          <p:cNvSpPr txBox="1"/>
          <p:nvPr/>
        </p:nvSpPr>
        <p:spPr>
          <a:xfrm>
            <a:off x="163956" y="7045525"/>
            <a:ext cx="5204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50 kD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77BE4582-3A71-2243-98CD-123C881AC26F}"/>
              </a:ext>
            </a:extLst>
          </p:cNvPr>
          <p:cNvSpPr txBox="1"/>
          <p:nvPr/>
        </p:nvSpPr>
        <p:spPr>
          <a:xfrm>
            <a:off x="163956" y="7278974"/>
            <a:ext cx="6094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0 kD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C0D06B17-7E5B-5B4B-B42E-EDC23B01CD7E}"/>
              </a:ext>
            </a:extLst>
          </p:cNvPr>
          <p:cNvSpPr txBox="1"/>
          <p:nvPr/>
        </p:nvSpPr>
        <p:spPr>
          <a:xfrm>
            <a:off x="207501" y="7509360"/>
            <a:ext cx="6094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75 kD</a:t>
            </a:r>
          </a:p>
        </p:txBody>
      </p:sp>
      <p:grpSp>
        <p:nvGrpSpPr>
          <p:cNvPr id="89" name="Group 88">
            <a:extLst>
              <a:ext uri="{FF2B5EF4-FFF2-40B4-BE49-F238E27FC236}">
                <a16:creationId xmlns:a16="http://schemas.microsoft.com/office/drawing/2014/main" id="{E977CAA6-7D69-D748-968C-E0C9EF07D3A9}"/>
              </a:ext>
            </a:extLst>
          </p:cNvPr>
          <p:cNvGrpSpPr/>
          <p:nvPr/>
        </p:nvGrpSpPr>
        <p:grpSpPr>
          <a:xfrm>
            <a:off x="2240835" y="6707560"/>
            <a:ext cx="638363" cy="213715"/>
            <a:chOff x="2120588" y="1948198"/>
            <a:chExt cx="556241" cy="287131"/>
          </a:xfrm>
        </p:grpSpPr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75F6178B-3829-2340-9AE8-2719DB869BC4}"/>
                </a:ext>
              </a:extLst>
            </p:cNvPr>
            <p:cNvSpPr txBox="1"/>
            <p:nvPr/>
          </p:nvSpPr>
          <p:spPr>
            <a:xfrm>
              <a:off x="2120588" y="1950321"/>
              <a:ext cx="556241" cy="162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OLR2A</a:t>
              </a:r>
            </a:p>
          </p:txBody>
        </p:sp>
        <p:sp>
          <p:nvSpPr>
            <p:cNvPr id="91" name="Right Brace 90">
              <a:extLst>
                <a:ext uri="{FF2B5EF4-FFF2-40B4-BE49-F238E27FC236}">
                  <a16:creationId xmlns:a16="http://schemas.microsoft.com/office/drawing/2014/main" id="{4B8F7D6C-7819-6141-99E8-065771EB267B}"/>
                </a:ext>
              </a:extLst>
            </p:cNvPr>
            <p:cNvSpPr/>
            <p:nvPr/>
          </p:nvSpPr>
          <p:spPr>
            <a:xfrm>
              <a:off x="2139728" y="1948198"/>
              <a:ext cx="39838" cy="287131"/>
            </a:xfrm>
            <a:prstGeom prst="righ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2" name="Group 91">
            <a:extLst>
              <a:ext uri="{FF2B5EF4-FFF2-40B4-BE49-F238E27FC236}">
                <a16:creationId xmlns:a16="http://schemas.microsoft.com/office/drawing/2014/main" id="{1BDAD85D-9AD1-FC43-A8F5-9925D55A86B2}"/>
              </a:ext>
            </a:extLst>
          </p:cNvPr>
          <p:cNvGrpSpPr/>
          <p:nvPr/>
        </p:nvGrpSpPr>
        <p:grpSpPr>
          <a:xfrm>
            <a:off x="2270102" y="7175157"/>
            <a:ext cx="644221" cy="251448"/>
            <a:chOff x="2128301" y="1947416"/>
            <a:chExt cx="561344" cy="189792"/>
          </a:xfrm>
        </p:grpSpPr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C7F64E49-B497-924A-BF09-EE75F876129B}"/>
                </a:ext>
              </a:extLst>
            </p:cNvPr>
            <p:cNvSpPr txBox="1"/>
            <p:nvPr/>
          </p:nvSpPr>
          <p:spPr>
            <a:xfrm>
              <a:off x="2133404" y="1954181"/>
              <a:ext cx="556241" cy="162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RMC5</a:t>
              </a:r>
            </a:p>
          </p:txBody>
        </p:sp>
        <p:sp>
          <p:nvSpPr>
            <p:cNvPr id="94" name="Right Brace 93">
              <a:extLst>
                <a:ext uri="{FF2B5EF4-FFF2-40B4-BE49-F238E27FC236}">
                  <a16:creationId xmlns:a16="http://schemas.microsoft.com/office/drawing/2014/main" id="{462450EE-8BD4-D740-89C0-BF8A5B6891A1}"/>
                </a:ext>
              </a:extLst>
            </p:cNvPr>
            <p:cNvSpPr/>
            <p:nvPr/>
          </p:nvSpPr>
          <p:spPr>
            <a:xfrm>
              <a:off x="2128301" y="1947416"/>
              <a:ext cx="59245" cy="189792"/>
            </a:xfrm>
            <a:prstGeom prst="righ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5" name="TextBox 94">
            <a:extLst>
              <a:ext uri="{FF2B5EF4-FFF2-40B4-BE49-F238E27FC236}">
                <a16:creationId xmlns:a16="http://schemas.microsoft.com/office/drawing/2014/main" id="{7F83DCF4-90A7-DB41-B4B3-07A047089FEF}"/>
              </a:ext>
            </a:extLst>
          </p:cNvPr>
          <p:cNvSpPr txBox="1"/>
          <p:nvPr/>
        </p:nvSpPr>
        <p:spPr>
          <a:xfrm>
            <a:off x="3766908" y="2757970"/>
            <a:ext cx="5868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250 kD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C9B489DE-E408-8A4C-9C2B-8A78E3A35759}"/>
              </a:ext>
            </a:extLst>
          </p:cNvPr>
          <p:cNvSpPr txBox="1"/>
          <p:nvPr/>
        </p:nvSpPr>
        <p:spPr>
          <a:xfrm>
            <a:off x="3758520" y="3044518"/>
            <a:ext cx="5204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50 kD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EA544E08-5650-6542-AD4C-0F833E23D964}"/>
              </a:ext>
            </a:extLst>
          </p:cNvPr>
          <p:cNvSpPr txBox="1"/>
          <p:nvPr/>
        </p:nvSpPr>
        <p:spPr>
          <a:xfrm>
            <a:off x="3758095" y="3366085"/>
            <a:ext cx="6094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0 kD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22EC175B-3CCB-5C41-B182-ECC06F61B550}"/>
              </a:ext>
            </a:extLst>
          </p:cNvPr>
          <p:cNvSpPr txBox="1"/>
          <p:nvPr/>
        </p:nvSpPr>
        <p:spPr>
          <a:xfrm>
            <a:off x="3761150" y="3526524"/>
            <a:ext cx="6094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75 kD</a:t>
            </a:r>
          </a:p>
        </p:txBody>
      </p:sp>
      <p:grpSp>
        <p:nvGrpSpPr>
          <p:cNvPr id="99" name="Group 98">
            <a:extLst>
              <a:ext uri="{FF2B5EF4-FFF2-40B4-BE49-F238E27FC236}">
                <a16:creationId xmlns:a16="http://schemas.microsoft.com/office/drawing/2014/main" id="{C1AA9463-A036-9A40-8D53-22BDC4C8454C}"/>
              </a:ext>
            </a:extLst>
          </p:cNvPr>
          <p:cNvGrpSpPr/>
          <p:nvPr/>
        </p:nvGrpSpPr>
        <p:grpSpPr>
          <a:xfrm>
            <a:off x="4179030" y="3406325"/>
            <a:ext cx="638363" cy="219223"/>
            <a:chOff x="2128906" y="1975602"/>
            <a:chExt cx="556241" cy="166471"/>
          </a:xfrm>
        </p:grpSpPr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E6D07533-743C-C64E-B54C-F6146CB70DD1}"/>
                </a:ext>
              </a:extLst>
            </p:cNvPr>
            <p:cNvSpPr txBox="1"/>
            <p:nvPr/>
          </p:nvSpPr>
          <p:spPr>
            <a:xfrm>
              <a:off x="2128906" y="1979456"/>
              <a:ext cx="556241" cy="162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RMC5</a:t>
              </a:r>
            </a:p>
          </p:txBody>
        </p:sp>
        <p:sp>
          <p:nvSpPr>
            <p:cNvPr id="101" name="Right Brace 100">
              <a:extLst>
                <a:ext uri="{FF2B5EF4-FFF2-40B4-BE49-F238E27FC236}">
                  <a16:creationId xmlns:a16="http://schemas.microsoft.com/office/drawing/2014/main" id="{11DE51D2-8161-4A4B-B399-01496F657C4D}"/>
                </a:ext>
              </a:extLst>
            </p:cNvPr>
            <p:cNvSpPr/>
            <p:nvPr/>
          </p:nvSpPr>
          <p:spPr>
            <a:xfrm>
              <a:off x="2136432" y="1975602"/>
              <a:ext cx="46530" cy="161606"/>
            </a:xfrm>
            <a:prstGeom prst="righ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9279C38F-6A49-EB40-A27F-D4168D3453B6}"/>
              </a:ext>
            </a:extLst>
          </p:cNvPr>
          <p:cNvGrpSpPr/>
          <p:nvPr/>
        </p:nvGrpSpPr>
        <p:grpSpPr>
          <a:xfrm>
            <a:off x="4178334" y="2803764"/>
            <a:ext cx="638361" cy="165131"/>
            <a:chOff x="2133140" y="1975697"/>
            <a:chExt cx="556241" cy="221856"/>
          </a:xfrm>
        </p:grpSpPr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802E90B2-FA31-F54F-AEA6-58F46A59BC3A}"/>
                </a:ext>
              </a:extLst>
            </p:cNvPr>
            <p:cNvSpPr txBox="1"/>
            <p:nvPr/>
          </p:nvSpPr>
          <p:spPr>
            <a:xfrm>
              <a:off x="2133140" y="1975697"/>
              <a:ext cx="556241" cy="162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OLR2A</a:t>
              </a:r>
            </a:p>
          </p:txBody>
        </p:sp>
        <p:sp>
          <p:nvSpPr>
            <p:cNvPr id="104" name="Right Brace 103">
              <a:extLst>
                <a:ext uri="{FF2B5EF4-FFF2-40B4-BE49-F238E27FC236}">
                  <a16:creationId xmlns:a16="http://schemas.microsoft.com/office/drawing/2014/main" id="{C3725F03-22E1-D748-9585-C900716355DE}"/>
                </a:ext>
              </a:extLst>
            </p:cNvPr>
            <p:cNvSpPr/>
            <p:nvPr/>
          </p:nvSpPr>
          <p:spPr>
            <a:xfrm>
              <a:off x="2139728" y="2006939"/>
              <a:ext cx="39838" cy="190614"/>
            </a:xfrm>
            <a:prstGeom prst="righ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6" name="TextBox 105">
            <a:extLst>
              <a:ext uri="{FF2B5EF4-FFF2-40B4-BE49-F238E27FC236}">
                <a16:creationId xmlns:a16="http://schemas.microsoft.com/office/drawing/2014/main" id="{35FC380C-66BF-834B-9842-D46CBD048B85}"/>
              </a:ext>
            </a:extLst>
          </p:cNvPr>
          <p:cNvSpPr txBox="1"/>
          <p:nvPr/>
        </p:nvSpPr>
        <p:spPr>
          <a:xfrm>
            <a:off x="142677" y="2486235"/>
            <a:ext cx="10350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onger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D508C19D-CF1C-D848-8DC2-6986C0F9B719}"/>
              </a:ext>
            </a:extLst>
          </p:cNvPr>
          <p:cNvSpPr txBox="1"/>
          <p:nvPr/>
        </p:nvSpPr>
        <p:spPr>
          <a:xfrm>
            <a:off x="2041793" y="2486235"/>
            <a:ext cx="10350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onger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C24951BD-22EB-4E41-85BC-67F3BC0623C1}"/>
              </a:ext>
            </a:extLst>
          </p:cNvPr>
          <p:cNvSpPr txBox="1"/>
          <p:nvPr/>
        </p:nvSpPr>
        <p:spPr>
          <a:xfrm>
            <a:off x="159204" y="3645099"/>
            <a:ext cx="10350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horter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24DBEE5B-BCF6-3D4B-ADE0-D3F4D1A8F819}"/>
              </a:ext>
            </a:extLst>
          </p:cNvPr>
          <p:cNvSpPr txBox="1"/>
          <p:nvPr/>
        </p:nvSpPr>
        <p:spPr>
          <a:xfrm>
            <a:off x="2060219" y="3645099"/>
            <a:ext cx="10350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horter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</a:p>
        </p:txBody>
      </p:sp>
    </p:spTree>
    <p:extLst>
      <p:ext uri="{BB962C8B-B14F-4D97-AF65-F5344CB8AC3E}">
        <p14:creationId xmlns:p14="http://schemas.microsoft.com/office/powerpoint/2010/main" val="276379682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2972F75-B239-624B-AC0A-065AA1808593}"/>
              </a:ext>
            </a:extLst>
          </p:cNvPr>
          <p:cNvSpPr txBox="1"/>
          <p:nvPr/>
        </p:nvSpPr>
        <p:spPr>
          <a:xfrm rot="16200000" flipH="1">
            <a:off x="2514663" y="1427443"/>
            <a:ext cx="400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22CBACB-9F41-524E-BFD2-2EB350899DA0}"/>
              </a:ext>
            </a:extLst>
          </p:cNvPr>
          <p:cNvSpPr txBox="1"/>
          <p:nvPr/>
        </p:nvSpPr>
        <p:spPr>
          <a:xfrm rot="16200000" flipH="1">
            <a:off x="1957941" y="1308911"/>
            <a:ext cx="6245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793Q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A1AD145-5E53-7D40-9C49-D14EBF0709A0}"/>
              </a:ext>
            </a:extLst>
          </p:cNvPr>
          <p:cNvSpPr txBox="1"/>
          <p:nvPr/>
        </p:nvSpPr>
        <p:spPr>
          <a:xfrm>
            <a:off x="740694" y="1912664"/>
            <a:ext cx="727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CUL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305BFE3-2573-494A-83FB-6A279F92A23E}"/>
              </a:ext>
            </a:extLst>
          </p:cNvPr>
          <p:cNvSpPr txBox="1"/>
          <p:nvPr/>
        </p:nvSpPr>
        <p:spPr>
          <a:xfrm rot="16200000">
            <a:off x="2021119" y="1129835"/>
            <a:ext cx="9861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mpty Vector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844AA3D1-32EF-854F-9A64-7158885496AD}"/>
              </a:ext>
            </a:extLst>
          </p:cNvPr>
          <p:cNvCxnSpPr>
            <a:cxnSpLocks/>
          </p:cNvCxnSpPr>
          <p:nvPr/>
        </p:nvCxnSpPr>
        <p:spPr>
          <a:xfrm>
            <a:off x="1406420" y="908849"/>
            <a:ext cx="65166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4297ED7B-6BC3-9A4E-94CF-AB29830C4E3D}"/>
              </a:ext>
            </a:extLst>
          </p:cNvPr>
          <p:cNvSpPr txBox="1"/>
          <p:nvPr/>
        </p:nvSpPr>
        <p:spPr>
          <a:xfrm>
            <a:off x="2746880" y="1752210"/>
            <a:ext cx="57765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100 k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601DC25-64DD-414D-8ABE-AD8BD1F25F07}"/>
              </a:ext>
            </a:extLst>
          </p:cNvPr>
          <p:cNvSpPr txBox="1"/>
          <p:nvPr/>
        </p:nvSpPr>
        <p:spPr>
          <a:xfrm>
            <a:off x="2761332" y="1920359"/>
            <a:ext cx="53410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-75 k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54945CA-1259-DF4D-BBC4-912E25D67E3F}"/>
              </a:ext>
            </a:extLst>
          </p:cNvPr>
          <p:cNvSpPr txBox="1"/>
          <p:nvPr/>
        </p:nvSpPr>
        <p:spPr>
          <a:xfrm rot="16200000" flipH="1">
            <a:off x="1782840" y="1421016"/>
            <a:ext cx="400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9C6FFA5-3884-7C45-A3A1-BDAE844C68E3}"/>
              </a:ext>
            </a:extLst>
          </p:cNvPr>
          <p:cNvSpPr txBox="1"/>
          <p:nvPr/>
        </p:nvSpPr>
        <p:spPr>
          <a:xfrm rot="16200000" flipH="1">
            <a:off x="1155804" y="1308911"/>
            <a:ext cx="6245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793Q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89CC453-71E1-5F43-A387-583938907F8E}"/>
              </a:ext>
            </a:extLst>
          </p:cNvPr>
          <p:cNvSpPr txBox="1"/>
          <p:nvPr/>
        </p:nvSpPr>
        <p:spPr>
          <a:xfrm rot="16200000">
            <a:off x="1286358" y="1210868"/>
            <a:ext cx="8206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mpty Vecto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EF78D52-05AE-884B-9802-96919D34E7E2}"/>
              </a:ext>
            </a:extLst>
          </p:cNvPr>
          <p:cNvSpPr txBox="1"/>
          <p:nvPr/>
        </p:nvSpPr>
        <p:spPr>
          <a:xfrm>
            <a:off x="746441" y="1708942"/>
            <a:ext cx="714403" cy="2222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FLAG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399A2AA7-8625-E948-AE13-5DB8ACE02C58}"/>
              </a:ext>
            </a:extLst>
          </p:cNvPr>
          <p:cNvCxnSpPr>
            <a:cxnSpLocks/>
          </p:cNvCxnSpPr>
          <p:nvPr/>
        </p:nvCxnSpPr>
        <p:spPr>
          <a:xfrm>
            <a:off x="2225474" y="908849"/>
            <a:ext cx="65166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51E03965-E039-F642-9C62-AFEBA07F0D18}"/>
              </a:ext>
            </a:extLst>
          </p:cNvPr>
          <p:cNvSpPr txBox="1"/>
          <p:nvPr/>
        </p:nvSpPr>
        <p:spPr>
          <a:xfrm>
            <a:off x="1367630" y="721820"/>
            <a:ext cx="742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FLAG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7FF747F-5B3C-8A43-98E1-9C7F72948084}"/>
              </a:ext>
            </a:extLst>
          </p:cNvPr>
          <p:cNvSpPr txBox="1"/>
          <p:nvPr/>
        </p:nvSpPr>
        <p:spPr>
          <a:xfrm>
            <a:off x="2296697" y="721820"/>
            <a:ext cx="4845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1B31285A-3CEF-574E-B3E7-59E823725322}"/>
              </a:ext>
            </a:extLst>
          </p:cNvPr>
          <p:cNvCxnSpPr/>
          <p:nvPr/>
        </p:nvCxnSpPr>
        <p:spPr>
          <a:xfrm>
            <a:off x="1314018" y="1058333"/>
            <a:ext cx="0" cy="57560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E697BC1A-5A05-FC48-ABB2-3C13A35F1DB1}"/>
              </a:ext>
            </a:extLst>
          </p:cNvPr>
          <p:cNvSpPr txBox="1"/>
          <p:nvPr/>
        </p:nvSpPr>
        <p:spPr>
          <a:xfrm rot="16200000">
            <a:off x="723628" y="1146803"/>
            <a:ext cx="1013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RMC5-FLA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EA9A22B-0EF6-5749-ACFB-F120F0A63EE1}"/>
              </a:ext>
            </a:extLst>
          </p:cNvPr>
          <p:cNvSpPr txBox="1"/>
          <p:nvPr/>
        </p:nvSpPr>
        <p:spPr>
          <a:xfrm>
            <a:off x="1633112" y="575986"/>
            <a:ext cx="10956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EK293 cells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B5B99168-6438-164B-9C91-B96D82022D7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8923" r="6570" b="29679"/>
          <a:stretch/>
        </p:blipFill>
        <p:spPr>
          <a:xfrm flipH="1">
            <a:off x="1423177" y="1720131"/>
            <a:ext cx="708764" cy="543824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E3846174-5A52-BF43-8F48-BFD794EB3C2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5385"/>
          <a:stretch/>
        </p:blipFill>
        <p:spPr>
          <a:xfrm>
            <a:off x="2160434" y="1720132"/>
            <a:ext cx="686542" cy="543824"/>
          </a:xfrm>
          <a:prstGeom prst="rect">
            <a:avLst/>
          </a:prstGeom>
        </p:spPr>
      </p:pic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CE08ADA7-AB13-D647-9CF3-B7BD0E87C594}"/>
              </a:ext>
            </a:extLst>
          </p:cNvPr>
          <p:cNvCxnSpPr>
            <a:endCxn id="8" idx="0"/>
          </p:cNvCxnSpPr>
          <p:nvPr/>
        </p:nvCxnSpPr>
        <p:spPr>
          <a:xfrm>
            <a:off x="2846976" y="1920359"/>
            <a:ext cx="181411" cy="0"/>
          </a:xfrm>
          <a:prstGeom prst="straightConnector1">
            <a:avLst/>
          </a:prstGeom>
          <a:ln>
            <a:headEnd type="none" w="med" len="med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75CFD77A-4B34-6745-8699-2D0D5E605A6F}"/>
              </a:ext>
            </a:extLst>
          </p:cNvPr>
          <p:cNvSpPr txBox="1"/>
          <p:nvPr/>
        </p:nvSpPr>
        <p:spPr>
          <a:xfrm>
            <a:off x="2985671" y="1820331"/>
            <a:ext cx="7299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Non-specifi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E39C0C8-B904-F54F-A6F1-22F6CBDA1B04}"/>
              </a:ext>
            </a:extLst>
          </p:cNvPr>
          <p:cNvSpPr txBox="1"/>
          <p:nvPr/>
        </p:nvSpPr>
        <p:spPr>
          <a:xfrm>
            <a:off x="2982911" y="1952265"/>
            <a:ext cx="7299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UL3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0D42128E-1A6A-6647-813B-91B8539FA0C1}"/>
              </a:ext>
            </a:extLst>
          </p:cNvPr>
          <p:cNvCxnSpPr/>
          <p:nvPr/>
        </p:nvCxnSpPr>
        <p:spPr>
          <a:xfrm>
            <a:off x="2842626" y="2057084"/>
            <a:ext cx="181411" cy="0"/>
          </a:xfrm>
          <a:prstGeom prst="straightConnector1">
            <a:avLst/>
          </a:prstGeom>
          <a:ln>
            <a:headEnd type="none" w="med" len="med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00393672-003C-E34E-943C-AF9173168E14}"/>
              </a:ext>
            </a:extLst>
          </p:cNvPr>
          <p:cNvCxnSpPr/>
          <p:nvPr/>
        </p:nvCxnSpPr>
        <p:spPr>
          <a:xfrm>
            <a:off x="2842626" y="1806982"/>
            <a:ext cx="181411" cy="0"/>
          </a:xfrm>
          <a:prstGeom prst="straightConnector1">
            <a:avLst/>
          </a:prstGeom>
          <a:ln>
            <a:headEnd type="none" w="med" len="med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725C1DD7-46C0-D347-A2B0-CDE58BD588A7}"/>
              </a:ext>
            </a:extLst>
          </p:cNvPr>
          <p:cNvSpPr txBox="1"/>
          <p:nvPr/>
        </p:nvSpPr>
        <p:spPr>
          <a:xfrm>
            <a:off x="2984947" y="1696297"/>
            <a:ext cx="7299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ARMC5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AE96889-BB70-4A8B-9138-E8DE0FCA380F}"/>
              </a:ext>
            </a:extLst>
          </p:cNvPr>
          <p:cNvSpPr txBox="1"/>
          <p:nvPr/>
        </p:nvSpPr>
        <p:spPr>
          <a:xfrm>
            <a:off x="218513" y="122841"/>
            <a:ext cx="1472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9D </a:t>
            </a:r>
            <a:endParaRPr lang="en-CA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45559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0E13B56-7093-4E97-B954-8B45E6DB2F8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2676" t="-696" r="4412" b="60156"/>
          <a:stretch/>
        </p:blipFill>
        <p:spPr>
          <a:xfrm>
            <a:off x="1477590" y="2937642"/>
            <a:ext cx="2930407" cy="92100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64F9EDF-CA9A-4993-96B7-B3BC65CF3C92}"/>
              </a:ext>
            </a:extLst>
          </p:cNvPr>
          <p:cNvSpPr txBox="1"/>
          <p:nvPr/>
        </p:nvSpPr>
        <p:spPr>
          <a:xfrm>
            <a:off x="608817" y="2121882"/>
            <a:ext cx="7505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74207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:</a:t>
            </a:r>
          </a:p>
          <a:p>
            <a:pPr algn="ctr" defTabSz="474207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POLR2A</a:t>
            </a:r>
          </a:p>
          <a:p>
            <a:pPr algn="ctr" defTabSz="474207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4H8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A879F1A-27F1-462C-90F5-9C094D809DBB}"/>
              </a:ext>
            </a:extLst>
          </p:cNvPr>
          <p:cNvSpPr txBox="1"/>
          <p:nvPr/>
        </p:nvSpPr>
        <p:spPr>
          <a:xfrm>
            <a:off x="4417193" y="2261097"/>
            <a:ext cx="60611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74207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250 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961FDE4-9927-484F-877E-5C6F034B97F9}"/>
              </a:ext>
            </a:extLst>
          </p:cNvPr>
          <p:cNvSpPr txBox="1"/>
          <p:nvPr/>
        </p:nvSpPr>
        <p:spPr>
          <a:xfrm>
            <a:off x="4307437" y="2701094"/>
            <a:ext cx="60611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74207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150 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1084BB3-99C7-4A72-B1D1-4BC4FDCF8B52}"/>
              </a:ext>
            </a:extLst>
          </p:cNvPr>
          <p:cNvSpPr txBox="1"/>
          <p:nvPr/>
        </p:nvSpPr>
        <p:spPr>
          <a:xfrm>
            <a:off x="4334194" y="3345200"/>
            <a:ext cx="5800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74207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D628458-FB70-45BC-AF0E-D903552142E6}"/>
              </a:ext>
            </a:extLst>
          </p:cNvPr>
          <p:cNvSpPr txBox="1"/>
          <p:nvPr/>
        </p:nvSpPr>
        <p:spPr>
          <a:xfrm>
            <a:off x="4325026" y="4304459"/>
            <a:ext cx="606111" cy="200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74207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150 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F5C536E-6258-4464-BF13-918249E7D814}"/>
              </a:ext>
            </a:extLst>
          </p:cNvPr>
          <p:cNvSpPr txBox="1"/>
          <p:nvPr/>
        </p:nvSpPr>
        <p:spPr>
          <a:xfrm>
            <a:off x="4334194" y="4655212"/>
            <a:ext cx="60611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74207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7B83A33-282F-42BF-86BA-01A5DA091AD0}"/>
              </a:ext>
            </a:extLst>
          </p:cNvPr>
          <p:cNvSpPr txBox="1"/>
          <p:nvPr/>
        </p:nvSpPr>
        <p:spPr>
          <a:xfrm>
            <a:off x="4327457" y="5480052"/>
            <a:ext cx="4899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74207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75 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7C27000-2C8C-46C4-8001-9523E9685D11}"/>
              </a:ext>
            </a:extLst>
          </p:cNvPr>
          <p:cNvSpPr txBox="1"/>
          <p:nvPr/>
        </p:nvSpPr>
        <p:spPr>
          <a:xfrm>
            <a:off x="831860" y="5197693"/>
            <a:ext cx="836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74207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8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in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D174D56-56FA-4E5C-90B6-D8853283D889}"/>
              </a:ext>
            </a:extLst>
          </p:cNvPr>
          <p:cNvSpPr txBox="1"/>
          <p:nvPr/>
        </p:nvSpPr>
        <p:spPr>
          <a:xfrm>
            <a:off x="812168" y="3396653"/>
            <a:ext cx="607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74207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H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A7BA85E-776E-4DAF-B221-A73C5923673D}"/>
              </a:ext>
            </a:extLst>
          </p:cNvPr>
          <p:cNvSpPr txBox="1"/>
          <p:nvPr/>
        </p:nvSpPr>
        <p:spPr>
          <a:xfrm>
            <a:off x="776811" y="4346982"/>
            <a:ext cx="8475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74207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FLAG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1BD140FC-7C57-49A1-B76D-ED8CA098DC22}"/>
              </a:ext>
            </a:extLst>
          </p:cNvPr>
          <p:cNvGrpSpPr/>
          <p:nvPr/>
        </p:nvGrpSpPr>
        <p:grpSpPr>
          <a:xfrm>
            <a:off x="4402065" y="2027953"/>
            <a:ext cx="604866" cy="380408"/>
            <a:chOff x="2116447" y="1948198"/>
            <a:chExt cx="527054" cy="287131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57722F5-8352-4500-A5AC-DCD5A279189D}"/>
                </a:ext>
              </a:extLst>
            </p:cNvPr>
            <p:cNvSpPr txBox="1"/>
            <p:nvPr/>
          </p:nvSpPr>
          <p:spPr>
            <a:xfrm>
              <a:off x="2116447" y="2009417"/>
              <a:ext cx="527054" cy="162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742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OLR2A</a:t>
              </a:r>
            </a:p>
          </p:txBody>
        </p:sp>
        <p:sp>
          <p:nvSpPr>
            <p:cNvPr id="17" name="Right Brace 16">
              <a:extLst>
                <a:ext uri="{FF2B5EF4-FFF2-40B4-BE49-F238E27FC236}">
                  <a16:creationId xmlns:a16="http://schemas.microsoft.com/office/drawing/2014/main" id="{2314C68A-F971-42B3-A0AA-E2068CA5C2DF}"/>
                </a:ext>
              </a:extLst>
            </p:cNvPr>
            <p:cNvSpPr/>
            <p:nvPr/>
          </p:nvSpPr>
          <p:spPr>
            <a:xfrm>
              <a:off x="2139728" y="1948198"/>
              <a:ext cx="39838" cy="287131"/>
            </a:xfrm>
            <a:prstGeom prst="rightBrac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742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6D4FD09C-EBBF-45D9-8180-14B1F5428BA0}"/>
              </a:ext>
            </a:extLst>
          </p:cNvPr>
          <p:cNvSpPr txBox="1"/>
          <p:nvPr/>
        </p:nvSpPr>
        <p:spPr>
          <a:xfrm>
            <a:off x="2014698" y="880345"/>
            <a:ext cx="2074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74207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fected with </a:t>
            </a:r>
            <a:r>
              <a:rPr lang="en-US" sz="8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HA   IP: </a:t>
            </a:r>
            <a:r>
              <a:rPr lang="en-US" sz="800" dirty="0">
                <a:solidFill>
                  <a:prstClr val="black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HA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ADC7B7F0-9DC9-4F11-BD43-4E4B4350B544}"/>
              </a:ext>
            </a:extLst>
          </p:cNvPr>
          <p:cNvCxnSpPr/>
          <p:nvPr/>
        </p:nvCxnSpPr>
        <p:spPr>
          <a:xfrm flipH="1">
            <a:off x="2014698" y="1067374"/>
            <a:ext cx="1803897" cy="6751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03876CB1-6551-4DAF-BD46-A16557B3314D}"/>
              </a:ext>
            </a:extLst>
          </p:cNvPr>
          <p:cNvSpPr txBox="1"/>
          <p:nvPr/>
        </p:nvSpPr>
        <p:spPr>
          <a:xfrm>
            <a:off x="4321185" y="5313109"/>
            <a:ext cx="60611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74207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81DEB0B4-7009-44BC-9210-85FAE206C7D8}"/>
              </a:ext>
            </a:extLst>
          </p:cNvPr>
          <p:cNvGrpSpPr/>
          <p:nvPr/>
        </p:nvGrpSpPr>
        <p:grpSpPr>
          <a:xfrm>
            <a:off x="1923796" y="1038114"/>
            <a:ext cx="1963143" cy="838771"/>
            <a:chOff x="3967053" y="4119728"/>
            <a:chExt cx="1963143" cy="838771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F9186D4-113D-4266-AD39-DD8647DB244D}"/>
                </a:ext>
              </a:extLst>
            </p:cNvPr>
            <p:cNvSpPr txBox="1"/>
            <p:nvPr/>
          </p:nvSpPr>
          <p:spPr>
            <a:xfrm rot="16200000">
              <a:off x="4121573" y="4647903"/>
              <a:ext cx="405746" cy="21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74207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691764F-32F8-4063-AE80-7779C08FE1D5}"/>
                </a:ext>
              </a:extLst>
            </p:cNvPr>
            <p:cNvSpPr txBox="1"/>
            <p:nvPr/>
          </p:nvSpPr>
          <p:spPr>
            <a:xfrm rot="16200000">
              <a:off x="4191672" y="4468331"/>
              <a:ext cx="764890" cy="21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74207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793Q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BAE7208-108E-4EE7-863F-C839DECFE268}"/>
                </a:ext>
              </a:extLst>
            </p:cNvPr>
            <p:cNvSpPr txBox="1"/>
            <p:nvPr/>
          </p:nvSpPr>
          <p:spPr>
            <a:xfrm rot="16200000">
              <a:off x="4421451" y="4448439"/>
              <a:ext cx="804675" cy="21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74207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559L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31CDE5B-6DFC-4AD7-AAF1-0DCFC1329F37}"/>
                </a:ext>
              </a:extLst>
            </p:cNvPr>
            <p:cNvSpPr txBox="1"/>
            <p:nvPr/>
          </p:nvSpPr>
          <p:spPr>
            <a:xfrm rot="16200000">
              <a:off x="4667931" y="4445248"/>
              <a:ext cx="811056" cy="21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74207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422S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76DCD13-54F7-4D2E-BDC8-053B59D87AAE}"/>
                </a:ext>
              </a:extLst>
            </p:cNvPr>
            <p:cNvSpPr txBox="1"/>
            <p:nvPr/>
          </p:nvSpPr>
          <p:spPr>
            <a:xfrm rot="16200000">
              <a:off x="4917602" y="4445248"/>
              <a:ext cx="811057" cy="21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74207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406Q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B078D1A-334F-4FDF-98F3-05FBC75CD7FA}"/>
                </a:ext>
              </a:extLst>
            </p:cNvPr>
            <p:cNvSpPr txBox="1"/>
            <p:nvPr/>
          </p:nvSpPr>
          <p:spPr>
            <a:xfrm rot="16200000">
              <a:off x="5267576" y="4545551"/>
              <a:ext cx="610450" cy="21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74207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334C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25AA02A-FA15-4D58-8339-A7E0D549EA37}"/>
                </a:ext>
              </a:extLst>
            </p:cNvPr>
            <p:cNvSpPr txBox="1"/>
            <p:nvPr/>
          </p:nvSpPr>
          <p:spPr>
            <a:xfrm rot="16200000">
              <a:off x="5517248" y="4545550"/>
              <a:ext cx="610452" cy="21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74207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33S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66E1ADC-4113-4705-A520-7F62728CFE41}"/>
                </a:ext>
              </a:extLst>
            </p:cNvPr>
            <p:cNvSpPr txBox="1"/>
            <p:nvPr/>
          </p:nvSpPr>
          <p:spPr>
            <a:xfrm rot="16200000">
              <a:off x="3655390" y="4431391"/>
              <a:ext cx="838771" cy="21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74207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mpty Vector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600CB8FA-DF26-490A-B1B3-AC111EB66BB4}"/>
              </a:ext>
            </a:extLst>
          </p:cNvPr>
          <p:cNvSpPr txBox="1"/>
          <p:nvPr/>
        </p:nvSpPr>
        <p:spPr>
          <a:xfrm rot="16200000">
            <a:off x="1267304" y="1340022"/>
            <a:ext cx="9271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74207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MC5-FLAG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79117BD1-EE48-47F5-98A0-5E5ABDA3DCDE}"/>
              </a:ext>
            </a:extLst>
          </p:cNvPr>
          <p:cNvCxnSpPr>
            <a:cxnSpLocks/>
          </p:cNvCxnSpPr>
          <p:nvPr/>
        </p:nvCxnSpPr>
        <p:spPr>
          <a:xfrm flipV="1">
            <a:off x="1892640" y="1272524"/>
            <a:ext cx="0" cy="510614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B33C27A2-A507-4E29-8C91-166CE38366CF}"/>
              </a:ext>
            </a:extLst>
          </p:cNvPr>
          <p:cNvCxnSpPr>
            <a:cxnSpLocks/>
          </p:cNvCxnSpPr>
          <p:nvPr/>
        </p:nvCxnSpPr>
        <p:spPr>
          <a:xfrm flipH="1">
            <a:off x="2001169" y="4046209"/>
            <a:ext cx="1905840" cy="6751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DC1615BB-3EED-4F84-9B09-FFEC6AD92B76}"/>
              </a:ext>
            </a:extLst>
          </p:cNvPr>
          <p:cNvSpPr txBox="1"/>
          <p:nvPr/>
        </p:nvSpPr>
        <p:spPr>
          <a:xfrm>
            <a:off x="2753961" y="3850437"/>
            <a:ext cx="5956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74207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DB4AFD2-B15E-4F5A-8095-21CC6C81C119}"/>
              </a:ext>
            </a:extLst>
          </p:cNvPr>
          <p:cNvSpPr txBox="1"/>
          <p:nvPr/>
        </p:nvSpPr>
        <p:spPr>
          <a:xfrm>
            <a:off x="2395216" y="734511"/>
            <a:ext cx="11600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74207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K293  cells 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39418D4-BC70-4098-B50B-A899C71671F5}"/>
              </a:ext>
            </a:extLst>
          </p:cNvPr>
          <p:cNvSpPr txBox="1"/>
          <p:nvPr/>
        </p:nvSpPr>
        <p:spPr>
          <a:xfrm>
            <a:off x="4322598" y="3549454"/>
            <a:ext cx="4899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74207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75 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66EFA6EB-83DD-489F-8DCB-B29715E4F929}"/>
              </a:ext>
            </a:extLst>
          </p:cNvPr>
          <p:cNvGrpSpPr/>
          <p:nvPr/>
        </p:nvGrpSpPr>
        <p:grpSpPr>
          <a:xfrm>
            <a:off x="4413050" y="4501462"/>
            <a:ext cx="578146" cy="220382"/>
            <a:chOff x="2126172" y="1940471"/>
            <a:chExt cx="503771" cy="151760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9B40AD3-F43E-48CB-8BCE-A7764D63D19E}"/>
                </a:ext>
              </a:extLst>
            </p:cNvPr>
            <p:cNvSpPr txBox="1"/>
            <p:nvPr/>
          </p:nvSpPr>
          <p:spPr>
            <a:xfrm>
              <a:off x="2152105" y="1940471"/>
              <a:ext cx="477838" cy="148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742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RMC5</a:t>
              </a:r>
            </a:p>
          </p:txBody>
        </p:sp>
        <p:sp>
          <p:nvSpPr>
            <p:cNvPr id="39" name="Right Brace 38">
              <a:extLst>
                <a:ext uri="{FF2B5EF4-FFF2-40B4-BE49-F238E27FC236}">
                  <a16:creationId xmlns:a16="http://schemas.microsoft.com/office/drawing/2014/main" id="{7A94E789-91C5-4691-A630-248649FF621D}"/>
                </a:ext>
              </a:extLst>
            </p:cNvPr>
            <p:cNvSpPr/>
            <p:nvPr/>
          </p:nvSpPr>
          <p:spPr>
            <a:xfrm>
              <a:off x="2126172" y="1948199"/>
              <a:ext cx="53395" cy="144032"/>
            </a:xfrm>
            <a:prstGeom prst="rightBrac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742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pic>
        <p:nvPicPr>
          <p:cNvPr id="40" name="Picture 39">
            <a:extLst>
              <a:ext uri="{FF2B5EF4-FFF2-40B4-BE49-F238E27FC236}">
                <a16:creationId xmlns:a16="http://schemas.microsoft.com/office/drawing/2014/main" id="{9FF66A86-6675-4897-9212-2D797ECE3FB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4136" t="52400" r="3437"/>
          <a:stretch/>
        </p:blipFill>
        <p:spPr>
          <a:xfrm>
            <a:off x="1465682" y="1831380"/>
            <a:ext cx="2901928" cy="1076489"/>
          </a:xfrm>
          <a:prstGeom prst="rect">
            <a:avLst/>
          </a:prstGeom>
        </p:spPr>
      </p:pic>
      <p:pic>
        <p:nvPicPr>
          <p:cNvPr id="41" name="Picture 4" descr="https://attachments.office.net/owa/hongyu.luo%40umontreal.ca/service.svc/s/GetAttachmentThumbnail?id=AAMkADU3MDgxNTA1LTZiNTctNGNhZi04M2M0LTgxNjY1OGE3M2NmZABGAAAAAABzUssUrvcMTIRZlBNbKtJLBwDn62b1UREgRa7DHJ%2FD50ZOAAK%2BmkX2AADn62b1UREgRa7DHJ%2FD50ZOAAK%2BmnlpAAABEgAQAO7V9wM7xMpMi2GmwdZ8IfA%3D&amp;thumbnailType=2&amp;token=eyJhbGciOiJSUzI1NiIsImtpZCI6IkQ4OThGN0RDMjk2ODQ1MDk1RUUwREZGQ0MzODBBOTM5NjUwNDNFNjQiLCJ0eXAiOiJKV1QiLCJ4NXQiOiIySmozM0Nsb1JRbGU0Tl84dzRDcE9XVUVQbVEifQ.eyJvcmlnaW4iOiJodHRwczovL291dGxvb2sub2ZmaWNlLmNvbSIsInVjIjoiYjg2NmQ2NDdlYzA2NGE3MjlmOWU0Yzk4M2ZkMGFlNzkiLCJzaWduaW5fc3RhdGUiOiJbXCJrbXNpXCJdIiwidmVyIjoiRXhjaGFuZ2UuQ2FsbGJhY2suVjEiLCJhcHBjdHhzZW5kZXIiOiJPd2FEb3dubG9hZEBkMjdlZWZlYy0yYTQ3LTRiZTctOTgxZS0wZjg5NzdmYTMxZDgiLCJpc3NyaW5nIjoiV1ciLCJhcHBjdHgiOiJ7XCJtc2V4Y2hwcm90XCI6XCJvd2FcIixcInB1aWRcIjpcIjExNTM5MDY2NjA5NDQ2ODY5NjJcIixcInNjb3BlXCI6XCJPd2FEb3dubG9hZFwiLFwib2lkXCI6XCJmMTRjYjhjNi1lYzA2LTQyZTAtOGZiMS0wNGIxNjg3MjMyMjZcIixcInByaW1hcnlzaWRcIjpcIlMtMS01LTIxLTI5NzMzOTAwOTctMTUyMDE2OTQwLTI1MTg4NzM1NDAtNzk0MjkxNlwifSIsIm5iZiI6MTY2OTgzNDA4OCwiZXhwIjoxNjY5ODM0Njg4LCJpc3MiOiIwMDAwMDAwMi0wMDAwLTBmZjEtY2UwMC0wMDAwMDAwMDAwMDBAZDI3ZWVmZWMtMmE0Ny00YmU3LTk4MWUtMGY4OTc3ZmEzMWQ4IiwiYXVkIjoiMDAwMDAwMDItMDAwMC0wZmYxLWNlMDAtMDAwMDAwMDAwMDAwL2F0dGFjaG1lbnRzLm9mZmljZS5uZXRAZDI3ZWVmZWMtMmE0Ny00YmU3LTk4MWUtMGY4OTc3ZmEzMWQ4IiwiaGFwcCI6Im93YSJ9.jLYo_yIfU8Wt26SNzIRnUTKUzi-wwdzSy6SJbcAZVc3mrcYxZifI4nysyUUQDpGTRTWAfYnDrcpu2GJd2k5TpPrZPG1o5P4QGRN4_3tIetXERq4CLstHF8AR2n0--pkikuzbP-ydzSTqdKjBcZaFOS2lfADSYFwf2n4YqzgKklf7X4VL9CaLJcuD0JN0j9AbiMaxiwY44L5ARqMQ9Y8uXXie0GQ78AUqE7UqSeAC63I7jWcpcMK875UqpcG7mYBp6y9l8G7bLA3nACPhDFjI1VfZWMfkysceb_mrkqi91BiJ2-pRbunG6W9W-mMxqeIOFTLA3QlM7khVrE7rG-VxLw&amp;X-OWA-CANARY=c9YpIDdfNU-pJ5XQJaJ3kcBaHbwD09oYtQrx6n-3YauaAJ_b9dPoGkqjRRXtOQAQR30NKU2X9Ig.&amp;owa=outlook.office.com&amp;scriptVer=20221104009.08&amp;animation=true">
            <a:extLst>
              <a:ext uri="{FF2B5EF4-FFF2-40B4-BE49-F238E27FC236}">
                <a16:creationId xmlns:a16="http://schemas.microsoft.com/office/drawing/2014/main" id="{4B7BF3E3-9DF2-4E4F-845B-26B36FA9654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0268" y="4142459"/>
            <a:ext cx="2803560" cy="8125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6" descr="https://attachments.office.net/owa/hongyu.luo%40umontreal.ca/service.svc/s/GetAttachmentThumbnail?id=AAMkADU3MDgxNTA1LTZiNTctNGNhZi04M2M0LTgxNjY1OGE3M2NmZABGAAAAAABzUssUrvcMTIRZlBNbKtJLBwDn62b1UREgRa7DHJ%2FD50ZOAAK%2BmkX2AADn62b1UREgRa7DHJ%2FD50ZOAAK%2BmnlqAAABEgAQAKfrxuEGQWhOn6kWFi7OQO8%3D&amp;thumbnailType=2&amp;token=eyJhbGciOiJSUzI1NiIsImtpZCI6IkQ4OThGN0RDMjk2ODQ1MDk1RUUwREZGQ0MzODBBOTM5NjUwNDNFNjQiLCJ0eXAiOiJKV1QiLCJ4NXQiOiIySmozM0Nsb1JRbGU0Tl84dzRDcE9XVUVQbVEifQ.eyJvcmlnaW4iOiJodHRwczovL291dGxvb2sub2ZmaWNlLmNvbSIsInVjIjoiYjg2NmQ2NDdlYzA2NGE3MjlmOWU0Yzk4M2ZkMGFlNzkiLCJzaWduaW5fc3RhdGUiOiJbXCJrbXNpXCJdIiwidmVyIjoiRXhjaGFuZ2UuQ2FsbGJhY2suVjEiLCJhcHBjdHhzZW5kZXIiOiJPd2FEb3dubG9hZEBkMjdlZWZlYy0yYTQ3LTRiZTctOTgxZS0wZjg5NzdmYTMxZDgiLCJpc3NyaW5nIjoiV1ciLCJhcHBjdHgiOiJ7XCJtc2V4Y2hwcm90XCI6XCJvd2FcIixcInB1aWRcIjpcIjExNTM5MDY2NjA5NDQ2ODY5NjJcIixcInNjb3BlXCI6XCJPd2FEb3dubG9hZFwiLFwib2lkXCI6XCJmMTRjYjhjNi1lYzA2LTQyZTAtOGZiMS0wNGIxNjg3MjMyMjZcIixcInByaW1hcnlzaWRcIjpcIlMtMS01LTIxLTI5NzMzOTAwOTctMTUyMDE2OTQwLTI1MTg4NzM1NDAtNzk0MjkxNlwifSIsIm5iZiI6MTY2OTgzNDA4OCwiZXhwIjoxNjY5ODM0Njg4LCJpc3MiOiIwMDAwMDAwMi0wMDAwLTBmZjEtY2UwMC0wMDAwMDAwMDAwMDBAZDI3ZWVmZWMtMmE0Ny00YmU3LTk4MWUtMGY4OTc3ZmEzMWQ4IiwiYXVkIjoiMDAwMDAwMDItMDAwMC0wZmYxLWNlMDAtMDAwMDAwMDAwMDAwL2F0dGFjaG1lbnRzLm9mZmljZS5uZXRAZDI3ZWVmZWMtMmE0Ny00YmU3LTk4MWUtMGY4OTc3ZmEzMWQ4IiwiaGFwcCI6Im93YSJ9.jLYo_yIfU8Wt26SNzIRnUTKUzi-wwdzSy6SJbcAZVc3mrcYxZifI4nysyUUQDpGTRTWAfYnDrcpu2GJd2k5TpPrZPG1o5P4QGRN4_3tIetXERq4CLstHF8AR2n0--pkikuzbP-ydzSTqdKjBcZaFOS2lfADSYFwf2n4YqzgKklf7X4VL9CaLJcuD0JN0j9AbiMaxiwY44L5ARqMQ9Y8uXXie0GQ78AUqE7UqSeAC63I7jWcpcMK875UqpcG7mYBp6y9l8G7bLA3nACPhDFjI1VfZWMfkysceb_mrkqi91BiJ2-pRbunG6W9W-mMxqeIOFTLA3QlM7khVrE7rG-VxLw&amp;X-OWA-CANARY=92STZ93xZ0KvixfI0L-A6XB-jL0D09oYMHBROgxxGDyPSZ6BJzhcE8QChG90E7mDJYl8AFWSUMU.&amp;owa=outlook.office.com&amp;scriptVer=20221104009.08&amp;animation=true">
            <a:extLst>
              <a:ext uri="{FF2B5EF4-FFF2-40B4-BE49-F238E27FC236}">
                <a16:creationId xmlns:a16="http://schemas.microsoft.com/office/drawing/2014/main" id="{2208DED0-5812-4EAC-9E5A-56BFE7541A1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2216" y="4998361"/>
            <a:ext cx="2800295" cy="8420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9EE7DBDB-D54B-418E-96BF-9F090FA698F6}"/>
              </a:ext>
            </a:extLst>
          </p:cNvPr>
          <p:cNvSpPr txBox="1"/>
          <p:nvPr/>
        </p:nvSpPr>
        <p:spPr>
          <a:xfrm rot="16200000">
            <a:off x="3235272" y="1116336"/>
            <a:ext cx="15601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74207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K293  cells without TF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AD79D81-BB87-4686-88A3-87A7E9384718}"/>
              </a:ext>
            </a:extLst>
          </p:cNvPr>
          <p:cNvSpPr txBox="1"/>
          <p:nvPr/>
        </p:nvSpPr>
        <p:spPr>
          <a:xfrm>
            <a:off x="4334194" y="3053549"/>
            <a:ext cx="60611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74207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150 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CB21234-8248-4A46-AA41-7020E1EAE500}"/>
              </a:ext>
            </a:extLst>
          </p:cNvPr>
          <p:cNvSpPr txBox="1"/>
          <p:nvPr/>
        </p:nvSpPr>
        <p:spPr>
          <a:xfrm>
            <a:off x="4348165" y="4960433"/>
            <a:ext cx="606111" cy="200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74207"/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150 </a:t>
            </a:r>
            <a:r>
              <a:rPr lang="en-US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3B1E50C-B67F-4099-9382-FB909986F443}"/>
              </a:ext>
            </a:extLst>
          </p:cNvPr>
          <p:cNvSpPr txBox="1"/>
          <p:nvPr/>
        </p:nvSpPr>
        <p:spPr>
          <a:xfrm>
            <a:off x="218513" y="122841"/>
            <a:ext cx="1472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9F (original)</a:t>
            </a:r>
            <a:endParaRPr lang="en-CA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2480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96</TotalTime>
  <Words>670</Words>
  <Application>Microsoft Office PowerPoint</Application>
  <PresentationFormat>Letter Paper (8.5x11 in)</PresentationFormat>
  <Paragraphs>296</Paragraphs>
  <Slides>9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等线</vt:lpstr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.L.</dc:creator>
  <cp:lastModifiedBy>Luo Hongyu</cp:lastModifiedBy>
  <cp:revision>57</cp:revision>
  <dcterms:created xsi:type="dcterms:W3CDTF">2022-11-26T13:21:19Z</dcterms:created>
  <dcterms:modified xsi:type="dcterms:W3CDTF">2023-12-07T21:11:03Z</dcterms:modified>
</cp:coreProperties>
</file>